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72" d="100"/>
          <a:sy n="72" d="100"/>
        </p:scale>
        <p:origin x="53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414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7602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715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5629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804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899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3584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2686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8331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414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724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F86E25-1244-4FAD-80AC-73507A8A76A4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81077-4831-4175-89A7-499B7F0CB0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1917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Rectangle 5"/>
          <p:cNvSpPr>
            <a:spLocks noChangeArrowheads="1"/>
          </p:cNvSpPr>
          <p:nvPr/>
        </p:nvSpPr>
        <p:spPr bwMode="auto">
          <a:xfrm>
            <a:off x="6491706" y="1541728"/>
            <a:ext cx="15112" cy="1728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3" name="テキスト ボックス 222"/>
          <p:cNvSpPr txBox="1"/>
          <p:nvPr/>
        </p:nvSpPr>
        <p:spPr>
          <a:xfrm rot="16200000">
            <a:off x="-576404" y="3453764"/>
            <a:ext cx="20394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bability of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304828" y="125202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1" name="直線コネクタ 230"/>
          <p:cNvCxnSpPr>
            <a:cxnSpLocks/>
          </p:cNvCxnSpPr>
          <p:nvPr/>
        </p:nvCxnSpPr>
        <p:spPr>
          <a:xfrm>
            <a:off x="1125437" y="1436689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Rectangle 45"/>
          <p:cNvSpPr>
            <a:spLocks noChangeArrowheads="1"/>
          </p:cNvSpPr>
          <p:nvPr/>
        </p:nvSpPr>
        <p:spPr bwMode="auto">
          <a:xfrm>
            <a:off x="2660873" y="5685635"/>
            <a:ext cx="76623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(months)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0D16A516-FEB2-4F73-91FB-2AB85585D3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415" y="1714573"/>
            <a:ext cx="15112" cy="1728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6">
            <a:extLst>
              <a:ext uri="{FF2B5EF4-FFF2-40B4-BE49-F238E27FC236}">
                <a16:creationId xmlns:a16="http://schemas.microsoft.com/office/drawing/2014/main" id="{BE84D229-619B-468D-95C5-B45E9854785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5171189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7">
            <a:extLst>
              <a:ext uri="{FF2B5EF4-FFF2-40B4-BE49-F238E27FC236}">
                <a16:creationId xmlns:a16="http://schemas.microsoft.com/office/drawing/2014/main" id="{10D4E839-9E80-432E-A182-0A699C6251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501562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8">
            <a:extLst>
              <a:ext uri="{FF2B5EF4-FFF2-40B4-BE49-F238E27FC236}">
                <a16:creationId xmlns:a16="http://schemas.microsoft.com/office/drawing/2014/main" id="{242E5E79-09D4-4A46-B46B-E922A3C4BCB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4894637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9">
            <a:extLst>
              <a:ext uri="{FF2B5EF4-FFF2-40B4-BE49-F238E27FC236}">
                <a16:creationId xmlns:a16="http://schemas.microsoft.com/office/drawing/2014/main" id="{BC924F31-0A5C-4F76-B00F-8FB09DBAD0E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4600800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10">
            <a:extLst>
              <a:ext uri="{FF2B5EF4-FFF2-40B4-BE49-F238E27FC236}">
                <a16:creationId xmlns:a16="http://schemas.microsoft.com/office/drawing/2014/main" id="{D9F7E4A1-EA30-4CEA-9BC8-B583BDF4FD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444524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2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1">
            <a:extLst>
              <a:ext uri="{FF2B5EF4-FFF2-40B4-BE49-F238E27FC236}">
                <a16:creationId xmlns:a16="http://schemas.microsoft.com/office/drawing/2014/main" id="{C3E5F41F-0ECF-4ADD-B909-6F0B4D671D7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4324248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2">
            <a:extLst>
              <a:ext uri="{FF2B5EF4-FFF2-40B4-BE49-F238E27FC236}">
                <a16:creationId xmlns:a16="http://schemas.microsoft.com/office/drawing/2014/main" id="{83E771B0-952A-455E-84E1-4DED48BC916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4047696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3">
            <a:extLst>
              <a:ext uri="{FF2B5EF4-FFF2-40B4-BE49-F238E27FC236}">
                <a16:creationId xmlns:a16="http://schemas.microsoft.com/office/drawing/2014/main" id="{2B859742-3822-40C3-A799-3F8F4F74BB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389213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4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14">
            <a:extLst>
              <a:ext uri="{FF2B5EF4-FFF2-40B4-BE49-F238E27FC236}">
                <a16:creationId xmlns:a16="http://schemas.microsoft.com/office/drawing/2014/main" id="{1CC2462B-DD3D-400A-9C5F-E9D8BD66A67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3771145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Line 15">
            <a:extLst>
              <a:ext uri="{FF2B5EF4-FFF2-40B4-BE49-F238E27FC236}">
                <a16:creationId xmlns:a16="http://schemas.microsoft.com/office/drawing/2014/main" id="{AE08AEE6-AEAB-47DE-B6CC-6152AD14618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3477308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6">
            <a:extLst>
              <a:ext uri="{FF2B5EF4-FFF2-40B4-BE49-F238E27FC236}">
                <a16:creationId xmlns:a16="http://schemas.microsoft.com/office/drawing/2014/main" id="{1B8B6E12-1D84-40DF-A3EF-49B449391A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332174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6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Line 17">
            <a:extLst>
              <a:ext uri="{FF2B5EF4-FFF2-40B4-BE49-F238E27FC236}">
                <a16:creationId xmlns:a16="http://schemas.microsoft.com/office/drawing/2014/main" id="{DCA29EEE-F57A-4CC0-A340-35300729163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3200756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Line 18">
            <a:extLst>
              <a:ext uri="{FF2B5EF4-FFF2-40B4-BE49-F238E27FC236}">
                <a16:creationId xmlns:a16="http://schemas.microsoft.com/office/drawing/2014/main" id="{CF7502B1-BD21-4A85-AA6D-2120633E3C1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2924204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9">
            <a:extLst>
              <a:ext uri="{FF2B5EF4-FFF2-40B4-BE49-F238E27FC236}">
                <a16:creationId xmlns:a16="http://schemas.microsoft.com/office/drawing/2014/main" id="{FF30BA54-1CA1-4B1E-97AA-1227F91993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2768644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.8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20">
            <a:extLst>
              <a:ext uri="{FF2B5EF4-FFF2-40B4-BE49-F238E27FC236}">
                <a16:creationId xmlns:a16="http://schemas.microsoft.com/office/drawing/2014/main" id="{3BC91216-A3EA-4BFC-9533-AD00CD22068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2630368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1">
            <a:extLst>
              <a:ext uri="{FF2B5EF4-FFF2-40B4-BE49-F238E27FC236}">
                <a16:creationId xmlns:a16="http://schemas.microsoft.com/office/drawing/2014/main" id="{1AF1DDAA-9AFE-4DAF-B717-5810F932B21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52551" y="2353816"/>
            <a:ext cx="9067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2">
            <a:extLst>
              <a:ext uri="{FF2B5EF4-FFF2-40B4-BE49-F238E27FC236}">
                <a16:creationId xmlns:a16="http://schemas.microsoft.com/office/drawing/2014/main" id="{06297F4B-C01D-4921-8AAB-90C3DBF0E0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302" y="219825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.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3">
            <a:extLst>
              <a:ext uri="{FF2B5EF4-FFF2-40B4-BE49-F238E27FC236}">
                <a16:creationId xmlns:a16="http://schemas.microsoft.com/office/drawing/2014/main" id="{BA8BD32B-ED0E-4474-8CF9-2F2C9D1B130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97888" y="2077264"/>
            <a:ext cx="45337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Line 31">
            <a:extLst>
              <a:ext uri="{FF2B5EF4-FFF2-40B4-BE49-F238E27FC236}">
                <a16:creationId xmlns:a16="http://schemas.microsoft.com/office/drawing/2014/main" id="{0D0BC4AE-28E6-4962-A895-AB7345024366}"/>
              </a:ext>
            </a:extLst>
          </p:cNvPr>
          <p:cNvSpPr>
            <a:spLocks noChangeShapeType="1"/>
          </p:cNvSpPr>
          <p:nvPr/>
        </p:nvSpPr>
        <p:spPr bwMode="auto">
          <a:xfrm>
            <a:off x="1143226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2">
            <a:extLst>
              <a:ext uri="{FF2B5EF4-FFF2-40B4-BE49-F238E27FC236}">
                <a16:creationId xmlns:a16="http://schemas.microsoft.com/office/drawing/2014/main" id="{5811A09A-784B-440F-9337-53585F2051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2776" y="5292180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Line 33">
            <a:extLst>
              <a:ext uri="{FF2B5EF4-FFF2-40B4-BE49-F238E27FC236}">
                <a16:creationId xmlns:a16="http://schemas.microsoft.com/office/drawing/2014/main" id="{07ADA2E6-1D43-496E-A7B1-BE8E546D708A}"/>
              </a:ext>
            </a:extLst>
          </p:cNvPr>
          <p:cNvSpPr>
            <a:spLocks noChangeShapeType="1"/>
          </p:cNvSpPr>
          <p:nvPr/>
        </p:nvSpPr>
        <p:spPr bwMode="auto">
          <a:xfrm>
            <a:off x="1611712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4">
            <a:extLst>
              <a:ext uri="{FF2B5EF4-FFF2-40B4-BE49-F238E27FC236}">
                <a16:creationId xmlns:a16="http://schemas.microsoft.com/office/drawing/2014/main" id="{155E41A4-2AA0-4A8E-9C61-B836DCDDF9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5925" y="5292180"/>
            <a:ext cx="1282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Line 35">
            <a:extLst>
              <a:ext uri="{FF2B5EF4-FFF2-40B4-BE49-F238E27FC236}">
                <a16:creationId xmlns:a16="http://schemas.microsoft.com/office/drawing/2014/main" id="{7B1D6A61-3620-4F9E-A530-7DCE8F5F2690}"/>
              </a:ext>
            </a:extLst>
          </p:cNvPr>
          <p:cNvSpPr>
            <a:spLocks noChangeShapeType="1"/>
          </p:cNvSpPr>
          <p:nvPr/>
        </p:nvSpPr>
        <p:spPr bwMode="auto">
          <a:xfrm>
            <a:off x="2065086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6">
            <a:extLst>
              <a:ext uri="{FF2B5EF4-FFF2-40B4-BE49-F238E27FC236}">
                <a16:creationId xmlns:a16="http://schemas.microsoft.com/office/drawing/2014/main" id="{B14755DD-3E36-4DDB-960C-D873AAD35D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9298" y="5292180"/>
            <a:ext cx="1282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ine 37">
            <a:extLst>
              <a:ext uri="{FF2B5EF4-FFF2-40B4-BE49-F238E27FC236}">
                <a16:creationId xmlns:a16="http://schemas.microsoft.com/office/drawing/2014/main" id="{77559B91-187B-4C8E-96F2-287C71B2460A}"/>
              </a:ext>
            </a:extLst>
          </p:cNvPr>
          <p:cNvSpPr>
            <a:spLocks noChangeShapeType="1"/>
          </p:cNvSpPr>
          <p:nvPr/>
        </p:nvSpPr>
        <p:spPr bwMode="auto">
          <a:xfrm>
            <a:off x="2533572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8">
            <a:extLst>
              <a:ext uri="{FF2B5EF4-FFF2-40B4-BE49-F238E27FC236}">
                <a16:creationId xmlns:a16="http://schemas.microsoft.com/office/drawing/2014/main" id="{50ED7680-F99A-4030-BE49-B3FDA1C2CC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7785" y="5292180"/>
            <a:ext cx="1282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Line 39">
            <a:extLst>
              <a:ext uri="{FF2B5EF4-FFF2-40B4-BE49-F238E27FC236}">
                <a16:creationId xmlns:a16="http://schemas.microsoft.com/office/drawing/2014/main" id="{8D35985E-B668-4075-843F-D3DB2F5D9507}"/>
              </a:ext>
            </a:extLst>
          </p:cNvPr>
          <p:cNvSpPr>
            <a:spLocks noChangeShapeType="1"/>
          </p:cNvSpPr>
          <p:nvPr/>
        </p:nvSpPr>
        <p:spPr bwMode="auto">
          <a:xfrm>
            <a:off x="3002058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0">
            <a:extLst>
              <a:ext uri="{FF2B5EF4-FFF2-40B4-BE49-F238E27FC236}">
                <a16:creationId xmlns:a16="http://schemas.microsoft.com/office/drawing/2014/main" id="{35452AD7-519C-43E3-9398-642DF1CF03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96271" y="5292180"/>
            <a:ext cx="12824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Line 41">
            <a:extLst>
              <a:ext uri="{FF2B5EF4-FFF2-40B4-BE49-F238E27FC236}">
                <a16:creationId xmlns:a16="http://schemas.microsoft.com/office/drawing/2014/main" id="{48F948EE-346D-4898-BAE0-60C351BE9822}"/>
              </a:ext>
            </a:extLst>
          </p:cNvPr>
          <p:cNvSpPr>
            <a:spLocks noChangeShapeType="1"/>
          </p:cNvSpPr>
          <p:nvPr/>
        </p:nvSpPr>
        <p:spPr bwMode="auto">
          <a:xfrm>
            <a:off x="3455431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2">
            <a:extLst>
              <a:ext uri="{FF2B5EF4-FFF2-40B4-BE49-F238E27FC236}">
                <a16:creationId xmlns:a16="http://schemas.microsoft.com/office/drawing/2014/main" id="{B930FA52-6C98-4F8B-8900-873CF4BB6D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9194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Line 43">
            <a:extLst>
              <a:ext uri="{FF2B5EF4-FFF2-40B4-BE49-F238E27FC236}">
                <a16:creationId xmlns:a16="http://schemas.microsoft.com/office/drawing/2014/main" id="{B59E7796-2671-4A0B-A491-5DA56700F405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3918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4">
            <a:extLst>
              <a:ext uri="{FF2B5EF4-FFF2-40B4-BE49-F238E27FC236}">
                <a16:creationId xmlns:a16="http://schemas.microsoft.com/office/drawing/2014/main" id="{73CB49E7-B867-4215-A23B-05264D3E07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7681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2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ine 45">
            <a:extLst>
              <a:ext uri="{FF2B5EF4-FFF2-40B4-BE49-F238E27FC236}">
                <a16:creationId xmlns:a16="http://schemas.microsoft.com/office/drawing/2014/main" id="{63588320-B97E-4A4F-80A0-77E42AA8D804}"/>
              </a:ext>
            </a:extLst>
          </p:cNvPr>
          <p:cNvSpPr>
            <a:spLocks noChangeShapeType="1"/>
          </p:cNvSpPr>
          <p:nvPr/>
        </p:nvSpPr>
        <p:spPr bwMode="auto">
          <a:xfrm>
            <a:off x="4392404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6">
            <a:extLst>
              <a:ext uri="{FF2B5EF4-FFF2-40B4-BE49-F238E27FC236}">
                <a16:creationId xmlns:a16="http://schemas.microsoft.com/office/drawing/2014/main" id="{97FEADFE-8F12-446A-8279-03BCBD14DD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6167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4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Line 47">
            <a:extLst>
              <a:ext uri="{FF2B5EF4-FFF2-40B4-BE49-F238E27FC236}">
                <a16:creationId xmlns:a16="http://schemas.microsoft.com/office/drawing/2014/main" id="{15684B31-E813-47FA-98D7-1AB35451FFCD}"/>
              </a:ext>
            </a:extLst>
          </p:cNvPr>
          <p:cNvSpPr>
            <a:spLocks noChangeShapeType="1"/>
          </p:cNvSpPr>
          <p:nvPr/>
        </p:nvSpPr>
        <p:spPr bwMode="auto">
          <a:xfrm>
            <a:off x="4845777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8">
            <a:extLst>
              <a:ext uri="{FF2B5EF4-FFF2-40B4-BE49-F238E27FC236}">
                <a16:creationId xmlns:a16="http://schemas.microsoft.com/office/drawing/2014/main" id="{68AC94EE-86C9-4745-B2BB-4FDE5C9816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9540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6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Line 49">
            <a:extLst>
              <a:ext uri="{FF2B5EF4-FFF2-40B4-BE49-F238E27FC236}">
                <a16:creationId xmlns:a16="http://schemas.microsoft.com/office/drawing/2014/main" id="{772C745F-3507-4F27-9AFC-B8A3F0122E1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14263" y="5171189"/>
            <a:ext cx="0" cy="103707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0">
            <a:extLst>
              <a:ext uri="{FF2B5EF4-FFF2-40B4-BE49-F238E27FC236}">
                <a16:creationId xmlns:a16="http://schemas.microsoft.com/office/drawing/2014/main" id="{1D731564-DB31-475C-AFB5-664DD58289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8026" y="5292180"/>
            <a:ext cx="192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8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A25430E8-3546-4793-8522-643EB81867A5}"/>
              </a:ext>
            </a:extLst>
          </p:cNvPr>
          <p:cNvCxnSpPr/>
          <p:nvPr/>
        </p:nvCxnSpPr>
        <p:spPr>
          <a:xfrm flipV="1">
            <a:off x="1140228" y="2043837"/>
            <a:ext cx="0" cy="31112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線コネクタ 156">
            <a:extLst>
              <a:ext uri="{FF2B5EF4-FFF2-40B4-BE49-F238E27FC236}">
                <a16:creationId xmlns:a16="http://schemas.microsoft.com/office/drawing/2014/main" id="{2460ABA4-86B4-4656-9EA3-CB2EE662414D}"/>
              </a:ext>
            </a:extLst>
          </p:cNvPr>
          <p:cNvCxnSpPr/>
          <p:nvPr/>
        </p:nvCxnSpPr>
        <p:spPr>
          <a:xfrm>
            <a:off x="1120557" y="5171189"/>
            <a:ext cx="41710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テキスト ボックス 280"/>
          <p:cNvSpPr txBox="1"/>
          <p:nvPr/>
        </p:nvSpPr>
        <p:spPr>
          <a:xfrm rot="16200000">
            <a:off x="5323044" y="3286833"/>
            <a:ext cx="2373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 of disease-free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Rectangle 54"/>
          <p:cNvSpPr>
            <a:spLocks noChangeArrowheads="1"/>
          </p:cNvSpPr>
          <p:nvPr/>
        </p:nvSpPr>
        <p:spPr bwMode="auto">
          <a:xfrm>
            <a:off x="6652855" y="185285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62">
            <a:extLst>
              <a:ext uri="{FF2B5EF4-FFF2-40B4-BE49-F238E27FC236}">
                <a16:creationId xmlns:a16="http://schemas.microsoft.com/office/drawing/2014/main" id="{9FBBA5ED-C602-4186-ADC1-651233C5E6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2001" y="158494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8" name="テキスト ボックス 277"/>
          <p:cNvSpPr txBox="1"/>
          <p:nvPr/>
        </p:nvSpPr>
        <p:spPr>
          <a:xfrm>
            <a:off x="6344898" y="12520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663306B6-7D8A-459E-89F8-B2944FB88A1C}"/>
              </a:ext>
            </a:extLst>
          </p:cNvPr>
          <p:cNvGrpSpPr/>
          <p:nvPr/>
        </p:nvGrpSpPr>
        <p:grpSpPr>
          <a:xfrm>
            <a:off x="6886634" y="2077271"/>
            <a:ext cx="4590085" cy="3762263"/>
            <a:chOff x="7459931" y="1690480"/>
            <a:chExt cx="3857353" cy="2764367"/>
          </a:xfrm>
        </p:grpSpPr>
        <p:sp>
          <p:nvSpPr>
            <p:cNvPr id="65" name="Line 63">
              <a:extLst>
                <a:ext uri="{FF2B5EF4-FFF2-40B4-BE49-F238E27FC236}">
                  <a16:creationId xmlns:a16="http://schemas.microsoft.com/office/drawing/2014/main" id="{622DD66F-18D2-4ECE-BE62-E2343F9A14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9764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4">
              <a:extLst>
                <a:ext uri="{FF2B5EF4-FFF2-40B4-BE49-F238E27FC236}">
                  <a16:creationId xmlns:a16="http://schemas.microsoft.com/office/drawing/2014/main" id="{A2DBD214-998E-4EE5-A8FA-8C87EC670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8621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65">
              <a:extLst>
                <a:ext uri="{FF2B5EF4-FFF2-40B4-BE49-F238E27FC236}">
                  <a16:creationId xmlns:a16="http://schemas.microsoft.com/office/drawing/2014/main" id="{AF9429A1-02A3-4310-A54A-AE3782B254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7732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Line 66">
              <a:extLst>
                <a:ext uri="{FF2B5EF4-FFF2-40B4-BE49-F238E27FC236}">
                  <a16:creationId xmlns:a16="http://schemas.microsoft.com/office/drawing/2014/main" id="{957DED8C-388F-47AF-88B5-A432969369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5573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7">
              <a:extLst>
                <a:ext uri="{FF2B5EF4-FFF2-40B4-BE49-F238E27FC236}">
                  <a16:creationId xmlns:a16="http://schemas.microsoft.com/office/drawing/2014/main" id="{E803655E-3DA6-4F0E-AE6D-62A0ADBDBD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4430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Line 68">
              <a:extLst>
                <a:ext uri="{FF2B5EF4-FFF2-40B4-BE49-F238E27FC236}">
                  <a16:creationId xmlns:a16="http://schemas.microsoft.com/office/drawing/2014/main" id="{32F18796-0943-4A0B-AFD0-2471AE67D7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3541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69">
              <a:extLst>
                <a:ext uri="{FF2B5EF4-FFF2-40B4-BE49-F238E27FC236}">
                  <a16:creationId xmlns:a16="http://schemas.microsoft.com/office/drawing/2014/main" id="{4C2D2B19-EFDD-4C38-9822-D176CB42B2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1509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0">
              <a:extLst>
                <a:ext uri="{FF2B5EF4-FFF2-40B4-BE49-F238E27FC236}">
                  <a16:creationId xmlns:a16="http://schemas.microsoft.com/office/drawing/2014/main" id="{75CC0B42-73D7-4A50-A3E3-E3FE4AFE94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0366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71">
              <a:extLst>
                <a:ext uri="{FF2B5EF4-FFF2-40B4-BE49-F238E27FC236}">
                  <a16:creationId xmlns:a16="http://schemas.microsoft.com/office/drawing/2014/main" id="{7C36C47F-50AA-45A3-9029-7A407D0F76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9350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72">
              <a:extLst>
                <a:ext uri="{FF2B5EF4-FFF2-40B4-BE49-F238E27FC236}">
                  <a16:creationId xmlns:a16="http://schemas.microsoft.com/office/drawing/2014/main" id="{7197086E-67D4-4153-87B8-6219A5332D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7318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3">
              <a:extLst>
                <a:ext uri="{FF2B5EF4-FFF2-40B4-BE49-F238E27FC236}">
                  <a16:creationId xmlns:a16="http://schemas.microsoft.com/office/drawing/2014/main" id="{2F6CF6FE-E265-4124-9602-0618CF5594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6175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74">
              <a:extLst>
                <a:ext uri="{FF2B5EF4-FFF2-40B4-BE49-F238E27FC236}">
                  <a16:creationId xmlns:a16="http://schemas.microsoft.com/office/drawing/2014/main" id="{7B3EB37F-9590-4E96-B8C7-9D2EDD18F2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5159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75">
              <a:extLst>
                <a:ext uri="{FF2B5EF4-FFF2-40B4-BE49-F238E27FC236}">
                  <a16:creationId xmlns:a16="http://schemas.microsoft.com/office/drawing/2014/main" id="{FF2B42B7-8D93-4628-BCC7-F782E92B4D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312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6">
              <a:extLst>
                <a:ext uri="{FF2B5EF4-FFF2-40B4-BE49-F238E27FC236}">
                  <a16:creationId xmlns:a16="http://schemas.microsoft.com/office/drawing/2014/main" id="{8A1800C4-5C93-43F5-A974-0CDD854466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198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77">
              <a:extLst>
                <a:ext uri="{FF2B5EF4-FFF2-40B4-BE49-F238E27FC236}">
                  <a16:creationId xmlns:a16="http://schemas.microsoft.com/office/drawing/2014/main" id="{DD131605-0106-4546-8556-F4AE3A8916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1095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Line 78">
              <a:extLst>
                <a:ext uri="{FF2B5EF4-FFF2-40B4-BE49-F238E27FC236}">
                  <a16:creationId xmlns:a16="http://schemas.microsoft.com/office/drawing/2014/main" id="{0DDDF813-2AF2-4147-A3BD-BA189753CD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1893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79">
              <a:extLst>
                <a:ext uri="{FF2B5EF4-FFF2-40B4-BE49-F238E27FC236}">
                  <a16:creationId xmlns:a16="http://schemas.microsoft.com/office/drawing/2014/main" id="{9BA0F6EE-9C5D-4F02-A225-0A01951E68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1779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80">
              <a:extLst>
                <a:ext uri="{FF2B5EF4-FFF2-40B4-BE49-F238E27FC236}">
                  <a16:creationId xmlns:a16="http://schemas.microsoft.com/office/drawing/2014/main" id="{12F1849C-DFD8-4866-82A9-B88E94ED97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1690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Line 88">
              <a:extLst>
                <a:ext uri="{FF2B5EF4-FFF2-40B4-BE49-F238E27FC236}">
                  <a16:creationId xmlns:a16="http://schemas.microsoft.com/office/drawing/2014/main" id="{B28D5815-4980-434A-A233-95B81578C9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901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89">
              <a:extLst>
                <a:ext uri="{FF2B5EF4-FFF2-40B4-BE49-F238E27FC236}">
                  <a16:creationId xmlns:a16="http://schemas.microsoft.com/office/drawing/2014/main" id="{8E839CC2-6A63-468F-A233-53199B80BD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39331" y="4065380"/>
              <a:ext cx="53884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Line 90">
              <a:extLst>
                <a:ext uri="{FF2B5EF4-FFF2-40B4-BE49-F238E27FC236}">
                  <a16:creationId xmlns:a16="http://schemas.microsoft.com/office/drawing/2014/main" id="{277E2621-0C8B-46A1-91F3-902ADE5A22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3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1">
              <a:extLst>
                <a:ext uri="{FF2B5EF4-FFF2-40B4-BE49-F238E27FC236}">
                  <a16:creationId xmlns:a16="http://schemas.microsoft.com/office/drawing/2014/main" id="{6D86256B-F9A2-45CB-B78A-4CE30CB8CD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4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Line 92">
              <a:extLst>
                <a:ext uri="{FF2B5EF4-FFF2-40B4-BE49-F238E27FC236}">
                  <a16:creationId xmlns:a16="http://schemas.microsoft.com/office/drawing/2014/main" id="{C4DC2F4C-6D4F-474E-9926-9C84FC5B24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64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93">
              <a:extLst>
                <a:ext uri="{FF2B5EF4-FFF2-40B4-BE49-F238E27FC236}">
                  <a16:creationId xmlns:a16="http://schemas.microsoft.com/office/drawing/2014/main" id="{05111821-4A6A-4DE9-BA65-49B6F10F5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75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Line 94">
              <a:extLst>
                <a:ext uri="{FF2B5EF4-FFF2-40B4-BE49-F238E27FC236}">
                  <a16:creationId xmlns:a16="http://schemas.microsoft.com/office/drawing/2014/main" id="{8D25425C-FA5E-451F-AA11-E8D63550F4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585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95">
              <a:extLst>
                <a:ext uri="{FF2B5EF4-FFF2-40B4-BE49-F238E27FC236}">
                  <a16:creationId xmlns:a16="http://schemas.microsoft.com/office/drawing/2014/main" id="{EF8B8AA4-937F-4477-AB49-E8438A7175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96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Line 96">
              <a:extLst>
                <a:ext uri="{FF2B5EF4-FFF2-40B4-BE49-F238E27FC236}">
                  <a16:creationId xmlns:a16="http://schemas.microsoft.com/office/drawing/2014/main" id="{F9DFFE10-36C4-49DE-8820-37ED4CBB17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52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EA951F92-DDC0-4063-871A-CD28031C9C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633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Line 98">
              <a:extLst>
                <a:ext uri="{FF2B5EF4-FFF2-40B4-BE49-F238E27FC236}">
                  <a16:creationId xmlns:a16="http://schemas.microsoft.com/office/drawing/2014/main" id="{8496229B-E404-4B32-9751-F050A19AE5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33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99">
              <a:extLst>
                <a:ext uri="{FF2B5EF4-FFF2-40B4-BE49-F238E27FC236}">
                  <a16:creationId xmlns:a16="http://schemas.microsoft.com/office/drawing/2014/main" id="{2E049407-B8A2-43C8-AE7C-13E96511BF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935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Line 100">
              <a:extLst>
                <a:ext uri="{FF2B5EF4-FFF2-40B4-BE49-F238E27FC236}">
                  <a16:creationId xmlns:a16="http://schemas.microsoft.com/office/drawing/2014/main" id="{6D9C17AD-43D8-43D8-977E-5AC4ACFBF3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269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101">
              <a:extLst>
                <a:ext uri="{FF2B5EF4-FFF2-40B4-BE49-F238E27FC236}">
                  <a16:creationId xmlns:a16="http://schemas.microsoft.com/office/drawing/2014/main" id="{D4216814-42CB-433A-88EE-013BA41EC8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72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Line 102">
              <a:extLst>
                <a:ext uri="{FF2B5EF4-FFF2-40B4-BE49-F238E27FC236}">
                  <a16:creationId xmlns:a16="http://schemas.microsoft.com/office/drawing/2014/main" id="{5CBF347C-EB80-43D0-A5A0-9BF4B5E332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0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103">
              <a:extLst>
                <a:ext uri="{FF2B5EF4-FFF2-40B4-BE49-F238E27FC236}">
                  <a16:creationId xmlns:a16="http://schemas.microsoft.com/office/drawing/2014/main" id="{9FE0AABE-F48D-49D9-A6E3-868CEA165C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0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Line 104">
              <a:extLst>
                <a:ext uri="{FF2B5EF4-FFF2-40B4-BE49-F238E27FC236}">
                  <a16:creationId xmlns:a16="http://schemas.microsoft.com/office/drawing/2014/main" id="{2E3508CC-B739-412E-8ED7-C016FF8DAD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01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105">
              <a:extLst>
                <a:ext uri="{FF2B5EF4-FFF2-40B4-BE49-F238E27FC236}">
                  <a16:creationId xmlns:a16="http://schemas.microsoft.com/office/drawing/2014/main" id="{D052E872-A040-49E1-B056-F6CD9E25B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61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Line 106">
              <a:extLst>
                <a:ext uri="{FF2B5EF4-FFF2-40B4-BE49-F238E27FC236}">
                  <a16:creationId xmlns:a16="http://schemas.microsoft.com/office/drawing/2014/main" id="{9C548FF1-3544-417F-87BA-65283046A2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953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107">
              <a:extLst>
                <a:ext uri="{FF2B5EF4-FFF2-40B4-BE49-F238E27FC236}">
                  <a16:creationId xmlns:a16="http://schemas.microsoft.com/office/drawing/2014/main" id="{3BD3F640-0B90-40FF-AAA8-31E8AC9E9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556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492DDF6B-2906-4DDB-91D2-FF91A6E46CD4}"/>
                </a:ext>
              </a:extLst>
            </p:cNvPr>
            <p:cNvGrpSpPr/>
            <p:nvPr/>
          </p:nvGrpSpPr>
          <p:grpSpPr>
            <a:xfrm>
              <a:off x="7790131" y="1690480"/>
              <a:ext cx="3505200" cy="2764367"/>
              <a:chOff x="7009954" y="1690480"/>
              <a:chExt cx="3505200" cy="2764367"/>
            </a:xfrm>
          </p:grpSpPr>
          <p:sp>
            <p:nvSpPr>
              <p:cNvPr id="283" name="Rectangle 45"/>
              <p:cNvSpPr>
                <a:spLocks noChangeArrowheads="1"/>
              </p:cNvSpPr>
              <p:nvPr/>
            </p:nvSpPr>
            <p:spPr bwMode="auto">
              <a:xfrm>
                <a:off x="8304384" y="4341776"/>
                <a:ext cx="643918" cy="113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Time (months)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" name="グループ化 5">
                <a:extLst>
                  <a:ext uri="{FF2B5EF4-FFF2-40B4-BE49-F238E27FC236}">
                    <a16:creationId xmlns:a16="http://schemas.microsoft.com/office/drawing/2014/main" id="{A3C0B6BF-E8EE-462C-B15A-49E7FA3ACAB0}"/>
                  </a:ext>
                </a:extLst>
              </p:cNvPr>
              <p:cNvGrpSpPr/>
              <p:nvPr/>
            </p:nvGrpSpPr>
            <p:grpSpPr>
              <a:xfrm>
                <a:off x="7009954" y="1690480"/>
                <a:ext cx="3505200" cy="2286000"/>
                <a:chOff x="7009954" y="1690480"/>
                <a:chExt cx="3505200" cy="2286000"/>
              </a:xfrm>
            </p:grpSpPr>
            <p:cxnSp>
              <p:nvCxnSpPr>
                <p:cNvPr id="220" name="直線コネクタ 219">
                  <a:extLst>
                    <a:ext uri="{FF2B5EF4-FFF2-40B4-BE49-F238E27FC236}">
                      <a16:creationId xmlns:a16="http://schemas.microsoft.com/office/drawing/2014/main" id="{7868AD88-EA69-4B42-914C-2556DE68218F}"/>
                    </a:ext>
                  </a:extLst>
                </p:cNvPr>
                <p:cNvCxnSpPr/>
                <p:nvPr/>
              </p:nvCxnSpPr>
              <p:spPr>
                <a:xfrm flipV="1">
                  <a:off x="7009954" y="1690480"/>
                  <a:ext cx="0" cy="228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1" name="直線コネクタ 220">
                  <a:extLst>
                    <a:ext uri="{FF2B5EF4-FFF2-40B4-BE49-F238E27FC236}">
                      <a16:creationId xmlns:a16="http://schemas.microsoft.com/office/drawing/2014/main" id="{67FAB179-DF8D-4449-83D3-ABB2A8BF2897}"/>
                    </a:ext>
                  </a:extLst>
                </p:cNvPr>
                <p:cNvCxnSpPr/>
                <p:nvPr/>
              </p:nvCxnSpPr>
              <p:spPr>
                <a:xfrm>
                  <a:off x="7009954" y="3972169"/>
                  <a:ext cx="3505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09430355-0F4B-4AC1-A87D-306C0D6F8B5D}"/>
              </a:ext>
            </a:extLst>
          </p:cNvPr>
          <p:cNvCxnSpPr>
            <a:cxnSpLocks/>
          </p:cNvCxnSpPr>
          <p:nvPr/>
        </p:nvCxnSpPr>
        <p:spPr>
          <a:xfrm>
            <a:off x="7435700" y="1436689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80CFFC3F-491B-4F9E-B364-6DBC3020C535}"/>
              </a:ext>
            </a:extLst>
          </p:cNvPr>
          <p:cNvSpPr txBox="1"/>
          <p:nvPr/>
        </p:nvSpPr>
        <p:spPr>
          <a:xfrm>
            <a:off x="4216411" y="3137612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g course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497C2860-82EC-4F7F-A182-5D345BBD42BE}"/>
              </a:ext>
            </a:extLst>
          </p:cNvPr>
          <p:cNvSpPr txBox="1"/>
          <p:nvPr/>
        </p:nvSpPr>
        <p:spPr>
          <a:xfrm>
            <a:off x="4216411" y="4204283"/>
            <a:ext cx="8098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rt course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24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DCDCB375-2478-460E-A0F9-82B42B4EFF6E}"/>
              </a:ext>
            </a:extLst>
          </p:cNvPr>
          <p:cNvSpPr txBox="1"/>
          <p:nvPr/>
        </p:nvSpPr>
        <p:spPr>
          <a:xfrm>
            <a:off x="1276660" y="4797972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00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sz="1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8</a:t>
            </a:r>
            <a:endParaRPr kumimoji="1" lang="ja-JP" altLang="en-US" sz="10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A9C52C9B-2676-46BC-B83D-86E20F7B5776}"/>
              </a:ext>
            </a:extLst>
          </p:cNvPr>
          <p:cNvSpPr txBox="1"/>
          <p:nvPr/>
        </p:nvSpPr>
        <p:spPr>
          <a:xfrm>
            <a:off x="10253985" y="3068015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g course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8EA53A70-4A99-485D-95F6-A36FE7CDC1A8}"/>
              </a:ext>
            </a:extLst>
          </p:cNvPr>
          <p:cNvSpPr txBox="1"/>
          <p:nvPr/>
        </p:nvSpPr>
        <p:spPr>
          <a:xfrm>
            <a:off x="10253985" y="3899033"/>
            <a:ext cx="8098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rt course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24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8B3D097E-CABF-4A85-81CF-86CFD8EAB957}"/>
              </a:ext>
            </a:extLst>
          </p:cNvPr>
          <p:cNvSpPr txBox="1"/>
          <p:nvPr/>
        </p:nvSpPr>
        <p:spPr>
          <a:xfrm>
            <a:off x="7396376" y="4843035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00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altLang="ja-JP" sz="1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2</a:t>
            </a:r>
            <a:endParaRPr kumimoji="1" lang="ja-JP" altLang="en-US" sz="10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Freeform 28">
            <a:extLst>
              <a:ext uri="{FF2B5EF4-FFF2-40B4-BE49-F238E27FC236}">
                <a16:creationId xmlns:a16="http://schemas.microsoft.com/office/drawing/2014/main" id="{7F491197-7AF6-45FD-8DD0-D8C54EC43E82}"/>
              </a:ext>
            </a:extLst>
          </p:cNvPr>
          <p:cNvSpPr>
            <a:spLocks/>
          </p:cNvSpPr>
          <p:nvPr/>
        </p:nvSpPr>
        <p:spPr bwMode="auto">
          <a:xfrm>
            <a:off x="1158411" y="2368153"/>
            <a:ext cx="3892550" cy="720725"/>
          </a:xfrm>
          <a:custGeom>
            <a:avLst/>
            <a:gdLst>
              <a:gd name="T0" fmla="*/ 174 w 2452"/>
              <a:gd name="T1" fmla="*/ 0 h 454"/>
              <a:gd name="T2" fmla="*/ 199 w 2452"/>
              <a:gd name="T3" fmla="*/ 25 h 454"/>
              <a:gd name="T4" fmla="*/ 219 w 2452"/>
              <a:gd name="T5" fmla="*/ 49 h 454"/>
              <a:gd name="T6" fmla="*/ 233 w 2452"/>
              <a:gd name="T7" fmla="*/ 74 h 454"/>
              <a:gd name="T8" fmla="*/ 332 w 2452"/>
              <a:gd name="T9" fmla="*/ 74 h 454"/>
              <a:gd name="T10" fmla="*/ 392 w 2452"/>
              <a:gd name="T11" fmla="*/ 74 h 454"/>
              <a:gd name="T12" fmla="*/ 402 w 2452"/>
              <a:gd name="T13" fmla="*/ 99 h 454"/>
              <a:gd name="T14" fmla="*/ 417 w 2452"/>
              <a:gd name="T15" fmla="*/ 99 h 454"/>
              <a:gd name="T16" fmla="*/ 431 w 2452"/>
              <a:gd name="T17" fmla="*/ 127 h 454"/>
              <a:gd name="T18" fmla="*/ 452 w 2452"/>
              <a:gd name="T19" fmla="*/ 157 h 454"/>
              <a:gd name="T20" fmla="*/ 493 w 2452"/>
              <a:gd name="T21" fmla="*/ 185 h 454"/>
              <a:gd name="T22" fmla="*/ 511 w 2452"/>
              <a:gd name="T23" fmla="*/ 213 h 454"/>
              <a:gd name="T24" fmla="*/ 517 w 2452"/>
              <a:gd name="T25" fmla="*/ 242 h 454"/>
              <a:gd name="T26" fmla="*/ 531 w 2452"/>
              <a:gd name="T27" fmla="*/ 270 h 454"/>
              <a:gd name="T28" fmla="*/ 596 w 2452"/>
              <a:gd name="T29" fmla="*/ 270 h 454"/>
              <a:gd name="T30" fmla="*/ 621 w 2452"/>
              <a:gd name="T31" fmla="*/ 301 h 454"/>
              <a:gd name="T32" fmla="*/ 655 w 2452"/>
              <a:gd name="T33" fmla="*/ 301 h 454"/>
              <a:gd name="T34" fmla="*/ 727 w 2452"/>
              <a:gd name="T35" fmla="*/ 301 h 454"/>
              <a:gd name="T36" fmla="*/ 760 w 2452"/>
              <a:gd name="T37" fmla="*/ 301 h 454"/>
              <a:gd name="T38" fmla="*/ 792 w 2452"/>
              <a:gd name="T39" fmla="*/ 301 h 454"/>
              <a:gd name="T40" fmla="*/ 810 w 2452"/>
              <a:gd name="T41" fmla="*/ 339 h 454"/>
              <a:gd name="T42" fmla="*/ 853 w 2452"/>
              <a:gd name="T43" fmla="*/ 339 h 454"/>
              <a:gd name="T44" fmla="*/ 980 w 2452"/>
              <a:gd name="T45" fmla="*/ 339 h 454"/>
              <a:gd name="T46" fmla="*/ 995 w 2452"/>
              <a:gd name="T47" fmla="*/ 387 h 454"/>
              <a:gd name="T48" fmla="*/ 1020 w 2452"/>
              <a:gd name="T49" fmla="*/ 387 h 454"/>
              <a:gd name="T50" fmla="*/ 1043 w 2452"/>
              <a:gd name="T51" fmla="*/ 387 h 454"/>
              <a:gd name="T52" fmla="*/ 1055 w 2452"/>
              <a:gd name="T53" fmla="*/ 387 h 454"/>
              <a:gd name="T54" fmla="*/ 1133 w 2452"/>
              <a:gd name="T55" fmla="*/ 387 h 454"/>
              <a:gd name="T56" fmla="*/ 1177 w 2452"/>
              <a:gd name="T57" fmla="*/ 454 h 454"/>
              <a:gd name="T58" fmla="*/ 1233 w 2452"/>
              <a:gd name="T59" fmla="*/ 454 h 454"/>
              <a:gd name="T60" fmla="*/ 1299 w 2452"/>
              <a:gd name="T61" fmla="*/ 454 h 454"/>
              <a:gd name="T62" fmla="*/ 1390 w 2452"/>
              <a:gd name="T63" fmla="*/ 454 h 454"/>
              <a:gd name="T64" fmla="*/ 1529 w 2452"/>
              <a:gd name="T65" fmla="*/ 454 h 454"/>
              <a:gd name="T66" fmla="*/ 1602 w 2452"/>
              <a:gd name="T67" fmla="*/ 454 h 454"/>
              <a:gd name="T68" fmla="*/ 1780 w 2452"/>
              <a:gd name="T69" fmla="*/ 454 h 454"/>
              <a:gd name="T70" fmla="*/ 1823 w 2452"/>
              <a:gd name="T71" fmla="*/ 454 h 454"/>
              <a:gd name="T72" fmla="*/ 2075 w 2452"/>
              <a:gd name="T73" fmla="*/ 454 h 4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2452" h="454">
                <a:moveTo>
                  <a:pt x="0" y="0"/>
                </a:moveTo>
                <a:lnTo>
                  <a:pt x="174" y="0"/>
                </a:lnTo>
                <a:lnTo>
                  <a:pt x="174" y="25"/>
                </a:lnTo>
                <a:lnTo>
                  <a:pt x="199" y="25"/>
                </a:lnTo>
                <a:lnTo>
                  <a:pt x="219" y="25"/>
                </a:lnTo>
                <a:lnTo>
                  <a:pt x="219" y="49"/>
                </a:lnTo>
                <a:lnTo>
                  <a:pt x="233" y="49"/>
                </a:lnTo>
                <a:lnTo>
                  <a:pt x="233" y="74"/>
                </a:lnTo>
                <a:lnTo>
                  <a:pt x="266" y="74"/>
                </a:lnTo>
                <a:lnTo>
                  <a:pt x="332" y="74"/>
                </a:lnTo>
                <a:lnTo>
                  <a:pt x="373" y="74"/>
                </a:lnTo>
                <a:lnTo>
                  <a:pt x="392" y="74"/>
                </a:lnTo>
                <a:lnTo>
                  <a:pt x="392" y="99"/>
                </a:lnTo>
                <a:lnTo>
                  <a:pt x="402" y="99"/>
                </a:lnTo>
                <a:lnTo>
                  <a:pt x="405" y="99"/>
                </a:lnTo>
                <a:lnTo>
                  <a:pt x="417" y="99"/>
                </a:lnTo>
                <a:lnTo>
                  <a:pt x="417" y="127"/>
                </a:lnTo>
                <a:lnTo>
                  <a:pt x="431" y="127"/>
                </a:lnTo>
                <a:lnTo>
                  <a:pt x="431" y="157"/>
                </a:lnTo>
                <a:lnTo>
                  <a:pt x="452" y="157"/>
                </a:lnTo>
                <a:lnTo>
                  <a:pt x="452" y="185"/>
                </a:lnTo>
                <a:lnTo>
                  <a:pt x="493" y="185"/>
                </a:lnTo>
                <a:lnTo>
                  <a:pt x="493" y="213"/>
                </a:lnTo>
                <a:lnTo>
                  <a:pt x="511" y="213"/>
                </a:lnTo>
                <a:lnTo>
                  <a:pt x="511" y="242"/>
                </a:lnTo>
                <a:lnTo>
                  <a:pt x="517" y="242"/>
                </a:lnTo>
                <a:lnTo>
                  <a:pt x="517" y="270"/>
                </a:lnTo>
                <a:lnTo>
                  <a:pt x="531" y="270"/>
                </a:lnTo>
                <a:lnTo>
                  <a:pt x="543" y="270"/>
                </a:lnTo>
                <a:lnTo>
                  <a:pt x="596" y="270"/>
                </a:lnTo>
                <a:lnTo>
                  <a:pt x="621" y="270"/>
                </a:lnTo>
                <a:lnTo>
                  <a:pt x="621" y="301"/>
                </a:lnTo>
                <a:lnTo>
                  <a:pt x="641" y="301"/>
                </a:lnTo>
                <a:lnTo>
                  <a:pt x="655" y="301"/>
                </a:lnTo>
                <a:lnTo>
                  <a:pt x="686" y="301"/>
                </a:lnTo>
                <a:lnTo>
                  <a:pt x="727" y="301"/>
                </a:lnTo>
                <a:lnTo>
                  <a:pt x="752" y="301"/>
                </a:lnTo>
                <a:lnTo>
                  <a:pt x="760" y="301"/>
                </a:lnTo>
                <a:lnTo>
                  <a:pt x="771" y="301"/>
                </a:lnTo>
                <a:lnTo>
                  <a:pt x="792" y="301"/>
                </a:lnTo>
                <a:lnTo>
                  <a:pt x="792" y="339"/>
                </a:lnTo>
                <a:lnTo>
                  <a:pt x="810" y="339"/>
                </a:lnTo>
                <a:lnTo>
                  <a:pt x="822" y="339"/>
                </a:lnTo>
                <a:lnTo>
                  <a:pt x="853" y="339"/>
                </a:lnTo>
                <a:lnTo>
                  <a:pt x="916" y="339"/>
                </a:lnTo>
                <a:lnTo>
                  <a:pt x="980" y="339"/>
                </a:lnTo>
                <a:lnTo>
                  <a:pt x="995" y="339"/>
                </a:lnTo>
                <a:lnTo>
                  <a:pt x="995" y="387"/>
                </a:lnTo>
                <a:lnTo>
                  <a:pt x="999" y="387"/>
                </a:lnTo>
                <a:lnTo>
                  <a:pt x="1020" y="387"/>
                </a:lnTo>
                <a:lnTo>
                  <a:pt x="1032" y="387"/>
                </a:lnTo>
                <a:lnTo>
                  <a:pt x="1043" y="387"/>
                </a:lnTo>
                <a:lnTo>
                  <a:pt x="1045" y="387"/>
                </a:lnTo>
                <a:lnTo>
                  <a:pt x="1055" y="387"/>
                </a:lnTo>
                <a:lnTo>
                  <a:pt x="1123" y="387"/>
                </a:lnTo>
                <a:lnTo>
                  <a:pt x="1133" y="387"/>
                </a:lnTo>
                <a:lnTo>
                  <a:pt x="1133" y="454"/>
                </a:lnTo>
                <a:lnTo>
                  <a:pt x="1177" y="454"/>
                </a:lnTo>
                <a:lnTo>
                  <a:pt x="1201" y="454"/>
                </a:lnTo>
                <a:lnTo>
                  <a:pt x="1233" y="454"/>
                </a:lnTo>
                <a:lnTo>
                  <a:pt x="1273" y="454"/>
                </a:lnTo>
                <a:lnTo>
                  <a:pt x="1299" y="454"/>
                </a:lnTo>
                <a:lnTo>
                  <a:pt x="1368" y="454"/>
                </a:lnTo>
                <a:lnTo>
                  <a:pt x="1390" y="454"/>
                </a:lnTo>
                <a:lnTo>
                  <a:pt x="1473" y="454"/>
                </a:lnTo>
                <a:lnTo>
                  <a:pt x="1529" y="454"/>
                </a:lnTo>
                <a:lnTo>
                  <a:pt x="1588" y="454"/>
                </a:lnTo>
                <a:lnTo>
                  <a:pt x="1602" y="454"/>
                </a:lnTo>
                <a:lnTo>
                  <a:pt x="1747" y="454"/>
                </a:lnTo>
                <a:lnTo>
                  <a:pt x="1780" y="454"/>
                </a:lnTo>
                <a:lnTo>
                  <a:pt x="1784" y="454"/>
                </a:lnTo>
                <a:lnTo>
                  <a:pt x="1823" y="454"/>
                </a:lnTo>
                <a:lnTo>
                  <a:pt x="1885" y="454"/>
                </a:lnTo>
                <a:lnTo>
                  <a:pt x="2075" y="454"/>
                </a:lnTo>
                <a:lnTo>
                  <a:pt x="2452" y="454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" name="Freeform 29">
            <a:extLst>
              <a:ext uri="{FF2B5EF4-FFF2-40B4-BE49-F238E27FC236}">
                <a16:creationId xmlns:a16="http://schemas.microsoft.com/office/drawing/2014/main" id="{360C9917-AEB9-4DE7-8EF5-9FD266EAADDA}"/>
              </a:ext>
            </a:extLst>
          </p:cNvPr>
          <p:cNvSpPr>
            <a:spLocks/>
          </p:cNvSpPr>
          <p:nvPr/>
        </p:nvSpPr>
        <p:spPr bwMode="auto">
          <a:xfrm>
            <a:off x="1158411" y="2368153"/>
            <a:ext cx="3762375" cy="1465263"/>
          </a:xfrm>
          <a:custGeom>
            <a:avLst/>
            <a:gdLst>
              <a:gd name="T0" fmla="*/ 0 w 2370"/>
              <a:gd name="T1" fmla="*/ 0 h 923"/>
              <a:gd name="T2" fmla="*/ 336 w 2370"/>
              <a:gd name="T3" fmla="*/ 0 h 923"/>
              <a:gd name="T4" fmla="*/ 336 w 2370"/>
              <a:gd name="T5" fmla="*/ 70 h 923"/>
              <a:gd name="T6" fmla="*/ 343 w 2370"/>
              <a:gd name="T7" fmla="*/ 70 h 923"/>
              <a:gd name="T8" fmla="*/ 343 w 2370"/>
              <a:gd name="T9" fmla="*/ 140 h 923"/>
              <a:gd name="T10" fmla="*/ 368 w 2370"/>
              <a:gd name="T11" fmla="*/ 140 h 923"/>
              <a:gd name="T12" fmla="*/ 490 w 2370"/>
              <a:gd name="T13" fmla="*/ 140 h 923"/>
              <a:gd name="T14" fmla="*/ 490 w 2370"/>
              <a:gd name="T15" fmla="*/ 212 h 923"/>
              <a:gd name="T16" fmla="*/ 494 w 2370"/>
              <a:gd name="T17" fmla="*/ 284 h 923"/>
              <a:gd name="T18" fmla="*/ 640 w 2370"/>
              <a:gd name="T19" fmla="*/ 284 h 923"/>
              <a:gd name="T20" fmla="*/ 640 w 2370"/>
              <a:gd name="T21" fmla="*/ 356 h 923"/>
              <a:gd name="T22" fmla="*/ 783 w 2370"/>
              <a:gd name="T23" fmla="*/ 356 h 923"/>
              <a:gd name="T24" fmla="*/ 783 w 2370"/>
              <a:gd name="T25" fmla="*/ 428 h 923"/>
              <a:gd name="T26" fmla="*/ 820 w 2370"/>
              <a:gd name="T27" fmla="*/ 428 h 923"/>
              <a:gd name="T28" fmla="*/ 820 w 2370"/>
              <a:gd name="T29" fmla="*/ 500 h 923"/>
              <a:gd name="T30" fmla="*/ 832 w 2370"/>
              <a:gd name="T31" fmla="*/ 500 h 923"/>
              <a:gd name="T32" fmla="*/ 1056 w 2370"/>
              <a:gd name="T33" fmla="*/ 500 h 923"/>
              <a:gd name="T34" fmla="*/ 1056 w 2370"/>
              <a:gd name="T35" fmla="*/ 577 h 923"/>
              <a:gd name="T36" fmla="*/ 1157 w 2370"/>
              <a:gd name="T37" fmla="*/ 577 h 923"/>
              <a:gd name="T38" fmla="*/ 1157 w 2370"/>
              <a:gd name="T39" fmla="*/ 655 h 923"/>
              <a:gd name="T40" fmla="*/ 1231 w 2370"/>
              <a:gd name="T41" fmla="*/ 655 h 923"/>
              <a:gd name="T42" fmla="*/ 1325 w 2370"/>
              <a:gd name="T43" fmla="*/ 655 h 923"/>
              <a:gd name="T44" fmla="*/ 1325 w 2370"/>
              <a:gd name="T45" fmla="*/ 738 h 923"/>
              <a:gd name="T46" fmla="*/ 1476 w 2370"/>
              <a:gd name="T47" fmla="*/ 738 h 923"/>
              <a:gd name="T48" fmla="*/ 1560 w 2370"/>
              <a:gd name="T49" fmla="*/ 738 h 923"/>
              <a:gd name="T50" fmla="*/ 1560 w 2370"/>
              <a:gd name="T51" fmla="*/ 831 h 923"/>
              <a:gd name="T52" fmla="*/ 1868 w 2370"/>
              <a:gd name="T53" fmla="*/ 831 h 923"/>
              <a:gd name="T54" fmla="*/ 1868 w 2370"/>
              <a:gd name="T55" fmla="*/ 923 h 923"/>
              <a:gd name="T56" fmla="*/ 1892 w 2370"/>
              <a:gd name="T57" fmla="*/ 923 h 923"/>
              <a:gd name="T58" fmla="*/ 1958 w 2370"/>
              <a:gd name="T59" fmla="*/ 923 h 923"/>
              <a:gd name="T60" fmla="*/ 1995 w 2370"/>
              <a:gd name="T61" fmla="*/ 923 h 923"/>
              <a:gd name="T62" fmla="*/ 2071 w 2370"/>
              <a:gd name="T63" fmla="*/ 923 h 923"/>
              <a:gd name="T64" fmla="*/ 2080 w 2370"/>
              <a:gd name="T65" fmla="*/ 923 h 923"/>
              <a:gd name="T66" fmla="*/ 2184 w 2370"/>
              <a:gd name="T67" fmla="*/ 923 h 923"/>
              <a:gd name="T68" fmla="*/ 2370 w 2370"/>
              <a:gd name="T69" fmla="*/ 923 h 9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>
              <a:path w="2370" h="923">
                <a:moveTo>
                  <a:pt x="0" y="0"/>
                </a:moveTo>
                <a:lnTo>
                  <a:pt x="336" y="0"/>
                </a:lnTo>
                <a:lnTo>
                  <a:pt x="336" y="70"/>
                </a:lnTo>
                <a:lnTo>
                  <a:pt x="343" y="70"/>
                </a:lnTo>
                <a:lnTo>
                  <a:pt x="343" y="140"/>
                </a:lnTo>
                <a:lnTo>
                  <a:pt x="368" y="140"/>
                </a:lnTo>
                <a:lnTo>
                  <a:pt x="490" y="140"/>
                </a:lnTo>
                <a:lnTo>
                  <a:pt x="490" y="212"/>
                </a:lnTo>
                <a:lnTo>
                  <a:pt x="494" y="284"/>
                </a:lnTo>
                <a:lnTo>
                  <a:pt x="640" y="284"/>
                </a:lnTo>
                <a:lnTo>
                  <a:pt x="640" y="356"/>
                </a:lnTo>
                <a:lnTo>
                  <a:pt x="783" y="356"/>
                </a:lnTo>
                <a:lnTo>
                  <a:pt x="783" y="428"/>
                </a:lnTo>
                <a:lnTo>
                  <a:pt x="820" y="428"/>
                </a:lnTo>
                <a:lnTo>
                  <a:pt x="820" y="500"/>
                </a:lnTo>
                <a:lnTo>
                  <a:pt x="832" y="500"/>
                </a:lnTo>
                <a:lnTo>
                  <a:pt x="1056" y="500"/>
                </a:lnTo>
                <a:lnTo>
                  <a:pt x="1056" y="577"/>
                </a:lnTo>
                <a:lnTo>
                  <a:pt x="1157" y="577"/>
                </a:lnTo>
                <a:lnTo>
                  <a:pt x="1157" y="655"/>
                </a:lnTo>
                <a:lnTo>
                  <a:pt x="1231" y="655"/>
                </a:lnTo>
                <a:lnTo>
                  <a:pt x="1325" y="655"/>
                </a:lnTo>
                <a:lnTo>
                  <a:pt x="1325" y="738"/>
                </a:lnTo>
                <a:lnTo>
                  <a:pt x="1476" y="738"/>
                </a:lnTo>
                <a:lnTo>
                  <a:pt x="1560" y="738"/>
                </a:lnTo>
                <a:lnTo>
                  <a:pt x="1560" y="831"/>
                </a:lnTo>
                <a:lnTo>
                  <a:pt x="1868" y="831"/>
                </a:lnTo>
                <a:lnTo>
                  <a:pt x="1868" y="923"/>
                </a:lnTo>
                <a:lnTo>
                  <a:pt x="1892" y="923"/>
                </a:lnTo>
                <a:lnTo>
                  <a:pt x="1958" y="923"/>
                </a:lnTo>
                <a:lnTo>
                  <a:pt x="1995" y="923"/>
                </a:lnTo>
                <a:lnTo>
                  <a:pt x="2071" y="923"/>
                </a:lnTo>
                <a:lnTo>
                  <a:pt x="2080" y="923"/>
                </a:lnTo>
                <a:lnTo>
                  <a:pt x="2184" y="923"/>
                </a:lnTo>
                <a:lnTo>
                  <a:pt x="2370" y="923"/>
                </a:lnTo>
              </a:path>
            </a:pathLst>
          </a:custGeom>
          <a:noFill/>
          <a:ln w="142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" name="Freeform 85">
            <a:extLst>
              <a:ext uri="{FF2B5EF4-FFF2-40B4-BE49-F238E27FC236}">
                <a16:creationId xmlns:a16="http://schemas.microsoft.com/office/drawing/2014/main" id="{9A875147-A49C-4B79-8AF7-2F7C37E44CA0}"/>
              </a:ext>
            </a:extLst>
          </p:cNvPr>
          <p:cNvSpPr>
            <a:spLocks/>
          </p:cNvSpPr>
          <p:nvPr/>
        </p:nvSpPr>
        <p:spPr bwMode="auto">
          <a:xfrm>
            <a:off x="7294188" y="2371937"/>
            <a:ext cx="3248025" cy="1169988"/>
          </a:xfrm>
          <a:custGeom>
            <a:avLst/>
            <a:gdLst>
              <a:gd name="T0" fmla="*/ 165 w 4092"/>
              <a:gd name="T1" fmla="*/ 0 h 1476"/>
              <a:gd name="T2" fmla="*/ 205 w 4092"/>
              <a:gd name="T3" fmla="*/ 52 h 1476"/>
              <a:gd name="T4" fmla="*/ 234 w 4092"/>
              <a:gd name="T5" fmla="*/ 104 h 1476"/>
              <a:gd name="T6" fmla="*/ 301 w 4092"/>
              <a:gd name="T7" fmla="*/ 156 h 1476"/>
              <a:gd name="T8" fmla="*/ 309 w 4092"/>
              <a:gd name="T9" fmla="*/ 208 h 1476"/>
              <a:gd name="T10" fmla="*/ 328 w 4092"/>
              <a:gd name="T11" fmla="*/ 259 h 1476"/>
              <a:gd name="T12" fmla="*/ 332 w 4092"/>
              <a:gd name="T13" fmla="*/ 363 h 1476"/>
              <a:gd name="T14" fmla="*/ 355 w 4092"/>
              <a:gd name="T15" fmla="*/ 417 h 1476"/>
              <a:gd name="T16" fmla="*/ 395 w 4092"/>
              <a:gd name="T17" fmla="*/ 417 h 1476"/>
              <a:gd name="T18" fmla="*/ 432 w 4092"/>
              <a:gd name="T19" fmla="*/ 469 h 1476"/>
              <a:gd name="T20" fmla="*/ 445 w 4092"/>
              <a:gd name="T21" fmla="*/ 575 h 1476"/>
              <a:gd name="T22" fmla="*/ 455 w 4092"/>
              <a:gd name="T23" fmla="*/ 628 h 1476"/>
              <a:gd name="T24" fmla="*/ 466 w 4092"/>
              <a:gd name="T25" fmla="*/ 732 h 1476"/>
              <a:gd name="T26" fmla="*/ 482 w 4092"/>
              <a:gd name="T27" fmla="*/ 786 h 1476"/>
              <a:gd name="T28" fmla="*/ 489 w 4092"/>
              <a:gd name="T29" fmla="*/ 838 h 1476"/>
              <a:gd name="T30" fmla="*/ 610 w 4092"/>
              <a:gd name="T31" fmla="*/ 838 h 1476"/>
              <a:gd name="T32" fmla="*/ 614 w 4092"/>
              <a:gd name="T33" fmla="*/ 894 h 1476"/>
              <a:gd name="T34" fmla="*/ 653 w 4092"/>
              <a:gd name="T35" fmla="*/ 947 h 1476"/>
              <a:gd name="T36" fmla="*/ 678 w 4092"/>
              <a:gd name="T37" fmla="*/ 1003 h 1476"/>
              <a:gd name="T38" fmla="*/ 791 w 4092"/>
              <a:gd name="T39" fmla="*/ 1059 h 1476"/>
              <a:gd name="T40" fmla="*/ 889 w 4092"/>
              <a:gd name="T41" fmla="*/ 1059 h 1476"/>
              <a:gd name="T42" fmla="*/ 1069 w 4092"/>
              <a:gd name="T43" fmla="*/ 1059 h 1476"/>
              <a:gd name="T44" fmla="*/ 1137 w 4092"/>
              <a:gd name="T45" fmla="*/ 1126 h 1476"/>
              <a:gd name="T46" fmla="*/ 1354 w 4092"/>
              <a:gd name="T47" fmla="*/ 1126 h 1476"/>
              <a:gd name="T48" fmla="*/ 1496 w 4092"/>
              <a:gd name="T49" fmla="*/ 1126 h 1476"/>
              <a:gd name="T50" fmla="*/ 1595 w 4092"/>
              <a:gd name="T51" fmla="*/ 1126 h 1476"/>
              <a:gd name="T52" fmla="*/ 1682 w 4092"/>
              <a:gd name="T53" fmla="*/ 1126 h 1476"/>
              <a:gd name="T54" fmla="*/ 1732 w 4092"/>
              <a:gd name="T55" fmla="*/ 1212 h 1476"/>
              <a:gd name="T56" fmla="*/ 1931 w 4092"/>
              <a:gd name="T57" fmla="*/ 1212 h 1476"/>
              <a:gd name="T58" fmla="*/ 2010 w 4092"/>
              <a:gd name="T59" fmla="*/ 1212 h 1476"/>
              <a:gd name="T60" fmla="*/ 2054 w 4092"/>
              <a:gd name="T61" fmla="*/ 1212 h 1476"/>
              <a:gd name="T62" fmla="*/ 2079 w 4092"/>
              <a:gd name="T63" fmla="*/ 1212 h 1476"/>
              <a:gd name="T64" fmla="*/ 2321 w 4092"/>
              <a:gd name="T65" fmla="*/ 1212 h 1476"/>
              <a:gd name="T66" fmla="*/ 2410 w 4092"/>
              <a:gd name="T67" fmla="*/ 1212 h 1476"/>
              <a:gd name="T68" fmla="*/ 2511 w 4092"/>
              <a:gd name="T69" fmla="*/ 1212 h 1476"/>
              <a:gd name="T70" fmla="*/ 2696 w 4092"/>
              <a:gd name="T71" fmla="*/ 1212 h 1476"/>
              <a:gd name="T72" fmla="*/ 2966 w 4092"/>
              <a:gd name="T73" fmla="*/ 1212 h 1476"/>
              <a:gd name="T74" fmla="*/ 3014 w 4092"/>
              <a:gd name="T75" fmla="*/ 1476 h 1476"/>
              <a:gd name="T76" fmla="*/ 3158 w 4092"/>
              <a:gd name="T77" fmla="*/ 1476 h 1476"/>
              <a:gd name="T78" fmla="*/ 3517 w 4092"/>
              <a:gd name="T79" fmla="*/ 1476 h 1476"/>
              <a:gd name="T80" fmla="*/ 3717 w 4092"/>
              <a:gd name="T81" fmla="*/ 1476 h 14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4092" h="1476">
                <a:moveTo>
                  <a:pt x="0" y="0"/>
                </a:moveTo>
                <a:lnTo>
                  <a:pt x="165" y="0"/>
                </a:lnTo>
                <a:lnTo>
                  <a:pt x="165" y="52"/>
                </a:lnTo>
                <a:lnTo>
                  <a:pt x="205" y="52"/>
                </a:lnTo>
                <a:lnTo>
                  <a:pt x="205" y="104"/>
                </a:lnTo>
                <a:lnTo>
                  <a:pt x="234" y="104"/>
                </a:lnTo>
                <a:lnTo>
                  <a:pt x="234" y="156"/>
                </a:lnTo>
                <a:lnTo>
                  <a:pt x="301" y="156"/>
                </a:lnTo>
                <a:lnTo>
                  <a:pt x="301" y="208"/>
                </a:lnTo>
                <a:lnTo>
                  <a:pt x="309" y="208"/>
                </a:lnTo>
                <a:lnTo>
                  <a:pt x="309" y="259"/>
                </a:lnTo>
                <a:lnTo>
                  <a:pt x="328" y="259"/>
                </a:lnTo>
                <a:lnTo>
                  <a:pt x="328" y="311"/>
                </a:lnTo>
                <a:lnTo>
                  <a:pt x="332" y="363"/>
                </a:lnTo>
                <a:lnTo>
                  <a:pt x="355" y="363"/>
                </a:lnTo>
                <a:lnTo>
                  <a:pt x="355" y="417"/>
                </a:lnTo>
                <a:lnTo>
                  <a:pt x="392" y="417"/>
                </a:lnTo>
                <a:lnTo>
                  <a:pt x="395" y="417"/>
                </a:lnTo>
                <a:lnTo>
                  <a:pt x="395" y="469"/>
                </a:lnTo>
                <a:lnTo>
                  <a:pt x="432" y="469"/>
                </a:lnTo>
                <a:lnTo>
                  <a:pt x="432" y="523"/>
                </a:lnTo>
                <a:lnTo>
                  <a:pt x="445" y="575"/>
                </a:lnTo>
                <a:lnTo>
                  <a:pt x="447" y="628"/>
                </a:lnTo>
                <a:lnTo>
                  <a:pt x="455" y="628"/>
                </a:lnTo>
                <a:lnTo>
                  <a:pt x="455" y="680"/>
                </a:lnTo>
                <a:lnTo>
                  <a:pt x="466" y="732"/>
                </a:lnTo>
                <a:lnTo>
                  <a:pt x="482" y="732"/>
                </a:lnTo>
                <a:lnTo>
                  <a:pt x="482" y="786"/>
                </a:lnTo>
                <a:lnTo>
                  <a:pt x="489" y="786"/>
                </a:lnTo>
                <a:lnTo>
                  <a:pt x="489" y="838"/>
                </a:lnTo>
                <a:lnTo>
                  <a:pt x="524" y="838"/>
                </a:lnTo>
                <a:lnTo>
                  <a:pt x="610" y="838"/>
                </a:lnTo>
                <a:lnTo>
                  <a:pt x="610" y="894"/>
                </a:lnTo>
                <a:lnTo>
                  <a:pt x="614" y="894"/>
                </a:lnTo>
                <a:lnTo>
                  <a:pt x="614" y="947"/>
                </a:lnTo>
                <a:lnTo>
                  <a:pt x="653" y="947"/>
                </a:lnTo>
                <a:lnTo>
                  <a:pt x="668" y="1003"/>
                </a:lnTo>
                <a:lnTo>
                  <a:pt x="678" y="1003"/>
                </a:lnTo>
                <a:lnTo>
                  <a:pt x="678" y="1059"/>
                </a:lnTo>
                <a:lnTo>
                  <a:pt x="791" y="1059"/>
                </a:lnTo>
                <a:lnTo>
                  <a:pt x="799" y="1059"/>
                </a:lnTo>
                <a:lnTo>
                  <a:pt x="889" y="1059"/>
                </a:lnTo>
                <a:lnTo>
                  <a:pt x="1004" y="1059"/>
                </a:lnTo>
                <a:lnTo>
                  <a:pt x="1069" y="1059"/>
                </a:lnTo>
                <a:lnTo>
                  <a:pt x="1137" y="1059"/>
                </a:lnTo>
                <a:lnTo>
                  <a:pt x="1137" y="1126"/>
                </a:lnTo>
                <a:lnTo>
                  <a:pt x="1173" y="1126"/>
                </a:lnTo>
                <a:lnTo>
                  <a:pt x="1354" y="1126"/>
                </a:lnTo>
                <a:lnTo>
                  <a:pt x="1434" y="1126"/>
                </a:lnTo>
                <a:lnTo>
                  <a:pt x="1496" y="1126"/>
                </a:lnTo>
                <a:lnTo>
                  <a:pt x="1519" y="1126"/>
                </a:lnTo>
                <a:lnTo>
                  <a:pt x="1595" y="1126"/>
                </a:lnTo>
                <a:lnTo>
                  <a:pt x="1618" y="1126"/>
                </a:lnTo>
                <a:lnTo>
                  <a:pt x="1682" y="1126"/>
                </a:lnTo>
                <a:lnTo>
                  <a:pt x="1732" y="1126"/>
                </a:lnTo>
                <a:lnTo>
                  <a:pt x="1732" y="1212"/>
                </a:lnTo>
                <a:lnTo>
                  <a:pt x="1807" y="1212"/>
                </a:lnTo>
                <a:lnTo>
                  <a:pt x="1931" y="1212"/>
                </a:lnTo>
                <a:lnTo>
                  <a:pt x="1968" y="1212"/>
                </a:lnTo>
                <a:lnTo>
                  <a:pt x="2010" y="1212"/>
                </a:lnTo>
                <a:lnTo>
                  <a:pt x="2035" y="1212"/>
                </a:lnTo>
                <a:lnTo>
                  <a:pt x="2054" y="1212"/>
                </a:lnTo>
                <a:lnTo>
                  <a:pt x="2060" y="1212"/>
                </a:lnTo>
                <a:lnTo>
                  <a:pt x="2079" y="1212"/>
                </a:lnTo>
                <a:lnTo>
                  <a:pt x="2214" y="1212"/>
                </a:lnTo>
                <a:lnTo>
                  <a:pt x="2321" y="1212"/>
                </a:lnTo>
                <a:lnTo>
                  <a:pt x="2367" y="1212"/>
                </a:lnTo>
                <a:lnTo>
                  <a:pt x="2410" y="1212"/>
                </a:lnTo>
                <a:lnTo>
                  <a:pt x="2429" y="1212"/>
                </a:lnTo>
                <a:lnTo>
                  <a:pt x="2511" y="1212"/>
                </a:lnTo>
                <a:lnTo>
                  <a:pt x="2561" y="1212"/>
                </a:lnTo>
                <a:lnTo>
                  <a:pt x="2696" y="1212"/>
                </a:lnTo>
                <a:lnTo>
                  <a:pt x="2738" y="1212"/>
                </a:lnTo>
                <a:lnTo>
                  <a:pt x="2966" y="1212"/>
                </a:lnTo>
                <a:lnTo>
                  <a:pt x="2966" y="1476"/>
                </a:lnTo>
                <a:lnTo>
                  <a:pt x="3014" y="1476"/>
                </a:lnTo>
                <a:lnTo>
                  <a:pt x="3130" y="1476"/>
                </a:lnTo>
                <a:lnTo>
                  <a:pt x="3158" y="1476"/>
                </a:lnTo>
                <a:lnTo>
                  <a:pt x="3510" y="1476"/>
                </a:lnTo>
                <a:lnTo>
                  <a:pt x="3517" y="1476"/>
                </a:lnTo>
                <a:lnTo>
                  <a:pt x="3594" y="1476"/>
                </a:lnTo>
                <a:lnTo>
                  <a:pt x="3717" y="1476"/>
                </a:lnTo>
                <a:lnTo>
                  <a:pt x="4092" y="1476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" name="Freeform 86">
            <a:extLst>
              <a:ext uri="{FF2B5EF4-FFF2-40B4-BE49-F238E27FC236}">
                <a16:creationId xmlns:a16="http://schemas.microsoft.com/office/drawing/2014/main" id="{D533604A-82BF-4C42-88BC-F54A36FAC7AB}"/>
              </a:ext>
            </a:extLst>
          </p:cNvPr>
          <p:cNvSpPr>
            <a:spLocks/>
          </p:cNvSpPr>
          <p:nvPr/>
        </p:nvSpPr>
        <p:spPr bwMode="auto">
          <a:xfrm>
            <a:off x="7294188" y="2371937"/>
            <a:ext cx="3708400" cy="1366838"/>
          </a:xfrm>
          <a:custGeom>
            <a:avLst/>
            <a:gdLst>
              <a:gd name="T0" fmla="*/ 0 w 4671"/>
              <a:gd name="T1" fmla="*/ 0 h 1724"/>
              <a:gd name="T2" fmla="*/ 138 w 4671"/>
              <a:gd name="T3" fmla="*/ 0 h 1724"/>
              <a:gd name="T4" fmla="*/ 138 w 4671"/>
              <a:gd name="T5" fmla="*/ 148 h 1724"/>
              <a:gd name="T6" fmla="*/ 271 w 4671"/>
              <a:gd name="T7" fmla="*/ 148 h 1724"/>
              <a:gd name="T8" fmla="*/ 271 w 4671"/>
              <a:gd name="T9" fmla="*/ 298 h 1724"/>
              <a:gd name="T10" fmla="*/ 292 w 4671"/>
              <a:gd name="T11" fmla="*/ 298 h 1724"/>
              <a:gd name="T12" fmla="*/ 292 w 4671"/>
              <a:gd name="T13" fmla="*/ 450 h 1724"/>
              <a:gd name="T14" fmla="*/ 411 w 4671"/>
              <a:gd name="T15" fmla="*/ 450 h 1724"/>
              <a:gd name="T16" fmla="*/ 411 w 4671"/>
              <a:gd name="T17" fmla="*/ 600 h 1724"/>
              <a:gd name="T18" fmla="*/ 486 w 4671"/>
              <a:gd name="T19" fmla="*/ 600 h 1724"/>
              <a:gd name="T20" fmla="*/ 486 w 4671"/>
              <a:gd name="T21" fmla="*/ 748 h 1724"/>
              <a:gd name="T22" fmla="*/ 657 w 4671"/>
              <a:gd name="T23" fmla="*/ 748 h 1724"/>
              <a:gd name="T24" fmla="*/ 657 w 4671"/>
              <a:gd name="T25" fmla="*/ 897 h 1724"/>
              <a:gd name="T26" fmla="*/ 699 w 4671"/>
              <a:gd name="T27" fmla="*/ 897 h 1724"/>
              <a:gd name="T28" fmla="*/ 699 w 4671"/>
              <a:gd name="T29" fmla="*/ 1047 h 1724"/>
              <a:gd name="T30" fmla="*/ 708 w 4671"/>
              <a:gd name="T31" fmla="*/ 1047 h 1724"/>
              <a:gd name="T32" fmla="*/ 708 w 4671"/>
              <a:gd name="T33" fmla="*/ 1197 h 1724"/>
              <a:gd name="T34" fmla="*/ 726 w 4671"/>
              <a:gd name="T35" fmla="*/ 1197 h 1724"/>
              <a:gd name="T36" fmla="*/ 766 w 4671"/>
              <a:gd name="T37" fmla="*/ 1197 h 1724"/>
              <a:gd name="T38" fmla="*/ 766 w 4671"/>
              <a:gd name="T39" fmla="*/ 1355 h 1724"/>
              <a:gd name="T40" fmla="*/ 1630 w 4671"/>
              <a:gd name="T41" fmla="*/ 1355 h 1724"/>
              <a:gd name="T42" fmla="*/ 1630 w 4671"/>
              <a:gd name="T43" fmla="*/ 1516 h 1724"/>
              <a:gd name="T44" fmla="*/ 1640 w 4671"/>
              <a:gd name="T45" fmla="*/ 1516 h 1724"/>
              <a:gd name="T46" fmla="*/ 2427 w 4671"/>
              <a:gd name="T47" fmla="*/ 1516 h 1724"/>
              <a:gd name="T48" fmla="*/ 2613 w 4671"/>
              <a:gd name="T49" fmla="*/ 1516 h 1724"/>
              <a:gd name="T50" fmla="*/ 2713 w 4671"/>
              <a:gd name="T51" fmla="*/ 1516 h 1724"/>
              <a:gd name="T52" fmla="*/ 2713 w 4671"/>
              <a:gd name="T53" fmla="*/ 1724 h 1724"/>
              <a:gd name="T54" fmla="*/ 2911 w 4671"/>
              <a:gd name="T55" fmla="*/ 1724 h 1724"/>
              <a:gd name="T56" fmla="*/ 3665 w 4671"/>
              <a:gd name="T57" fmla="*/ 1724 h 1724"/>
              <a:gd name="T58" fmla="*/ 3681 w 4671"/>
              <a:gd name="T59" fmla="*/ 1724 h 1724"/>
              <a:gd name="T60" fmla="*/ 3729 w 4671"/>
              <a:gd name="T61" fmla="*/ 1724 h 1724"/>
              <a:gd name="T62" fmla="*/ 3859 w 4671"/>
              <a:gd name="T63" fmla="*/ 1724 h 1724"/>
              <a:gd name="T64" fmla="*/ 3934 w 4671"/>
              <a:gd name="T65" fmla="*/ 1724 h 1724"/>
              <a:gd name="T66" fmla="*/ 4101 w 4671"/>
              <a:gd name="T67" fmla="*/ 1724 h 1724"/>
              <a:gd name="T68" fmla="*/ 4307 w 4671"/>
              <a:gd name="T69" fmla="*/ 1724 h 1724"/>
              <a:gd name="T70" fmla="*/ 4671 w 4671"/>
              <a:gd name="T71" fmla="*/ 1724 h 17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</a:cxnLst>
            <a:rect l="0" t="0" r="r" b="b"/>
            <a:pathLst>
              <a:path w="4671" h="1724">
                <a:moveTo>
                  <a:pt x="0" y="0"/>
                </a:moveTo>
                <a:lnTo>
                  <a:pt x="138" y="0"/>
                </a:lnTo>
                <a:lnTo>
                  <a:pt x="138" y="148"/>
                </a:lnTo>
                <a:lnTo>
                  <a:pt x="271" y="148"/>
                </a:lnTo>
                <a:lnTo>
                  <a:pt x="271" y="298"/>
                </a:lnTo>
                <a:lnTo>
                  <a:pt x="292" y="298"/>
                </a:lnTo>
                <a:lnTo>
                  <a:pt x="292" y="450"/>
                </a:lnTo>
                <a:lnTo>
                  <a:pt x="411" y="450"/>
                </a:lnTo>
                <a:lnTo>
                  <a:pt x="411" y="600"/>
                </a:lnTo>
                <a:lnTo>
                  <a:pt x="486" y="600"/>
                </a:lnTo>
                <a:lnTo>
                  <a:pt x="486" y="748"/>
                </a:lnTo>
                <a:lnTo>
                  <a:pt x="657" y="748"/>
                </a:lnTo>
                <a:lnTo>
                  <a:pt x="657" y="897"/>
                </a:lnTo>
                <a:lnTo>
                  <a:pt x="699" y="897"/>
                </a:lnTo>
                <a:lnTo>
                  <a:pt x="699" y="1047"/>
                </a:lnTo>
                <a:lnTo>
                  <a:pt x="708" y="1047"/>
                </a:lnTo>
                <a:lnTo>
                  <a:pt x="708" y="1197"/>
                </a:lnTo>
                <a:lnTo>
                  <a:pt x="726" y="1197"/>
                </a:lnTo>
                <a:lnTo>
                  <a:pt x="766" y="1197"/>
                </a:lnTo>
                <a:lnTo>
                  <a:pt x="766" y="1355"/>
                </a:lnTo>
                <a:lnTo>
                  <a:pt x="1630" y="1355"/>
                </a:lnTo>
                <a:lnTo>
                  <a:pt x="1630" y="1516"/>
                </a:lnTo>
                <a:lnTo>
                  <a:pt x="1640" y="1516"/>
                </a:lnTo>
                <a:lnTo>
                  <a:pt x="2427" y="1516"/>
                </a:lnTo>
                <a:lnTo>
                  <a:pt x="2613" y="1516"/>
                </a:lnTo>
                <a:lnTo>
                  <a:pt x="2713" y="1516"/>
                </a:lnTo>
                <a:lnTo>
                  <a:pt x="2713" y="1724"/>
                </a:lnTo>
                <a:lnTo>
                  <a:pt x="2911" y="1724"/>
                </a:lnTo>
                <a:lnTo>
                  <a:pt x="3665" y="1724"/>
                </a:lnTo>
                <a:lnTo>
                  <a:pt x="3681" y="1724"/>
                </a:lnTo>
                <a:lnTo>
                  <a:pt x="3729" y="1724"/>
                </a:lnTo>
                <a:lnTo>
                  <a:pt x="3859" y="1724"/>
                </a:lnTo>
                <a:lnTo>
                  <a:pt x="3934" y="1724"/>
                </a:lnTo>
                <a:lnTo>
                  <a:pt x="4101" y="1724"/>
                </a:lnTo>
                <a:lnTo>
                  <a:pt x="4307" y="1724"/>
                </a:lnTo>
                <a:lnTo>
                  <a:pt x="4671" y="1724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30357BB-61E2-4777-8A9B-B9195A00A3A5}"/>
              </a:ext>
            </a:extLst>
          </p:cNvPr>
          <p:cNvSpPr txBox="1"/>
          <p:nvPr/>
        </p:nvSpPr>
        <p:spPr>
          <a:xfrm>
            <a:off x="2481072" y="1078992"/>
            <a:ext cx="1591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patient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54061310-9D15-40EF-B617-C8E689ECB3A7}"/>
              </a:ext>
            </a:extLst>
          </p:cNvPr>
          <p:cNvSpPr txBox="1"/>
          <p:nvPr/>
        </p:nvSpPr>
        <p:spPr>
          <a:xfrm>
            <a:off x="8763000" y="1078992"/>
            <a:ext cx="1591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patient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D8858ABC-4786-496C-87B1-5DCB9EDADA8A}"/>
              </a:ext>
            </a:extLst>
          </p:cNvPr>
          <p:cNvSpPr txBox="1"/>
          <p:nvPr/>
        </p:nvSpPr>
        <p:spPr>
          <a:xfrm>
            <a:off x="0" y="36576"/>
            <a:ext cx="2258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Fig. 2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33389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5">
            <a:extLst>
              <a:ext uri="{FF2B5EF4-FFF2-40B4-BE49-F238E27FC236}">
                <a16:creationId xmlns:a16="http://schemas.microsoft.com/office/drawing/2014/main" id="{B1115143-9495-4C44-BF33-8C57E8067E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91706" y="1541728"/>
            <a:ext cx="15112" cy="1728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5815F14-F85F-4A2E-ADE1-1433426C194B}"/>
              </a:ext>
            </a:extLst>
          </p:cNvPr>
          <p:cNvSpPr txBox="1"/>
          <p:nvPr/>
        </p:nvSpPr>
        <p:spPr>
          <a:xfrm rot="16200000">
            <a:off x="-576404" y="3453764"/>
            <a:ext cx="20394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bability of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A534DE1-D287-457F-A0F6-B8E647CDAB2E}"/>
              </a:ext>
            </a:extLst>
          </p:cNvPr>
          <p:cNvSpPr txBox="1"/>
          <p:nvPr/>
        </p:nvSpPr>
        <p:spPr>
          <a:xfrm>
            <a:off x="304828" y="1252023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9B987067-4DCC-4966-A6DE-692BDA6FF9FB}"/>
              </a:ext>
            </a:extLst>
          </p:cNvPr>
          <p:cNvCxnSpPr>
            <a:cxnSpLocks/>
          </p:cNvCxnSpPr>
          <p:nvPr/>
        </p:nvCxnSpPr>
        <p:spPr>
          <a:xfrm>
            <a:off x="1125437" y="1503350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6C36961C-999B-4EDD-B3E6-CBDFA3D37C0D}"/>
              </a:ext>
            </a:extLst>
          </p:cNvPr>
          <p:cNvGrpSpPr/>
          <p:nvPr/>
        </p:nvGrpSpPr>
        <p:grpSpPr>
          <a:xfrm>
            <a:off x="750302" y="1714573"/>
            <a:ext cx="4590085" cy="4124950"/>
            <a:chOff x="684686" y="1423988"/>
            <a:chExt cx="3857353" cy="3030859"/>
          </a:xfrm>
        </p:grpSpPr>
        <p:sp>
          <p:nvSpPr>
            <p:cNvPr id="9" name="Rectangle 45">
              <a:extLst>
                <a:ext uri="{FF2B5EF4-FFF2-40B4-BE49-F238E27FC236}">
                  <a16:creationId xmlns:a16="http://schemas.microsoft.com/office/drawing/2014/main" id="{CBACB78C-1C25-4532-8D62-56928E2D17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0266" y="4341776"/>
              <a:ext cx="643918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(months)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5">
              <a:extLst>
                <a:ext uri="{FF2B5EF4-FFF2-40B4-BE49-F238E27FC236}">
                  <a16:creationId xmlns:a16="http://schemas.microsoft.com/office/drawing/2014/main" id="{E1D02969-B6CC-4C26-BACC-ACD7D529C7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700" y="1423988"/>
              <a:ext cx="12700" cy="127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6">
              <a:extLst>
                <a:ext uri="{FF2B5EF4-FFF2-40B4-BE49-F238E27FC236}">
                  <a16:creationId xmlns:a16="http://schemas.microsoft.com/office/drawing/2014/main" id="{81198873-E377-4E1A-AD98-0AA51313DF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963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7">
              <a:extLst>
                <a:ext uri="{FF2B5EF4-FFF2-40B4-BE49-F238E27FC236}">
                  <a16:creationId xmlns:a16="http://schemas.microsoft.com/office/drawing/2014/main" id="{C8DE1B10-58B7-469D-B3D6-286698AD84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849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8">
              <a:extLst>
                <a:ext uri="{FF2B5EF4-FFF2-40B4-BE49-F238E27FC236}">
                  <a16:creationId xmlns:a16="http://schemas.microsoft.com/office/drawing/2014/main" id="{6ABC764C-8783-4816-BF06-691BD682B1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37605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9">
              <a:extLst>
                <a:ext uri="{FF2B5EF4-FFF2-40B4-BE49-F238E27FC236}">
                  <a16:creationId xmlns:a16="http://schemas.microsoft.com/office/drawing/2014/main" id="{EF772464-5674-4F36-B431-D5A1B3690B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544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0">
              <a:extLst>
                <a:ext uri="{FF2B5EF4-FFF2-40B4-BE49-F238E27FC236}">
                  <a16:creationId xmlns:a16="http://schemas.microsoft.com/office/drawing/2014/main" id="{3D00D977-80C6-4BFB-9FD9-13E872ACB2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430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Line 11">
              <a:extLst>
                <a:ext uri="{FF2B5EF4-FFF2-40B4-BE49-F238E27FC236}">
                  <a16:creationId xmlns:a16="http://schemas.microsoft.com/office/drawing/2014/main" id="{34B059CA-9E11-47D2-A338-91488A0E7F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3341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12">
              <a:extLst>
                <a:ext uri="{FF2B5EF4-FFF2-40B4-BE49-F238E27FC236}">
                  <a16:creationId xmlns:a16="http://schemas.microsoft.com/office/drawing/2014/main" id="{0647C739-6981-4623-9319-1C1A52B811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1382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3">
              <a:extLst>
                <a:ext uri="{FF2B5EF4-FFF2-40B4-BE49-F238E27FC236}">
                  <a16:creationId xmlns:a16="http://schemas.microsoft.com/office/drawing/2014/main" id="{D88ED72B-9DF1-40FF-B5A8-BE99FA2CD7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0239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Line 14">
              <a:extLst>
                <a:ext uri="{FF2B5EF4-FFF2-40B4-BE49-F238E27FC236}">
                  <a16:creationId xmlns:a16="http://schemas.microsoft.com/office/drawing/2014/main" id="{A40DE045-4A97-4A67-8612-92D82860BC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9350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15">
              <a:extLst>
                <a:ext uri="{FF2B5EF4-FFF2-40B4-BE49-F238E27FC236}">
                  <a16:creationId xmlns:a16="http://schemas.microsoft.com/office/drawing/2014/main" id="{4DD4D25D-6E7E-4DA2-92EC-50A3CFEED0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27191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6">
              <a:extLst>
                <a:ext uri="{FF2B5EF4-FFF2-40B4-BE49-F238E27FC236}">
                  <a16:creationId xmlns:a16="http://schemas.microsoft.com/office/drawing/2014/main" id="{8B496F13-A082-4208-A7F9-85C06D29EB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26048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17">
              <a:extLst>
                <a:ext uri="{FF2B5EF4-FFF2-40B4-BE49-F238E27FC236}">
                  <a16:creationId xmlns:a16="http://schemas.microsoft.com/office/drawing/2014/main" id="{FBA2C5CA-79AD-4E57-94D1-56826141CF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5159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18">
              <a:extLst>
                <a:ext uri="{FF2B5EF4-FFF2-40B4-BE49-F238E27FC236}">
                  <a16:creationId xmlns:a16="http://schemas.microsoft.com/office/drawing/2014/main" id="{C3BF85FB-BE6B-45B8-88A8-6ECD0878AE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2312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19">
              <a:extLst>
                <a:ext uri="{FF2B5EF4-FFF2-40B4-BE49-F238E27FC236}">
                  <a16:creationId xmlns:a16="http://schemas.microsoft.com/office/drawing/2014/main" id="{2033FD13-F0F6-41DD-AA16-01D3CBFF45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2198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0">
              <a:extLst>
                <a:ext uri="{FF2B5EF4-FFF2-40B4-BE49-F238E27FC236}">
                  <a16:creationId xmlns:a16="http://schemas.microsoft.com/office/drawing/2014/main" id="{92AA39B5-171D-43AA-85E0-1315472BEA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0968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1">
              <a:extLst>
                <a:ext uri="{FF2B5EF4-FFF2-40B4-BE49-F238E27FC236}">
                  <a16:creationId xmlns:a16="http://schemas.microsoft.com/office/drawing/2014/main" id="{289DCD35-9630-4A3D-96FD-0CE04DC5A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1893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2">
              <a:extLst>
                <a:ext uri="{FF2B5EF4-FFF2-40B4-BE49-F238E27FC236}">
                  <a16:creationId xmlns:a16="http://schemas.microsoft.com/office/drawing/2014/main" id="{E337351A-31BE-4185-9886-4F53FC8BA6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1779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23">
              <a:extLst>
                <a:ext uri="{FF2B5EF4-FFF2-40B4-BE49-F238E27FC236}">
                  <a16:creationId xmlns:a16="http://schemas.microsoft.com/office/drawing/2014/main" id="{900857D4-1914-4ADE-80E0-152D62FB42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1690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Line 31">
              <a:extLst>
                <a:ext uri="{FF2B5EF4-FFF2-40B4-BE49-F238E27FC236}">
                  <a16:creationId xmlns:a16="http://schemas.microsoft.com/office/drawing/2014/main" id="{7FA77F55-D109-4E98-A053-D29199A982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48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81189238-2730-48F0-8D9D-22D4FB82B6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4086" y="4052680"/>
              <a:ext cx="53884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Line 33">
              <a:extLst>
                <a:ext uri="{FF2B5EF4-FFF2-40B4-BE49-F238E27FC236}">
                  <a16:creationId xmlns:a16="http://schemas.microsoft.com/office/drawing/2014/main" id="{D413805E-51A9-41FC-9061-CF1657675E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085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B213B726-493F-4FB9-B05B-AE9EE342F6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96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Line 35">
              <a:extLst>
                <a:ext uri="{FF2B5EF4-FFF2-40B4-BE49-F238E27FC236}">
                  <a16:creationId xmlns:a16="http://schemas.microsoft.com/office/drawing/2014/main" id="{DDD502A4-DE86-4DC3-B29C-EFC83393AB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895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F111C11A-E5C4-4B2D-AC98-A68D3221B9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06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Line 37">
              <a:extLst>
                <a:ext uri="{FF2B5EF4-FFF2-40B4-BE49-F238E27FC236}">
                  <a16:creationId xmlns:a16="http://schemas.microsoft.com/office/drawing/2014/main" id="{775D1D83-9FE9-40CB-AFB9-A5A9287C65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32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F67B30F3-0B25-43D7-837B-1873B8EB96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43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Line 39">
              <a:extLst>
                <a:ext uri="{FF2B5EF4-FFF2-40B4-BE49-F238E27FC236}">
                  <a16:creationId xmlns:a16="http://schemas.microsoft.com/office/drawing/2014/main" id="{6F6C327E-9727-4064-BB56-C59ED00820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69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CCF4FC84-D300-443D-AAE9-98C7D890F6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80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Line 41">
              <a:extLst>
                <a:ext uri="{FF2B5EF4-FFF2-40B4-BE49-F238E27FC236}">
                  <a16:creationId xmlns:a16="http://schemas.microsoft.com/office/drawing/2014/main" id="{DAE8F3C8-CACA-4F94-ADF9-F79B096BEE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579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6AD6FC54-12FE-487C-83EB-D21AC3AB8F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82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Line 43">
              <a:extLst>
                <a:ext uri="{FF2B5EF4-FFF2-40B4-BE49-F238E27FC236}">
                  <a16:creationId xmlns:a16="http://schemas.microsoft.com/office/drawing/2014/main" id="{8323EBA0-2C57-4E3F-BAE9-0A976938BE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516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03D90D5B-416D-43DD-AC87-E8FCD50957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19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Line 45">
              <a:extLst>
                <a:ext uri="{FF2B5EF4-FFF2-40B4-BE49-F238E27FC236}">
                  <a16:creationId xmlns:a16="http://schemas.microsoft.com/office/drawing/2014/main" id="{A8463F09-8C7B-41CF-9BA4-E746D01D14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53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46EE9B1D-AE33-4CD4-B551-F70364EB4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56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Line 47">
              <a:extLst>
                <a:ext uri="{FF2B5EF4-FFF2-40B4-BE49-F238E27FC236}">
                  <a16:creationId xmlns:a16="http://schemas.microsoft.com/office/drawing/2014/main" id="{3AA36CA2-BA8C-4C02-862C-8F182C9449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263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178291A9-1C61-480A-B80B-4EA006A90E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66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Line 49">
              <a:extLst>
                <a:ext uri="{FF2B5EF4-FFF2-40B4-BE49-F238E27FC236}">
                  <a16:creationId xmlns:a16="http://schemas.microsoft.com/office/drawing/2014/main" id="{52DE115A-8147-46DC-86A6-26EA20DC91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00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C65AA564-D89D-42AB-997D-CBB8EE30DC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03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16F26561-AF15-4FF8-B62D-C83F9A1FF6BD}"/>
                </a:ext>
              </a:extLst>
            </p:cNvPr>
            <p:cNvCxnSpPr/>
            <p:nvPr/>
          </p:nvCxnSpPr>
          <p:spPr>
            <a:xfrm flipV="1">
              <a:off x="1012367" y="1665919"/>
              <a:ext cx="0" cy="228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7838F753-8D26-4966-AD60-9ACAD8665A22}"/>
                </a:ext>
              </a:extLst>
            </p:cNvPr>
            <p:cNvCxnSpPr/>
            <p:nvPr/>
          </p:nvCxnSpPr>
          <p:spPr>
            <a:xfrm>
              <a:off x="995836" y="3963780"/>
              <a:ext cx="3505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A19CE15-0DA7-46A2-96AF-DE2CBA7EDC0C}"/>
              </a:ext>
            </a:extLst>
          </p:cNvPr>
          <p:cNvSpPr txBox="1"/>
          <p:nvPr/>
        </p:nvSpPr>
        <p:spPr>
          <a:xfrm rot="16200000">
            <a:off x="5323044" y="3286833"/>
            <a:ext cx="2373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 of disease-free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54">
            <a:extLst>
              <a:ext uri="{FF2B5EF4-FFF2-40B4-BE49-F238E27FC236}">
                <a16:creationId xmlns:a16="http://schemas.microsoft.com/office/drawing/2014/main" id="{5ADE0D89-CBF1-46CF-8F20-E2E07437B1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2855" y="185285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62">
            <a:extLst>
              <a:ext uri="{FF2B5EF4-FFF2-40B4-BE49-F238E27FC236}">
                <a16:creationId xmlns:a16="http://schemas.microsoft.com/office/drawing/2014/main" id="{86AEE0FB-2B10-449F-9149-89178B9D17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2001" y="158494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439EA555-CA1D-494C-8D48-CC121B1D8A6C}"/>
              </a:ext>
            </a:extLst>
          </p:cNvPr>
          <p:cNvSpPr txBox="1"/>
          <p:nvPr/>
        </p:nvSpPr>
        <p:spPr>
          <a:xfrm>
            <a:off x="6344898" y="12520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36218B09-70A0-492C-8B3F-BD3D19723A59}"/>
              </a:ext>
            </a:extLst>
          </p:cNvPr>
          <p:cNvGrpSpPr/>
          <p:nvPr/>
        </p:nvGrpSpPr>
        <p:grpSpPr>
          <a:xfrm>
            <a:off x="6886634" y="2077271"/>
            <a:ext cx="4590085" cy="3762263"/>
            <a:chOff x="7459931" y="1690480"/>
            <a:chExt cx="3857353" cy="2764367"/>
          </a:xfrm>
        </p:grpSpPr>
        <p:sp>
          <p:nvSpPr>
            <p:cNvPr id="62" name="Line 63">
              <a:extLst>
                <a:ext uri="{FF2B5EF4-FFF2-40B4-BE49-F238E27FC236}">
                  <a16:creationId xmlns:a16="http://schemas.microsoft.com/office/drawing/2014/main" id="{41F20D0C-E0AF-42F7-B58B-6C605EF4AF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9764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4">
              <a:extLst>
                <a:ext uri="{FF2B5EF4-FFF2-40B4-BE49-F238E27FC236}">
                  <a16:creationId xmlns:a16="http://schemas.microsoft.com/office/drawing/2014/main" id="{83553F3B-8E08-4AB6-A0F8-9B9A44F3FF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8621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Line 65">
              <a:extLst>
                <a:ext uri="{FF2B5EF4-FFF2-40B4-BE49-F238E27FC236}">
                  <a16:creationId xmlns:a16="http://schemas.microsoft.com/office/drawing/2014/main" id="{4C7A6457-115C-48F4-88FB-17F890035C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7732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66">
              <a:extLst>
                <a:ext uri="{FF2B5EF4-FFF2-40B4-BE49-F238E27FC236}">
                  <a16:creationId xmlns:a16="http://schemas.microsoft.com/office/drawing/2014/main" id="{3305D2F6-BF2B-46EE-9670-112914A723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5573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7">
              <a:extLst>
                <a:ext uri="{FF2B5EF4-FFF2-40B4-BE49-F238E27FC236}">
                  <a16:creationId xmlns:a16="http://schemas.microsoft.com/office/drawing/2014/main" id="{DFD05DB3-5F97-4F0D-A0FA-EF45BB9435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4430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68">
              <a:extLst>
                <a:ext uri="{FF2B5EF4-FFF2-40B4-BE49-F238E27FC236}">
                  <a16:creationId xmlns:a16="http://schemas.microsoft.com/office/drawing/2014/main" id="{F04FC540-040E-48DD-9641-D4FE9BACC6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3541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Line 69">
              <a:extLst>
                <a:ext uri="{FF2B5EF4-FFF2-40B4-BE49-F238E27FC236}">
                  <a16:creationId xmlns:a16="http://schemas.microsoft.com/office/drawing/2014/main" id="{B1E8748E-4C60-4417-8A52-2F0BA25A44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1509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70">
              <a:extLst>
                <a:ext uri="{FF2B5EF4-FFF2-40B4-BE49-F238E27FC236}">
                  <a16:creationId xmlns:a16="http://schemas.microsoft.com/office/drawing/2014/main" id="{E6DA65AB-DAB6-4C44-8C0E-56B5F98C7F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0366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Line 71">
              <a:extLst>
                <a:ext uri="{FF2B5EF4-FFF2-40B4-BE49-F238E27FC236}">
                  <a16:creationId xmlns:a16="http://schemas.microsoft.com/office/drawing/2014/main" id="{E0B76009-2AE0-4B69-ABEA-447C4F4FC7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9350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72">
              <a:extLst>
                <a:ext uri="{FF2B5EF4-FFF2-40B4-BE49-F238E27FC236}">
                  <a16:creationId xmlns:a16="http://schemas.microsoft.com/office/drawing/2014/main" id="{93F0280B-851B-49B1-9957-8AA88487A7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7318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3">
              <a:extLst>
                <a:ext uri="{FF2B5EF4-FFF2-40B4-BE49-F238E27FC236}">
                  <a16:creationId xmlns:a16="http://schemas.microsoft.com/office/drawing/2014/main" id="{1307051F-6A0E-4F4D-B7FA-7BDD4E63CF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6175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74">
              <a:extLst>
                <a:ext uri="{FF2B5EF4-FFF2-40B4-BE49-F238E27FC236}">
                  <a16:creationId xmlns:a16="http://schemas.microsoft.com/office/drawing/2014/main" id="{282329DE-F3D9-4A5E-83CE-3337E18411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5159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75">
              <a:extLst>
                <a:ext uri="{FF2B5EF4-FFF2-40B4-BE49-F238E27FC236}">
                  <a16:creationId xmlns:a16="http://schemas.microsoft.com/office/drawing/2014/main" id="{A60AD0E9-8E61-4AC3-ADDD-4F7AC3567F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312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6">
              <a:extLst>
                <a:ext uri="{FF2B5EF4-FFF2-40B4-BE49-F238E27FC236}">
                  <a16:creationId xmlns:a16="http://schemas.microsoft.com/office/drawing/2014/main" id="{879224D7-A042-4A35-8D58-C7D3C5C07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198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77">
              <a:extLst>
                <a:ext uri="{FF2B5EF4-FFF2-40B4-BE49-F238E27FC236}">
                  <a16:creationId xmlns:a16="http://schemas.microsoft.com/office/drawing/2014/main" id="{08824B05-68E4-4F80-9155-B84D351080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1095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78">
              <a:extLst>
                <a:ext uri="{FF2B5EF4-FFF2-40B4-BE49-F238E27FC236}">
                  <a16:creationId xmlns:a16="http://schemas.microsoft.com/office/drawing/2014/main" id="{61BDC263-2846-407F-BBF1-F5CD38FE77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1893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9">
              <a:extLst>
                <a:ext uri="{FF2B5EF4-FFF2-40B4-BE49-F238E27FC236}">
                  <a16:creationId xmlns:a16="http://schemas.microsoft.com/office/drawing/2014/main" id="{38540C36-D3E0-4EC7-BBBF-90FE8F9A61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1779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80">
              <a:extLst>
                <a:ext uri="{FF2B5EF4-FFF2-40B4-BE49-F238E27FC236}">
                  <a16:creationId xmlns:a16="http://schemas.microsoft.com/office/drawing/2014/main" id="{E3213FA5-EE36-4249-ABE8-B62B7BAB1F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1690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88">
              <a:extLst>
                <a:ext uri="{FF2B5EF4-FFF2-40B4-BE49-F238E27FC236}">
                  <a16:creationId xmlns:a16="http://schemas.microsoft.com/office/drawing/2014/main" id="{FBC427DB-5467-4F7D-9CC8-D3A80CFD34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901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9">
              <a:extLst>
                <a:ext uri="{FF2B5EF4-FFF2-40B4-BE49-F238E27FC236}">
                  <a16:creationId xmlns:a16="http://schemas.microsoft.com/office/drawing/2014/main" id="{27F7BF80-1498-4857-9419-C89A9A3007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39331" y="4065380"/>
              <a:ext cx="53884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Line 90">
              <a:extLst>
                <a:ext uri="{FF2B5EF4-FFF2-40B4-BE49-F238E27FC236}">
                  <a16:creationId xmlns:a16="http://schemas.microsoft.com/office/drawing/2014/main" id="{25E60813-C7B0-4EEE-AFDF-31A3EF2679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3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91">
              <a:extLst>
                <a:ext uri="{FF2B5EF4-FFF2-40B4-BE49-F238E27FC236}">
                  <a16:creationId xmlns:a16="http://schemas.microsoft.com/office/drawing/2014/main" id="{30557258-2C77-421B-8051-C146DC7BE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4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Line 92">
              <a:extLst>
                <a:ext uri="{FF2B5EF4-FFF2-40B4-BE49-F238E27FC236}">
                  <a16:creationId xmlns:a16="http://schemas.microsoft.com/office/drawing/2014/main" id="{47B82442-125E-4C02-9613-56B5A88FCE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64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93">
              <a:extLst>
                <a:ext uri="{FF2B5EF4-FFF2-40B4-BE49-F238E27FC236}">
                  <a16:creationId xmlns:a16="http://schemas.microsoft.com/office/drawing/2014/main" id="{67DA3106-B6CE-4AF9-8129-9C14D84B2B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75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Line 94">
              <a:extLst>
                <a:ext uri="{FF2B5EF4-FFF2-40B4-BE49-F238E27FC236}">
                  <a16:creationId xmlns:a16="http://schemas.microsoft.com/office/drawing/2014/main" id="{EA2DA26D-0B9D-42AD-A6D3-8633AB6FD6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585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95">
              <a:extLst>
                <a:ext uri="{FF2B5EF4-FFF2-40B4-BE49-F238E27FC236}">
                  <a16:creationId xmlns:a16="http://schemas.microsoft.com/office/drawing/2014/main" id="{07BDF8C0-AD27-4329-9C53-8012ABD7D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96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Line 96">
              <a:extLst>
                <a:ext uri="{FF2B5EF4-FFF2-40B4-BE49-F238E27FC236}">
                  <a16:creationId xmlns:a16="http://schemas.microsoft.com/office/drawing/2014/main" id="{706C4FB7-1F4B-4E59-A919-663C3D0EC7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52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97">
              <a:extLst>
                <a:ext uri="{FF2B5EF4-FFF2-40B4-BE49-F238E27FC236}">
                  <a16:creationId xmlns:a16="http://schemas.microsoft.com/office/drawing/2014/main" id="{3BFDB2BF-179C-4E31-AB61-684AD23FD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633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Line 98">
              <a:extLst>
                <a:ext uri="{FF2B5EF4-FFF2-40B4-BE49-F238E27FC236}">
                  <a16:creationId xmlns:a16="http://schemas.microsoft.com/office/drawing/2014/main" id="{21AC52E1-371D-427F-BE5D-6A90BAF3EF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33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9">
              <a:extLst>
                <a:ext uri="{FF2B5EF4-FFF2-40B4-BE49-F238E27FC236}">
                  <a16:creationId xmlns:a16="http://schemas.microsoft.com/office/drawing/2014/main" id="{03D4FA76-5ACA-458B-A5D9-CE7E504882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935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Line 100">
              <a:extLst>
                <a:ext uri="{FF2B5EF4-FFF2-40B4-BE49-F238E27FC236}">
                  <a16:creationId xmlns:a16="http://schemas.microsoft.com/office/drawing/2014/main" id="{5C2A47F8-A813-47B1-9253-05D0DB7651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269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101">
              <a:extLst>
                <a:ext uri="{FF2B5EF4-FFF2-40B4-BE49-F238E27FC236}">
                  <a16:creationId xmlns:a16="http://schemas.microsoft.com/office/drawing/2014/main" id="{5485F41C-78F6-49C2-8154-A0F1C2F2E8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72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Line 102">
              <a:extLst>
                <a:ext uri="{FF2B5EF4-FFF2-40B4-BE49-F238E27FC236}">
                  <a16:creationId xmlns:a16="http://schemas.microsoft.com/office/drawing/2014/main" id="{421C9D4D-AD36-4AFB-884C-190B38C9E8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0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103">
              <a:extLst>
                <a:ext uri="{FF2B5EF4-FFF2-40B4-BE49-F238E27FC236}">
                  <a16:creationId xmlns:a16="http://schemas.microsoft.com/office/drawing/2014/main" id="{ED7AF7CF-DBD1-40B3-81CA-5A2D8DE7E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0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Line 104">
              <a:extLst>
                <a:ext uri="{FF2B5EF4-FFF2-40B4-BE49-F238E27FC236}">
                  <a16:creationId xmlns:a16="http://schemas.microsoft.com/office/drawing/2014/main" id="{A4D98045-6380-4369-9C98-80EF061F76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01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105">
              <a:extLst>
                <a:ext uri="{FF2B5EF4-FFF2-40B4-BE49-F238E27FC236}">
                  <a16:creationId xmlns:a16="http://schemas.microsoft.com/office/drawing/2014/main" id="{64D288A7-D11F-453A-B3A3-758634E72C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61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Line 106">
              <a:extLst>
                <a:ext uri="{FF2B5EF4-FFF2-40B4-BE49-F238E27FC236}">
                  <a16:creationId xmlns:a16="http://schemas.microsoft.com/office/drawing/2014/main" id="{7A47BB4C-8D3C-41AB-A54D-B7D380450F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953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107">
              <a:extLst>
                <a:ext uri="{FF2B5EF4-FFF2-40B4-BE49-F238E27FC236}">
                  <a16:creationId xmlns:a16="http://schemas.microsoft.com/office/drawing/2014/main" id="{8A60A163-C5E9-4A76-BFEC-AF0AA369E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556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2" name="グループ化 101">
              <a:extLst>
                <a:ext uri="{FF2B5EF4-FFF2-40B4-BE49-F238E27FC236}">
                  <a16:creationId xmlns:a16="http://schemas.microsoft.com/office/drawing/2014/main" id="{DF8F8734-00E3-4B05-B0AF-441F97D44B2E}"/>
                </a:ext>
              </a:extLst>
            </p:cNvPr>
            <p:cNvGrpSpPr/>
            <p:nvPr/>
          </p:nvGrpSpPr>
          <p:grpSpPr>
            <a:xfrm>
              <a:off x="7790131" y="1690480"/>
              <a:ext cx="3505200" cy="2764367"/>
              <a:chOff x="7009954" y="1690480"/>
              <a:chExt cx="3505200" cy="2764367"/>
            </a:xfrm>
          </p:grpSpPr>
          <p:sp>
            <p:nvSpPr>
              <p:cNvPr id="104" name="Rectangle 45">
                <a:extLst>
                  <a:ext uri="{FF2B5EF4-FFF2-40B4-BE49-F238E27FC236}">
                    <a16:creationId xmlns:a16="http://schemas.microsoft.com/office/drawing/2014/main" id="{21DAD6E6-888F-4B4A-9BAF-5CC391EEC7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04384" y="4341776"/>
                <a:ext cx="643918" cy="113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Time (months)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5" name="グループ化 104">
                <a:extLst>
                  <a:ext uri="{FF2B5EF4-FFF2-40B4-BE49-F238E27FC236}">
                    <a16:creationId xmlns:a16="http://schemas.microsoft.com/office/drawing/2014/main" id="{374252DF-92F4-4689-B375-08CDA6EA4601}"/>
                  </a:ext>
                </a:extLst>
              </p:cNvPr>
              <p:cNvGrpSpPr/>
              <p:nvPr/>
            </p:nvGrpSpPr>
            <p:grpSpPr>
              <a:xfrm>
                <a:off x="7009954" y="1690480"/>
                <a:ext cx="3505200" cy="2286000"/>
                <a:chOff x="7009954" y="1690480"/>
                <a:chExt cx="3505200" cy="2286000"/>
              </a:xfrm>
            </p:grpSpPr>
            <p:cxnSp>
              <p:nvCxnSpPr>
                <p:cNvPr id="109" name="直線コネクタ 108">
                  <a:extLst>
                    <a:ext uri="{FF2B5EF4-FFF2-40B4-BE49-F238E27FC236}">
                      <a16:creationId xmlns:a16="http://schemas.microsoft.com/office/drawing/2014/main" id="{3002C42D-FC6D-4379-86CD-1E7574303729}"/>
                    </a:ext>
                  </a:extLst>
                </p:cNvPr>
                <p:cNvCxnSpPr/>
                <p:nvPr/>
              </p:nvCxnSpPr>
              <p:spPr>
                <a:xfrm flipV="1">
                  <a:off x="7009954" y="1690480"/>
                  <a:ext cx="0" cy="228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コネクタ 106">
                  <a:extLst>
                    <a:ext uri="{FF2B5EF4-FFF2-40B4-BE49-F238E27FC236}">
                      <a16:creationId xmlns:a16="http://schemas.microsoft.com/office/drawing/2014/main" id="{4C9FD613-8D49-4AE1-B91A-6F36E727A319}"/>
                    </a:ext>
                  </a:extLst>
                </p:cNvPr>
                <p:cNvCxnSpPr/>
                <p:nvPr/>
              </p:nvCxnSpPr>
              <p:spPr>
                <a:xfrm>
                  <a:off x="7009954" y="3972169"/>
                  <a:ext cx="3505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F04BF26B-DF10-4A98-9F57-2BA9449440F9}"/>
              </a:ext>
            </a:extLst>
          </p:cNvPr>
          <p:cNvCxnSpPr>
            <a:cxnSpLocks/>
          </p:cNvCxnSpPr>
          <p:nvPr/>
        </p:nvCxnSpPr>
        <p:spPr>
          <a:xfrm>
            <a:off x="7464197" y="1503350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B15B3EB1-AC86-4E9A-9858-708DB9127620}"/>
              </a:ext>
            </a:extLst>
          </p:cNvPr>
          <p:cNvSpPr txBox="1"/>
          <p:nvPr/>
        </p:nvSpPr>
        <p:spPr>
          <a:xfrm>
            <a:off x="3841688" y="2233782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ong course</a:t>
            </a:r>
            <a:endParaRPr kumimoji="1" lang="en-US" altLang="ja-JP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41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D639AFD9-025D-4454-A021-2C90463C0EF8}"/>
              </a:ext>
            </a:extLst>
          </p:cNvPr>
          <p:cNvSpPr txBox="1"/>
          <p:nvPr/>
        </p:nvSpPr>
        <p:spPr>
          <a:xfrm>
            <a:off x="3939706" y="3390491"/>
            <a:ext cx="8098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hort course</a:t>
            </a:r>
            <a:endParaRPr kumimoji="1" lang="en-US" altLang="ja-JP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14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0595C1BE-F240-4791-BD92-06310170C689}"/>
              </a:ext>
            </a:extLst>
          </p:cNvPr>
          <p:cNvSpPr txBox="1"/>
          <p:nvPr/>
        </p:nvSpPr>
        <p:spPr>
          <a:xfrm>
            <a:off x="1251945" y="4792787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=</a:t>
            </a:r>
            <a:r>
              <a:rPr kumimoji="1" lang="en-US" altLang="ja-JP" sz="1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23</a:t>
            </a:r>
            <a:endParaRPr kumimoji="1" lang="ja-JP" altLang="en-US" sz="10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776C3EBA-7E17-49EC-8771-E0105FD1DA1E}"/>
              </a:ext>
            </a:extLst>
          </p:cNvPr>
          <p:cNvSpPr txBox="1"/>
          <p:nvPr/>
        </p:nvSpPr>
        <p:spPr>
          <a:xfrm>
            <a:off x="9845112" y="3044152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ong course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41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70C198C5-7BD2-4687-A821-B207CE107093}"/>
              </a:ext>
            </a:extLst>
          </p:cNvPr>
          <p:cNvSpPr txBox="1"/>
          <p:nvPr/>
        </p:nvSpPr>
        <p:spPr>
          <a:xfrm>
            <a:off x="9845112" y="3723871"/>
            <a:ext cx="8098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hort course</a:t>
            </a:r>
            <a:endParaRPr kumimoji="1" lang="en-US" altLang="ja-JP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14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7AAFB70D-85D0-4456-BA9F-0048EE36819E}"/>
              </a:ext>
            </a:extLst>
          </p:cNvPr>
          <p:cNvSpPr txBox="1"/>
          <p:nvPr/>
        </p:nvSpPr>
        <p:spPr>
          <a:xfrm>
            <a:off x="7372153" y="4792787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</a:t>
            </a:r>
            <a:r>
              <a:rPr kumimoji="1" lang="en-US" altLang="ja-JP" sz="1000" b="0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=</a:t>
            </a:r>
            <a:r>
              <a:rPr kumimoji="1" lang="en-US" altLang="ja-JP" sz="1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52</a:t>
            </a:r>
            <a:endParaRPr kumimoji="1" lang="ja-JP" altLang="en-US" sz="10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4" name="Freeform 90">
            <a:extLst>
              <a:ext uri="{FF2B5EF4-FFF2-40B4-BE49-F238E27FC236}">
                <a16:creationId xmlns:a16="http://schemas.microsoft.com/office/drawing/2014/main" id="{C2F2A659-F255-455C-9631-330EED243598}"/>
              </a:ext>
            </a:extLst>
          </p:cNvPr>
          <p:cNvSpPr>
            <a:spLocks/>
          </p:cNvSpPr>
          <p:nvPr/>
        </p:nvSpPr>
        <p:spPr bwMode="auto">
          <a:xfrm>
            <a:off x="1108508" y="2362417"/>
            <a:ext cx="3349625" cy="323850"/>
          </a:xfrm>
          <a:custGeom>
            <a:avLst/>
            <a:gdLst>
              <a:gd name="T0" fmla="*/ 0 w 4221"/>
              <a:gd name="T1" fmla="*/ 0 h 407"/>
              <a:gd name="T2" fmla="*/ 123 w 4221"/>
              <a:gd name="T3" fmla="*/ 0 h 407"/>
              <a:gd name="T4" fmla="*/ 169 w 4221"/>
              <a:gd name="T5" fmla="*/ 0 h 407"/>
              <a:gd name="T6" fmla="*/ 169 w 4221"/>
              <a:gd name="T7" fmla="*/ 88 h 407"/>
              <a:gd name="T8" fmla="*/ 271 w 4221"/>
              <a:gd name="T9" fmla="*/ 88 h 407"/>
              <a:gd name="T10" fmla="*/ 413 w 4221"/>
              <a:gd name="T11" fmla="*/ 88 h 407"/>
              <a:gd name="T12" fmla="*/ 543 w 4221"/>
              <a:gd name="T13" fmla="*/ 88 h 407"/>
              <a:gd name="T14" fmla="*/ 543 w 4221"/>
              <a:gd name="T15" fmla="*/ 184 h 407"/>
              <a:gd name="T16" fmla="*/ 566 w 4221"/>
              <a:gd name="T17" fmla="*/ 184 h 407"/>
              <a:gd name="T18" fmla="*/ 578 w 4221"/>
              <a:gd name="T19" fmla="*/ 184 h 407"/>
              <a:gd name="T20" fmla="*/ 585 w 4221"/>
              <a:gd name="T21" fmla="*/ 184 h 407"/>
              <a:gd name="T22" fmla="*/ 762 w 4221"/>
              <a:gd name="T23" fmla="*/ 184 h 407"/>
              <a:gd name="T24" fmla="*/ 762 w 4221"/>
              <a:gd name="T25" fmla="*/ 290 h 407"/>
              <a:gd name="T26" fmla="*/ 801 w 4221"/>
              <a:gd name="T27" fmla="*/ 290 h 407"/>
              <a:gd name="T28" fmla="*/ 874 w 4221"/>
              <a:gd name="T29" fmla="*/ 290 h 407"/>
              <a:gd name="T30" fmla="*/ 989 w 4221"/>
              <a:gd name="T31" fmla="*/ 290 h 407"/>
              <a:gd name="T32" fmla="*/ 1043 w 4221"/>
              <a:gd name="T33" fmla="*/ 290 h 407"/>
              <a:gd name="T34" fmla="*/ 1043 w 4221"/>
              <a:gd name="T35" fmla="*/ 407 h 407"/>
              <a:gd name="T36" fmla="*/ 1087 w 4221"/>
              <a:gd name="T37" fmla="*/ 407 h 407"/>
              <a:gd name="T38" fmla="*/ 1188 w 4221"/>
              <a:gd name="T39" fmla="*/ 407 h 407"/>
              <a:gd name="T40" fmla="*/ 1277 w 4221"/>
              <a:gd name="T41" fmla="*/ 407 h 407"/>
              <a:gd name="T42" fmla="*/ 1331 w 4221"/>
              <a:gd name="T43" fmla="*/ 407 h 407"/>
              <a:gd name="T44" fmla="*/ 1457 w 4221"/>
              <a:gd name="T45" fmla="*/ 407 h 407"/>
              <a:gd name="T46" fmla="*/ 1482 w 4221"/>
              <a:gd name="T47" fmla="*/ 407 h 407"/>
              <a:gd name="T48" fmla="*/ 1690 w 4221"/>
              <a:gd name="T49" fmla="*/ 407 h 407"/>
              <a:gd name="T50" fmla="*/ 1828 w 4221"/>
              <a:gd name="T51" fmla="*/ 407 h 407"/>
              <a:gd name="T52" fmla="*/ 1868 w 4221"/>
              <a:gd name="T53" fmla="*/ 407 h 407"/>
              <a:gd name="T54" fmla="*/ 1964 w 4221"/>
              <a:gd name="T55" fmla="*/ 407 h 407"/>
              <a:gd name="T56" fmla="*/ 1970 w 4221"/>
              <a:gd name="T57" fmla="*/ 407 h 407"/>
              <a:gd name="T58" fmla="*/ 1991 w 4221"/>
              <a:gd name="T59" fmla="*/ 407 h 407"/>
              <a:gd name="T60" fmla="*/ 2258 w 4221"/>
              <a:gd name="T61" fmla="*/ 407 h 407"/>
              <a:gd name="T62" fmla="*/ 2310 w 4221"/>
              <a:gd name="T63" fmla="*/ 407 h 407"/>
              <a:gd name="T64" fmla="*/ 2377 w 4221"/>
              <a:gd name="T65" fmla="*/ 407 h 407"/>
              <a:gd name="T66" fmla="*/ 2523 w 4221"/>
              <a:gd name="T67" fmla="*/ 407 h 407"/>
              <a:gd name="T68" fmla="*/ 2675 w 4221"/>
              <a:gd name="T69" fmla="*/ 407 h 407"/>
              <a:gd name="T70" fmla="*/ 2903 w 4221"/>
              <a:gd name="T71" fmla="*/ 407 h 407"/>
              <a:gd name="T72" fmla="*/ 3026 w 4221"/>
              <a:gd name="T73" fmla="*/ 407 h 407"/>
              <a:gd name="T74" fmla="*/ 3153 w 4221"/>
              <a:gd name="T75" fmla="*/ 407 h 407"/>
              <a:gd name="T76" fmla="*/ 3186 w 4221"/>
              <a:gd name="T77" fmla="*/ 407 h 407"/>
              <a:gd name="T78" fmla="*/ 3501 w 4221"/>
              <a:gd name="T79" fmla="*/ 407 h 407"/>
              <a:gd name="T80" fmla="*/ 3575 w 4221"/>
              <a:gd name="T81" fmla="*/ 407 h 407"/>
              <a:gd name="T82" fmla="*/ 3668 w 4221"/>
              <a:gd name="T83" fmla="*/ 407 h 407"/>
              <a:gd name="T84" fmla="*/ 3804 w 4221"/>
              <a:gd name="T85" fmla="*/ 407 h 407"/>
              <a:gd name="T86" fmla="*/ 4221 w 4221"/>
              <a:gd name="T87" fmla="*/ 407 h 4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4221" h="407">
                <a:moveTo>
                  <a:pt x="0" y="0"/>
                </a:moveTo>
                <a:lnTo>
                  <a:pt x="123" y="0"/>
                </a:lnTo>
                <a:lnTo>
                  <a:pt x="169" y="0"/>
                </a:lnTo>
                <a:lnTo>
                  <a:pt x="169" y="88"/>
                </a:lnTo>
                <a:lnTo>
                  <a:pt x="271" y="88"/>
                </a:lnTo>
                <a:lnTo>
                  <a:pt x="413" y="88"/>
                </a:lnTo>
                <a:lnTo>
                  <a:pt x="543" y="88"/>
                </a:lnTo>
                <a:lnTo>
                  <a:pt x="543" y="184"/>
                </a:lnTo>
                <a:lnTo>
                  <a:pt x="566" y="184"/>
                </a:lnTo>
                <a:lnTo>
                  <a:pt x="578" y="184"/>
                </a:lnTo>
                <a:lnTo>
                  <a:pt x="585" y="184"/>
                </a:lnTo>
                <a:lnTo>
                  <a:pt x="762" y="184"/>
                </a:lnTo>
                <a:lnTo>
                  <a:pt x="762" y="290"/>
                </a:lnTo>
                <a:lnTo>
                  <a:pt x="801" y="290"/>
                </a:lnTo>
                <a:lnTo>
                  <a:pt x="874" y="290"/>
                </a:lnTo>
                <a:lnTo>
                  <a:pt x="989" y="290"/>
                </a:lnTo>
                <a:lnTo>
                  <a:pt x="1043" y="290"/>
                </a:lnTo>
                <a:lnTo>
                  <a:pt x="1043" y="407"/>
                </a:lnTo>
                <a:lnTo>
                  <a:pt x="1087" y="407"/>
                </a:lnTo>
                <a:lnTo>
                  <a:pt x="1188" y="407"/>
                </a:lnTo>
                <a:lnTo>
                  <a:pt x="1277" y="407"/>
                </a:lnTo>
                <a:lnTo>
                  <a:pt x="1331" y="407"/>
                </a:lnTo>
                <a:lnTo>
                  <a:pt x="1457" y="407"/>
                </a:lnTo>
                <a:lnTo>
                  <a:pt x="1482" y="407"/>
                </a:lnTo>
                <a:lnTo>
                  <a:pt x="1690" y="407"/>
                </a:lnTo>
                <a:lnTo>
                  <a:pt x="1828" y="407"/>
                </a:lnTo>
                <a:lnTo>
                  <a:pt x="1868" y="407"/>
                </a:lnTo>
                <a:lnTo>
                  <a:pt x="1964" y="407"/>
                </a:lnTo>
                <a:lnTo>
                  <a:pt x="1970" y="407"/>
                </a:lnTo>
                <a:lnTo>
                  <a:pt x="1991" y="407"/>
                </a:lnTo>
                <a:lnTo>
                  <a:pt x="2258" y="407"/>
                </a:lnTo>
                <a:lnTo>
                  <a:pt x="2310" y="407"/>
                </a:lnTo>
                <a:lnTo>
                  <a:pt x="2377" y="407"/>
                </a:lnTo>
                <a:lnTo>
                  <a:pt x="2523" y="407"/>
                </a:lnTo>
                <a:lnTo>
                  <a:pt x="2675" y="407"/>
                </a:lnTo>
                <a:lnTo>
                  <a:pt x="2903" y="407"/>
                </a:lnTo>
                <a:lnTo>
                  <a:pt x="3026" y="407"/>
                </a:lnTo>
                <a:lnTo>
                  <a:pt x="3153" y="407"/>
                </a:lnTo>
                <a:lnTo>
                  <a:pt x="3186" y="407"/>
                </a:lnTo>
                <a:lnTo>
                  <a:pt x="3501" y="407"/>
                </a:lnTo>
                <a:lnTo>
                  <a:pt x="3575" y="407"/>
                </a:lnTo>
                <a:lnTo>
                  <a:pt x="3668" y="407"/>
                </a:lnTo>
                <a:lnTo>
                  <a:pt x="3804" y="407"/>
                </a:lnTo>
                <a:lnTo>
                  <a:pt x="4221" y="407"/>
                </a:lnTo>
              </a:path>
            </a:pathLst>
          </a:custGeom>
          <a:noFill/>
          <a:ln w="19050">
            <a:solidFill>
              <a:srgbClr val="00206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" name="Freeform 91">
            <a:extLst>
              <a:ext uri="{FF2B5EF4-FFF2-40B4-BE49-F238E27FC236}">
                <a16:creationId xmlns:a16="http://schemas.microsoft.com/office/drawing/2014/main" id="{D59402B2-9D91-4FFA-B7E1-3DAF04FDB5C5}"/>
              </a:ext>
            </a:extLst>
          </p:cNvPr>
          <p:cNvSpPr>
            <a:spLocks/>
          </p:cNvSpPr>
          <p:nvPr/>
        </p:nvSpPr>
        <p:spPr bwMode="auto">
          <a:xfrm>
            <a:off x="1108508" y="2362417"/>
            <a:ext cx="3859213" cy="898525"/>
          </a:xfrm>
          <a:custGeom>
            <a:avLst/>
            <a:gdLst>
              <a:gd name="T0" fmla="*/ 0 w 4862"/>
              <a:gd name="T1" fmla="*/ 0 h 1131"/>
              <a:gd name="T2" fmla="*/ 491 w 4862"/>
              <a:gd name="T3" fmla="*/ 0 h 1131"/>
              <a:gd name="T4" fmla="*/ 766 w 4862"/>
              <a:gd name="T5" fmla="*/ 0 h 1131"/>
              <a:gd name="T6" fmla="*/ 766 w 4862"/>
              <a:gd name="T7" fmla="*/ 274 h 1131"/>
              <a:gd name="T8" fmla="*/ 1398 w 4862"/>
              <a:gd name="T9" fmla="*/ 274 h 1131"/>
              <a:gd name="T10" fmla="*/ 1398 w 4862"/>
              <a:gd name="T11" fmla="*/ 549 h 1131"/>
              <a:gd name="T12" fmla="*/ 1478 w 4862"/>
              <a:gd name="T13" fmla="*/ 549 h 1131"/>
              <a:gd name="T14" fmla="*/ 1478 w 4862"/>
              <a:gd name="T15" fmla="*/ 826 h 1131"/>
              <a:gd name="T16" fmla="*/ 1503 w 4862"/>
              <a:gd name="T17" fmla="*/ 826 h 1131"/>
              <a:gd name="T18" fmla="*/ 2216 w 4862"/>
              <a:gd name="T19" fmla="*/ 826 h 1131"/>
              <a:gd name="T20" fmla="*/ 2216 w 4862"/>
              <a:gd name="T21" fmla="*/ 1131 h 1131"/>
              <a:gd name="T22" fmla="*/ 3771 w 4862"/>
              <a:gd name="T23" fmla="*/ 1131 h 1131"/>
              <a:gd name="T24" fmla="*/ 3819 w 4862"/>
              <a:gd name="T25" fmla="*/ 1131 h 1131"/>
              <a:gd name="T26" fmla="*/ 3963 w 4862"/>
              <a:gd name="T27" fmla="*/ 1131 h 1131"/>
              <a:gd name="T28" fmla="*/ 4046 w 4862"/>
              <a:gd name="T29" fmla="*/ 1131 h 1131"/>
              <a:gd name="T30" fmla="*/ 4209 w 4862"/>
              <a:gd name="T31" fmla="*/ 1131 h 1131"/>
              <a:gd name="T32" fmla="*/ 4230 w 4862"/>
              <a:gd name="T33" fmla="*/ 1131 h 1131"/>
              <a:gd name="T34" fmla="*/ 4457 w 4862"/>
              <a:gd name="T35" fmla="*/ 1131 h 1131"/>
              <a:gd name="T36" fmla="*/ 4862 w 4862"/>
              <a:gd name="T37" fmla="*/ 1131 h 11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>
              <a:path w="4862" h="1131">
                <a:moveTo>
                  <a:pt x="0" y="0"/>
                </a:moveTo>
                <a:lnTo>
                  <a:pt x="491" y="0"/>
                </a:lnTo>
                <a:lnTo>
                  <a:pt x="766" y="0"/>
                </a:lnTo>
                <a:lnTo>
                  <a:pt x="766" y="274"/>
                </a:lnTo>
                <a:lnTo>
                  <a:pt x="1398" y="274"/>
                </a:lnTo>
                <a:lnTo>
                  <a:pt x="1398" y="549"/>
                </a:lnTo>
                <a:lnTo>
                  <a:pt x="1478" y="549"/>
                </a:lnTo>
                <a:lnTo>
                  <a:pt x="1478" y="826"/>
                </a:lnTo>
                <a:lnTo>
                  <a:pt x="1503" y="826"/>
                </a:lnTo>
                <a:lnTo>
                  <a:pt x="2216" y="826"/>
                </a:lnTo>
                <a:lnTo>
                  <a:pt x="2216" y="1131"/>
                </a:lnTo>
                <a:lnTo>
                  <a:pt x="3771" y="1131"/>
                </a:lnTo>
                <a:lnTo>
                  <a:pt x="3819" y="1131"/>
                </a:lnTo>
                <a:lnTo>
                  <a:pt x="3963" y="1131"/>
                </a:lnTo>
                <a:lnTo>
                  <a:pt x="4046" y="1131"/>
                </a:lnTo>
                <a:lnTo>
                  <a:pt x="4209" y="1131"/>
                </a:lnTo>
                <a:lnTo>
                  <a:pt x="4230" y="1131"/>
                </a:lnTo>
                <a:lnTo>
                  <a:pt x="4457" y="1131"/>
                </a:lnTo>
                <a:lnTo>
                  <a:pt x="4862" y="1131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" name="Freeform 152">
            <a:extLst>
              <a:ext uri="{FF2B5EF4-FFF2-40B4-BE49-F238E27FC236}">
                <a16:creationId xmlns:a16="http://schemas.microsoft.com/office/drawing/2014/main" id="{30927669-3A16-4257-8CF3-5711E3945EC8}"/>
              </a:ext>
            </a:extLst>
          </p:cNvPr>
          <p:cNvSpPr>
            <a:spLocks/>
          </p:cNvSpPr>
          <p:nvPr/>
        </p:nvSpPr>
        <p:spPr bwMode="auto">
          <a:xfrm>
            <a:off x="7274246" y="2353901"/>
            <a:ext cx="3281363" cy="1125538"/>
          </a:xfrm>
          <a:custGeom>
            <a:avLst/>
            <a:gdLst>
              <a:gd name="T0" fmla="*/ 83 w 2067"/>
              <a:gd name="T1" fmla="*/ 0 h 709"/>
              <a:gd name="T2" fmla="*/ 104 w 2067"/>
              <a:gd name="T3" fmla="*/ 25 h 709"/>
              <a:gd name="T4" fmla="*/ 119 w 2067"/>
              <a:gd name="T5" fmla="*/ 50 h 709"/>
              <a:gd name="T6" fmla="*/ 153 w 2067"/>
              <a:gd name="T7" fmla="*/ 76 h 709"/>
              <a:gd name="T8" fmla="*/ 156 w 2067"/>
              <a:gd name="T9" fmla="*/ 101 h 709"/>
              <a:gd name="T10" fmla="*/ 166 w 2067"/>
              <a:gd name="T11" fmla="*/ 125 h 709"/>
              <a:gd name="T12" fmla="*/ 167 w 2067"/>
              <a:gd name="T13" fmla="*/ 175 h 709"/>
              <a:gd name="T14" fmla="*/ 180 w 2067"/>
              <a:gd name="T15" fmla="*/ 201 h 709"/>
              <a:gd name="T16" fmla="*/ 201 w 2067"/>
              <a:gd name="T17" fmla="*/ 201 h 709"/>
              <a:gd name="T18" fmla="*/ 218 w 2067"/>
              <a:gd name="T19" fmla="*/ 225 h 709"/>
              <a:gd name="T20" fmla="*/ 225 w 2067"/>
              <a:gd name="T21" fmla="*/ 277 h 709"/>
              <a:gd name="T22" fmla="*/ 230 w 2067"/>
              <a:gd name="T23" fmla="*/ 302 h 709"/>
              <a:gd name="T24" fmla="*/ 236 w 2067"/>
              <a:gd name="T25" fmla="*/ 352 h 709"/>
              <a:gd name="T26" fmla="*/ 244 w 2067"/>
              <a:gd name="T27" fmla="*/ 378 h 709"/>
              <a:gd name="T28" fmla="*/ 247 w 2067"/>
              <a:gd name="T29" fmla="*/ 403 h 709"/>
              <a:gd name="T30" fmla="*/ 309 w 2067"/>
              <a:gd name="T31" fmla="*/ 403 h 709"/>
              <a:gd name="T32" fmla="*/ 311 w 2067"/>
              <a:gd name="T33" fmla="*/ 430 h 709"/>
              <a:gd name="T34" fmla="*/ 330 w 2067"/>
              <a:gd name="T35" fmla="*/ 455 h 709"/>
              <a:gd name="T36" fmla="*/ 343 w 2067"/>
              <a:gd name="T37" fmla="*/ 483 h 709"/>
              <a:gd name="T38" fmla="*/ 400 w 2067"/>
              <a:gd name="T39" fmla="*/ 509 h 709"/>
              <a:gd name="T40" fmla="*/ 450 w 2067"/>
              <a:gd name="T41" fmla="*/ 509 h 709"/>
              <a:gd name="T42" fmla="*/ 540 w 2067"/>
              <a:gd name="T43" fmla="*/ 509 h 709"/>
              <a:gd name="T44" fmla="*/ 575 w 2067"/>
              <a:gd name="T45" fmla="*/ 541 h 709"/>
              <a:gd name="T46" fmla="*/ 683 w 2067"/>
              <a:gd name="T47" fmla="*/ 541 h 709"/>
              <a:gd name="T48" fmla="*/ 756 w 2067"/>
              <a:gd name="T49" fmla="*/ 541 h 709"/>
              <a:gd name="T50" fmla="*/ 806 w 2067"/>
              <a:gd name="T51" fmla="*/ 541 h 709"/>
              <a:gd name="T52" fmla="*/ 849 w 2067"/>
              <a:gd name="T53" fmla="*/ 541 h 709"/>
              <a:gd name="T54" fmla="*/ 875 w 2067"/>
              <a:gd name="T55" fmla="*/ 583 h 709"/>
              <a:gd name="T56" fmla="*/ 975 w 2067"/>
              <a:gd name="T57" fmla="*/ 583 h 709"/>
              <a:gd name="T58" fmla="*/ 1015 w 2067"/>
              <a:gd name="T59" fmla="*/ 583 h 709"/>
              <a:gd name="T60" fmla="*/ 1039 w 2067"/>
              <a:gd name="T61" fmla="*/ 583 h 709"/>
              <a:gd name="T62" fmla="*/ 1051 w 2067"/>
              <a:gd name="T63" fmla="*/ 583 h 709"/>
              <a:gd name="T64" fmla="*/ 1172 w 2067"/>
              <a:gd name="T65" fmla="*/ 583 h 709"/>
              <a:gd name="T66" fmla="*/ 1217 w 2067"/>
              <a:gd name="T67" fmla="*/ 583 h 709"/>
              <a:gd name="T68" fmla="*/ 1268 w 2067"/>
              <a:gd name="T69" fmla="*/ 583 h 709"/>
              <a:gd name="T70" fmla="*/ 1362 w 2067"/>
              <a:gd name="T71" fmla="*/ 583 h 709"/>
              <a:gd name="T72" fmla="*/ 1498 w 2067"/>
              <a:gd name="T73" fmla="*/ 583 h 709"/>
              <a:gd name="T74" fmla="*/ 1522 w 2067"/>
              <a:gd name="T75" fmla="*/ 709 h 709"/>
              <a:gd name="T76" fmla="*/ 1595 w 2067"/>
              <a:gd name="T77" fmla="*/ 709 h 709"/>
              <a:gd name="T78" fmla="*/ 1777 w 2067"/>
              <a:gd name="T79" fmla="*/ 709 h 709"/>
              <a:gd name="T80" fmla="*/ 1878 w 2067"/>
              <a:gd name="T81" fmla="*/ 709 h 7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2067" h="709">
                <a:moveTo>
                  <a:pt x="0" y="0"/>
                </a:moveTo>
                <a:lnTo>
                  <a:pt x="83" y="0"/>
                </a:lnTo>
                <a:lnTo>
                  <a:pt x="83" y="25"/>
                </a:lnTo>
                <a:lnTo>
                  <a:pt x="104" y="25"/>
                </a:lnTo>
                <a:lnTo>
                  <a:pt x="104" y="50"/>
                </a:lnTo>
                <a:lnTo>
                  <a:pt x="119" y="50"/>
                </a:lnTo>
                <a:lnTo>
                  <a:pt x="119" y="76"/>
                </a:lnTo>
                <a:lnTo>
                  <a:pt x="153" y="76"/>
                </a:lnTo>
                <a:lnTo>
                  <a:pt x="153" y="101"/>
                </a:lnTo>
                <a:lnTo>
                  <a:pt x="156" y="101"/>
                </a:lnTo>
                <a:lnTo>
                  <a:pt x="156" y="125"/>
                </a:lnTo>
                <a:lnTo>
                  <a:pt x="166" y="125"/>
                </a:lnTo>
                <a:lnTo>
                  <a:pt x="166" y="150"/>
                </a:lnTo>
                <a:lnTo>
                  <a:pt x="167" y="175"/>
                </a:lnTo>
                <a:lnTo>
                  <a:pt x="180" y="175"/>
                </a:lnTo>
                <a:lnTo>
                  <a:pt x="180" y="201"/>
                </a:lnTo>
                <a:lnTo>
                  <a:pt x="198" y="201"/>
                </a:lnTo>
                <a:lnTo>
                  <a:pt x="201" y="201"/>
                </a:lnTo>
                <a:lnTo>
                  <a:pt x="201" y="225"/>
                </a:lnTo>
                <a:lnTo>
                  <a:pt x="218" y="225"/>
                </a:lnTo>
                <a:lnTo>
                  <a:pt x="218" y="251"/>
                </a:lnTo>
                <a:lnTo>
                  <a:pt x="225" y="277"/>
                </a:lnTo>
                <a:lnTo>
                  <a:pt x="226" y="302"/>
                </a:lnTo>
                <a:lnTo>
                  <a:pt x="230" y="302"/>
                </a:lnTo>
                <a:lnTo>
                  <a:pt x="230" y="327"/>
                </a:lnTo>
                <a:lnTo>
                  <a:pt x="236" y="352"/>
                </a:lnTo>
                <a:lnTo>
                  <a:pt x="244" y="352"/>
                </a:lnTo>
                <a:lnTo>
                  <a:pt x="244" y="378"/>
                </a:lnTo>
                <a:lnTo>
                  <a:pt x="247" y="378"/>
                </a:lnTo>
                <a:lnTo>
                  <a:pt x="247" y="403"/>
                </a:lnTo>
                <a:lnTo>
                  <a:pt x="265" y="403"/>
                </a:lnTo>
                <a:lnTo>
                  <a:pt x="309" y="403"/>
                </a:lnTo>
                <a:lnTo>
                  <a:pt x="309" y="430"/>
                </a:lnTo>
                <a:lnTo>
                  <a:pt x="311" y="430"/>
                </a:lnTo>
                <a:lnTo>
                  <a:pt x="311" y="455"/>
                </a:lnTo>
                <a:lnTo>
                  <a:pt x="330" y="455"/>
                </a:lnTo>
                <a:lnTo>
                  <a:pt x="338" y="483"/>
                </a:lnTo>
                <a:lnTo>
                  <a:pt x="343" y="483"/>
                </a:lnTo>
                <a:lnTo>
                  <a:pt x="343" y="509"/>
                </a:lnTo>
                <a:lnTo>
                  <a:pt x="400" y="509"/>
                </a:lnTo>
                <a:lnTo>
                  <a:pt x="403" y="509"/>
                </a:lnTo>
                <a:lnTo>
                  <a:pt x="450" y="509"/>
                </a:lnTo>
                <a:lnTo>
                  <a:pt x="508" y="509"/>
                </a:lnTo>
                <a:lnTo>
                  <a:pt x="540" y="509"/>
                </a:lnTo>
                <a:lnTo>
                  <a:pt x="575" y="509"/>
                </a:lnTo>
                <a:lnTo>
                  <a:pt x="575" y="541"/>
                </a:lnTo>
                <a:lnTo>
                  <a:pt x="594" y="541"/>
                </a:lnTo>
                <a:lnTo>
                  <a:pt x="683" y="541"/>
                </a:lnTo>
                <a:lnTo>
                  <a:pt x="724" y="541"/>
                </a:lnTo>
                <a:lnTo>
                  <a:pt x="756" y="541"/>
                </a:lnTo>
                <a:lnTo>
                  <a:pt x="767" y="541"/>
                </a:lnTo>
                <a:lnTo>
                  <a:pt x="806" y="541"/>
                </a:lnTo>
                <a:lnTo>
                  <a:pt x="818" y="541"/>
                </a:lnTo>
                <a:lnTo>
                  <a:pt x="849" y="541"/>
                </a:lnTo>
                <a:lnTo>
                  <a:pt x="875" y="541"/>
                </a:lnTo>
                <a:lnTo>
                  <a:pt x="875" y="583"/>
                </a:lnTo>
                <a:lnTo>
                  <a:pt x="912" y="583"/>
                </a:lnTo>
                <a:lnTo>
                  <a:pt x="975" y="583"/>
                </a:lnTo>
                <a:lnTo>
                  <a:pt x="994" y="583"/>
                </a:lnTo>
                <a:lnTo>
                  <a:pt x="1015" y="583"/>
                </a:lnTo>
                <a:lnTo>
                  <a:pt x="1027" y="583"/>
                </a:lnTo>
                <a:lnTo>
                  <a:pt x="1039" y="583"/>
                </a:lnTo>
                <a:lnTo>
                  <a:pt x="1041" y="583"/>
                </a:lnTo>
                <a:lnTo>
                  <a:pt x="1051" y="583"/>
                </a:lnTo>
                <a:lnTo>
                  <a:pt x="1118" y="583"/>
                </a:lnTo>
                <a:lnTo>
                  <a:pt x="1172" y="583"/>
                </a:lnTo>
                <a:lnTo>
                  <a:pt x="1196" y="583"/>
                </a:lnTo>
                <a:lnTo>
                  <a:pt x="1217" y="583"/>
                </a:lnTo>
                <a:lnTo>
                  <a:pt x="1228" y="583"/>
                </a:lnTo>
                <a:lnTo>
                  <a:pt x="1268" y="583"/>
                </a:lnTo>
                <a:lnTo>
                  <a:pt x="1293" y="583"/>
                </a:lnTo>
                <a:lnTo>
                  <a:pt x="1362" y="583"/>
                </a:lnTo>
                <a:lnTo>
                  <a:pt x="1384" y="583"/>
                </a:lnTo>
                <a:lnTo>
                  <a:pt x="1498" y="583"/>
                </a:lnTo>
                <a:lnTo>
                  <a:pt x="1498" y="709"/>
                </a:lnTo>
                <a:lnTo>
                  <a:pt x="1522" y="709"/>
                </a:lnTo>
                <a:lnTo>
                  <a:pt x="1581" y="709"/>
                </a:lnTo>
                <a:lnTo>
                  <a:pt x="1595" y="709"/>
                </a:lnTo>
                <a:lnTo>
                  <a:pt x="1772" y="709"/>
                </a:lnTo>
                <a:lnTo>
                  <a:pt x="1777" y="709"/>
                </a:lnTo>
                <a:lnTo>
                  <a:pt x="1816" y="709"/>
                </a:lnTo>
                <a:lnTo>
                  <a:pt x="1878" y="709"/>
                </a:lnTo>
                <a:lnTo>
                  <a:pt x="2067" y="709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" name="Freeform 153">
            <a:extLst>
              <a:ext uri="{FF2B5EF4-FFF2-40B4-BE49-F238E27FC236}">
                <a16:creationId xmlns:a16="http://schemas.microsoft.com/office/drawing/2014/main" id="{03A001E1-F222-4FD1-9628-4B06A406217D}"/>
              </a:ext>
            </a:extLst>
          </p:cNvPr>
          <p:cNvSpPr>
            <a:spLocks/>
          </p:cNvSpPr>
          <p:nvPr/>
        </p:nvSpPr>
        <p:spPr bwMode="auto">
          <a:xfrm>
            <a:off x="7274246" y="2353901"/>
            <a:ext cx="3746500" cy="1314450"/>
          </a:xfrm>
          <a:custGeom>
            <a:avLst/>
            <a:gdLst>
              <a:gd name="T0" fmla="*/ 0 w 2360"/>
              <a:gd name="T1" fmla="*/ 0 h 828"/>
              <a:gd name="T2" fmla="*/ 70 w 2360"/>
              <a:gd name="T3" fmla="*/ 0 h 828"/>
              <a:gd name="T4" fmla="*/ 70 w 2360"/>
              <a:gd name="T5" fmla="*/ 72 h 828"/>
              <a:gd name="T6" fmla="*/ 137 w 2360"/>
              <a:gd name="T7" fmla="*/ 72 h 828"/>
              <a:gd name="T8" fmla="*/ 137 w 2360"/>
              <a:gd name="T9" fmla="*/ 144 h 828"/>
              <a:gd name="T10" fmla="*/ 147 w 2360"/>
              <a:gd name="T11" fmla="*/ 144 h 828"/>
              <a:gd name="T12" fmla="*/ 147 w 2360"/>
              <a:gd name="T13" fmla="*/ 216 h 828"/>
              <a:gd name="T14" fmla="*/ 208 w 2360"/>
              <a:gd name="T15" fmla="*/ 216 h 828"/>
              <a:gd name="T16" fmla="*/ 208 w 2360"/>
              <a:gd name="T17" fmla="*/ 288 h 828"/>
              <a:gd name="T18" fmla="*/ 246 w 2360"/>
              <a:gd name="T19" fmla="*/ 288 h 828"/>
              <a:gd name="T20" fmla="*/ 246 w 2360"/>
              <a:gd name="T21" fmla="*/ 360 h 828"/>
              <a:gd name="T22" fmla="*/ 332 w 2360"/>
              <a:gd name="T23" fmla="*/ 360 h 828"/>
              <a:gd name="T24" fmla="*/ 332 w 2360"/>
              <a:gd name="T25" fmla="*/ 431 h 828"/>
              <a:gd name="T26" fmla="*/ 353 w 2360"/>
              <a:gd name="T27" fmla="*/ 431 h 828"/>
              <a:gd name="T28" fmla="*/ 353 w 2360"/>
              <a:gd name="T29" fmla="*/ 503 h 828"/>
              <a:gd name="T30" fmla="*/ 358 w 2360"/>
              <a:gd name="T31" fmla="*/ 503 h 828"/>
              <a:gd name="T32" fmla="*/ 358 w 2360"/>
              <a:gd name="T33" fmla="*/ 575 h 828"/>
              <a:gd name="T34" fmla="*/ 367 w 2360"/>
              <a:gd name="T35" fmla="*/ 575 h 828"/>
              <a:gd name="T36" fmla="*/ 387 w 2360"/>
              <a:gd name="T37" fmla="*/ 575 h 828"/>
              <a:gd name="T38" fmla="*/ 387 w 2360"/>
              <a:gd name="T39" fmla="*/ 651 h 828"/>
              <a:gd name="T40" fmla="*/ 824 w 2360"/>
              <a:gd name="T41" fmla="*/ 651 h 828"/>
              <a:gd name="T42" fmla="*/ 824 w 2360"/>
              <a:gd name="T43" fmla="*/ 728 h 828"/>
              <a:gd name="T44" fmla="*/ 828 w 2360"/>
              <a:gd name="T45" fmla="*/ 728 h 828"/>
              <a:gd name="T46" fmla="*/ 1226 w 2360"/>
              <a:gd name="T47" fmla="*/ 728 h 828"/>
              <a:gd name="T48" fmla="*/ 1320 w 2360"/>
              <a:gd name="T49" fmla="*/ 728 h 828"/>
              <a:gd name="T50" fmla="*/ 1371 w 2360"/>
              <a:gd name="T51" fmla="*/ 728 h 828"/>
              <a:gd name="T52" fmla="*/ 1371 w 2360"/>
              <a:gd name="T53" fmla="*/ 828 h 828"/>
              <a:gd name="T54" fmla="*/ 1470 w 2360"/>
              <a:gd name="T55" fmla="*/ 828 h 828"/>
              <a:gd name="T56" fmla="*/ 1851 w 2360"/>
              <a:gd name="T57" fmla="*/ 828 h 828"/>
              <a:gd name="T58" fmla="*/ 1860 w 2360"/>
              <a:gd name="T59" fmla="*/ 828 h 828"/>
              <a:gd name="T60" fmla="*/ 1884 w 2360"/>
              <a:gd name="T61" fmla="*/ 828 h 828"/>
              <a:gd name="T62" fmla="*/ 1950 w 2360"/>
              <a:gd name="T63" fmla="*/ 828 h 828"/>
              <a:gd name="T64" fmla="*/ 1987 w 2360"/>
              <a:gd name="T65" fmla="*/ 828 h 828"/>
              <a:gd name="T66" fmla="*/ 2071 w 2360"/>
              <a:gd name="T67" fmla="*/ 828 h 828"/>
              <a:gd name="T68" fmla="*/ 2175 w 2360"/>
              <a:gd name="T69" fmla="*/ 828 h 828"/>
              <a:gd name="T70" fmla="*/ 2360 w 2360"/>
              <a:gd name="T71" fmla="*/ 828 h 8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</a:cxnLst>
            <a:rect l="0" t="0" r="r" b="b"/>
            <a:pathLst>
              <a:path w="2360" h="828">
                <a:moveTo>
                  <a:pt x="0" y="0"/>
                </a:moveTo>
                <a:lnTo>
                  <a:pt x="70" y="0"/>
                </a:lnTo>
                <a:lnTo>
                  <a:pt x="70" y="72"/>
                </a:lnTo>
                <a:lnTo>
                  <a:pt x="137" y="72"/>
                </a:lnTo>
                <a:lnTo>
                  <a:pt x="137" y="144"/>
                </a:lnTo>
                <a:lnTo>
                  <a:pt x="147" y="144"/>
                </a:lnTo>
                <a:lnTo>
                  <a:pt x="147" y="216"/>
                </a:lnTo>
                <a:lnTo>
                  <a:pt x="208" y="216"/>
                </a:lnTo>
                <a:lnTo>
                  <a:pt x="208" y="288"/>
                </a:lnTo>
                <a:lnTo>
                  <a:pt x="246" y="288"/>
                </a:lnTo>
                <a:lnTo>
                  <a:pt x="246" y="360"/>
                </a:lnTo>
                <a:lnTo>
                  <a:pt x="332" y="360"/>
                </a:lnTo>
                <a:lnTo>
                  <a:pt x="332" y="431"/>
                </a:lnTo>
                <a:lnTo>
                  <a:pt x="353" y="431"/>
                </a:lnTo>
                <a:lnTo>
                  <a:pt x="353" y="503"/>
                </a:lnTo>
                <a:lnTo>
                  <a:pt x="358" y="503"/>
                </a:lnTo>
                <a:lnTo>
                  <a:pt x="358" y="575"/>
                </a:lnTo>
                <a:lnTo>
                  <a:pt x="367" y="575"/>
                </a:lnTo>
                <a:lnTo>
                  <a:pt x="387" y="575"/>
                </a:lnTo>
                <a:lnTo>
                  <a:pt x="387" y="651"/>
                </a:lnTo>
                <a:lnTo>
                  <a:pt x="824" y="651"/>
                </a:lnTo>
                <a:lnTo>
                  <a:pt x="824" y="728"/>
                </a:lnTo>
                <a:lnTo>
                  <a:pt x="828" y="728"/>
                </a:lnTo>
                <a:lnTo>
                  <a:pt x="1226" y="728"/>
                </a:lnTo>
                <a:lnTo>
                  <a:pt x="1320" y="728"/>
                </a:lnTo>
                <a:lnTo>
                  <a:pt x="1371" y="728"/>
                </a:lnTo>
                <a:lnTo>
                  <a:pt x="1371" y="828"/>
                </a:lnTo>
                <a:lnTo>
                  <a:pt x="1470" y="828"/>
                </a:lnTo>
                <a:lnTo>
                  <a:pt x="1851" y="828"/>
                </a:lnTo>
                <a:lnTo>
                  <a:pt x="1860" y="828"/>
                </a:lnTo>
                <a:lnTo>
                  <a:pt x="1884" y="828"/>
                </a:lnTo>
                <a:lnTo>
                  <a:pt x="1950" y="828"/>
                </a:lnTo>
                <a:lnTo>
                  <a:pt x="1987" y="828"/>
                </a:lnTo>
                <a:lnTo>
                  <a:pt x="2071" y="828"/>
                </a:lnTo>
                <a:lnTo>
                  <a:pt x="2175" y="828"/>
                </a:lnTo>
                <a:lnTo>
                  <a:pt x="2360" y="828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4D84E2A9-C35B-4B8C-9217-F2B422417A69}"/>
              </a:ext>
            </a:extLst>
          </p:cNvPr>
          <p:cNvSpPr txBox="1"/>
          <p:nvPr/>
        </p:nvSpPr>
        <p:spPr>
          <a:xfrm>
            <a:off x="2396844" y="1108933"/>
            <a:ext cx="1977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RI high grou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EDE2F693-3733-4899-80E1-D1EFA636016F}"/>
              </a:ext>
            </a:extLst>
          </p:cNvPr>
          <p:cNvSpPr txBox="1"/>
          <p:nvPr/>
        </p:nvSpPr>
        <p:spPr>
          <a:xfrm>
            <a:off x="8681820" y="1108933"/>
            <a:ext cx="1977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RI high grou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D0A2F267-5046-4A67-9A45-8BFB16EFA2EA}"/>
              </a:ext>
            </a:extLst>
          </p:cNvPr>
          <p:cNvSpPr txBox="1"/>
          <p:nvPr/>
        </p:nvSpPr>
        <p:spPr>
          <a:xfrm>
            <a:off x="0" y="36576"/>
            <a:ext cx="2258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Fig. 2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596196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5">
            <a:extLst>
              <a:ext uri="{FF2B5EF4-FFF2-40B4-BE49-F238E27FC236}">
                <a16:creationId xmlns:a16="http://schemas.microsoft.com/office/drawing/2014/main" id="{B1115143-9495-4C44-BF33-8C57E8067E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91706" y="1541728"/>
            <a:ext cx="15112" cy="1728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5815F14-F85F-4A2E-ADE1-1433426C194B}"/>
              </a:ext>
            </a:extLst>
          </p:cNvPr>
          <p:cNvSpPr txBox="1"/>
          <p:nvPr/>
        </p:nvSpPr>
        <p:spPr>
          <a:xfrm rot="16200000">
            <a:off x="-576404" y="3453764"/>
            <a:ext cx="20394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bability of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A534DE1-D287-457F-A0F6-B8E647CDAB2E}"/>
              </a:ext>
            </a:extLst>
          </p:cNvPr>
          <p:cNvSpPr txBox="1"/>
          <p:nvPr/>
        </p:nvSpPr>
        <p:spPr>
          <a:xfrm>
            <a:off x="304828" y="1252023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9B987067-4DCC-4966-A6DE-692BDA6FF9FB}"/>
              </a:ext>
            </a:extLst>
          </p:cNvPr>
          <p:cNvCxnSpPr>
            <a:cxnSpLocks/>
          </p:cNvCxnSpPr>
          <p:nvPr/>
        </p:nvCxnSpPr>
        <p:spPr>
          <a:xfrm>
            <a:off x="1125437" y="1503350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6C36961C-999B-4EDD-B3E6-CBDFA3D37C0D}"/>
              </a:ext>
            </a:extLst>
          </p:cNvPr>
          <p:cNvGrpSpPr/>
          <p:nvPr/>
        </p:nvGrpSpPr>
        <p:grpSpPr>
          <a:xfrm>
            <a:off x="750302" y="1714573"/>
            <a:ext cx="4590085" cy="4124950"/>
            <a:chOff x="684686" y="1423988"/>
            <a:chExt cx="3857353" cy="3030859"/>
          </a:xfrm>
        </p:grpSpPr>
        <p:sp>
          <p:nvSpPr>
            <p:cNvPr id="9" name="Rectangle 45">
              <a:extLst>
                <a:ext uri="{FF2B5EF4-FFF2-40B4-BE49-F238E27FC236}">
                  <a16:creationId xmlns:a16="http://schemas.microsoft.com/office/drawing/2014/main" id="{CBACB78C-1C25-4532-8D62-56928E2D17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0266" y="4341776"/>
              <a:ext cx="643918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(months)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5">
              <a:extLst>
                <a:ext uri="{FF2B5EF4-FFF2-40B4-BE49-F238E27FC236}">
                  <a16:creationId xmlns:a16="http://schemas.microsoft.com/office/drawing/2014/main" id="{E1D02969-B6CC-4C26-BACC-ACD7D529C7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700" y="1423988"/>
              <a:ext cx="12700" cy="127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6">
              <a:extLst>
                <a:ext uri="{FF2B5EF4-FFF2-40B4-BE49-F238E27FC236}">
                  <a16:creationId xmlns:a16="http://schemas.microsoft.com/office/drawing/2014/main" id="{81198873-E377-4E1A-AD98-0AA51313DF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963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7">
              <a:extLst>
                <a:ext uri="{FF2B5EF4-FFF2-40B4-BE49-F238E27FC236}">
                  <a16:creationId xmlns:a16="http://schemas.microsoft.com/office/drawing/2014/main" id="{C8DE1B10-58B7-469D-B3D6-286698AD84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849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8">
              <a:extLst>
                <a:ext uri="{FF2B5EF4-FFF2-40B4-BE49-F238E27FC236}">
                  <a16:creationId xmlns:a16="http://schemas.microsoft.com/office/drawing/2014/main" id="{6ABC764C-8783-4816-BF06-691BD682B1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37605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9">
              <a:extLst>
                <a:ext uri="{FF2B5EF4-FFF2-40B4-BE49-F238E27FC236}">
                  <a16:creationId xmlns:a16="http://schemas.microsoft.com/office/drawing/2014/main" id="{EF772464-5674-4F36-B431-D5A1B3690B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544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0">
              <a:extLst>
                <a:ext uri="{FF2B5EF4-FFF2-40B4-BE49-F238E27FC236}">
                  <a16:creationId xmlns:a16="http://schemas.microsoft.com/office/drawing/2014/main" id="{3D00D977-80C6-4BFB-9FD9-13E872ACB2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430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Line 11">
              <a:extLst>
                <a:ext uri="{FF2B5EF4-FFF2-40B4-BE49-F238E27FC236}">
                  <a16:creationId xmlns:a16="http://schemas.microsoft.com/office/drawing/2014/main" id="{34B059CA-9E11-47D2-A338-91488A0E7F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3341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12">
              <a:extLst>
                <a:ext uri="{FF2B5EF4-FFF2-40B4-BE49-F238E27FC236}">
                  <a16:creationId xmlns:a16="http://schemas.microsoft.com/office/drawing/2014/main" id="{0647C739-6981-4623-9319-1C1A52B811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31382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3">
              <a:extLst>
                <a:ext uri="{FF2B5EF4-FFF2-40B4-BE49-F238E27FC236}">
                  <a16:creationId xmlns:a16="http://schemas.microsoft.com/office/drawing/2014/main" id="{D88ED72B-9DF1-40FF-B5A8-BE99FA2CD7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30239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Line 14">
              <a:extLst>
                <a:ext uri="{FF2B5EF4-FFF2-40B4-BE49-F238E27FC236}">
                  <a16:creationId xmlns:a16="http://schemas.microsoft.com/office/drawing/2014/main" id="{A40DE045-4A97-4A67-8612-92D82860BC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9350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Line 15">
              <a:extLst>
                <a:ext uri="{FF2B5EF4-FFF2-40B4-BE49-F238E27FC236}">
                  <a16:creationId xmlns:a16="http://schemas.microsoft.com/office/drawing/2014/main" id="{4DD4D25D-6E7E-4DA2-92EC-50A3CFEED0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27191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6">
              <a:extLst>
                <a:ext uri="{FF2B5EF4-FFF2-40B4-BE49-F238E27FC236}">
                  <a16:creationId xmlns:a16="http://schemas.microsoft.com/office/drawing/2014/main" id="{8B496F13-A082-4208-A7F9-85C06D29EB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26048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17">
              <a:extLst>
                <a:ext uri="{FF2B5EF4-FFF2-40B4-BE49-F238E27FC236}">
                  <a16:creationId xmlns:a16="http://schemas.microsoft.com/office/drawing/2014/main" id="{FBA2C5CA-79AD-4E57-94D1-56826141CF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5159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18">
              <a:extLst>
                <a:ext uri="{FF2B5EF4-FFF2-40B4-BE49-F238E27FC236}">
                  <a16:creationId xmlns:a16="http://schemas.microsoft.com/office/drawing/2014/main" id="{C3BF85FB-BE6B-45B8-88A8-6ECD0878AE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2312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19">
              <a:extLst>
                <a:ext uri="{FF2B5EF4-FFF2-40B4-BE49-F238E27FC236}">
                  <a16:creationId xmlns:a16="http://schemas.microsoft.com/office/drawing/2014/main" id="{2033FD13-F0F6-41DD-AA16-01D3CBFF45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2198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0">
              <a:extLst>
                <a:ext uri="{FF2B5EF4-FFF2-40B4-BE49-F238E27FC236}">
                  <a16:creationId xmlns:a16="http://schemas.microsoft.com/office/drawing/2014/main" id="{92AA39B5-171D-43AA-85E0-1315472BEA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20968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1">
              <a:extLst>
                <a:ext uri="{FF2B5EF4-FFF2-40B4-BE49-F238E27FC236}">
                  <a16:creationId xmlns:a16="http://schemas.microsoft.com/office/drawing/2014/main" id="{289DCD35-9630-4A3D-96FD-0CE04DC5A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38686" y="1893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2">
              <a:extLst>
                <a:ext uri="{FF2B5EF4-FFF2-40B4-BE49-F238E27FC236}">
                  <a16:creationId xmlns:a16="http://schemas.microsoft.com/office/drawing/2014/main" id="{E337351A-31BE-4185-9886-4F53FC8BA6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686" y="1779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23">
              <a:extLst>
                <a:ext uri="{FF2B5EF4-FFF2-40B4-BE49-F238E27FC236}">
                  <a16:creationId xmlns:a16="http://schemas.microsoft.com/office/drawing/2014/main" id="{900857D4-1914-4ADE-80E0-152D62FB42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76786" y="1690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Line 31">
              <a:extLst>
                <a:ext uri="{FF2B5EF4-FFF2-40B4-BE49-F238E27FC236}">
                  <a16:creationId xmlns:a16="http://schemas.microsoft.com/office/drawing/2014/main" id="{7FA77F55-D109-4E98-A053-D29199A982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48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81189238-2730-48F0-8D9D-22D4FB82B6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4086" y="4052680"/>
              <a:ext cx="53884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Line 33">
              <a:extLst>
                <a:ext uri="{FF2B5EF4-FFF2-40B4-BE49-F238E27FC236}">
                  <a16:creationId xmlns:a16="http://schemas.microsoft.com/office/drawing/2014/main" id="{D413805E-51A9-41FC-9061-CF1657675E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085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B213B726-493F-4FB9-B05B-AE9EE342F6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96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Line 35">
              <a:extLst>
                <a:ext uri="{FF2B5EF4-FFF2-40B4-BE49-F238E27FC236}">
                  <a16:creationId xmlns:a16="http://schemas.microsoft.com/office/drawing/2014/main" id="{DDD502A4-DE86-4DC3-B29C-EFC83393AB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895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F111C11A-E5C4-4B2D-AC98-A68D3221B9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06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Line 37">
              <a:extLst>
                <a:ext uri="{FF2B5EF4-FFF2-40B4-BE49-F238E27FC236}">
                  <a16:creationId xmlns:a16="http://schemas.microsoft.com/office/drawing/2014/main" id="{775D1D83-9FE9-40CB-AFB9-A5A9287C65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32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F67B30F3-0B25-43D7-837B-1873B8EB96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43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Line 39">
              <a:extLst>
                <a:ext uri="{FF2B5EF4-FFF2-40B4-BE49-F238E27FC236}">
                  <a16:creationId xmlns:a16="http://schemas.microsoft.com/office/drawing/2014/main" id="{6F6C327E-9727-4064-BB56-C59ED00820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69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CCF4FC84-D300-443D-AAE9-98C7D890F6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8086" y="40526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Line 41">
              <a:extLst>
                <a:ext uri="{FF2B5EF4-FFF2-40B4-BE49-F238E27FC236}">
                  <a16:creationId xmlns:a16="http://schemas.microsoft.com/office/drawing/2014/main" id="{DAE8F3C8-CACA-4F94-ADF9-F79B096BEE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579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6AD6FC54-12FE-487C-83EB-D21AC3AB8F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82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Line 43">
              <a:extLst>
                <a:ext uri="{FF2B5EF4-FFF2-40B4-BE49-F238E27FC236}">
                  <a16:creationId xmlns:a16="http://schemas.microsoft.com/office/drawing/2014/main" id="{8323EBA0-2C57-4E3F-BAE9-0A976938BE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516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03D90D5B-416D-43DD-AC87-E8FCD50957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19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Line 45">
              <a:extLst>
                <a:ext uri="{FF2B5EF4-FFF2-40B4-BE49-F238E27FC236}">
                  <a16:creationId xmlns:a16="http://schemas.microsoft.com/office/drawing/2014/main" id="{A8463F09-8C7B-41CF-9BA4-E746D01D14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53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46EE9B1D-AE33-4CD4-B551-F70364EB4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56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Line 47">
              <a:extLst>
                <a:ext uri="{FF2B5EF4-FFF2-40B4-BE49-F238E27FC236}">
                  <a16:creationId xmlns:a16="http://schemas.microsoft.com/office/drawing/2014/main" id="{3AA36CA2-BA8C-4C02-862C-8F182C9449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263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178291A9-1C61-480A-B80B-4EA006A90E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66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Line 49">
              <a:extLst>
                <a:ext uri="{FF2B5EF4-FFF2-40B4-BE49-F238E27FC236}">
                  <a16:creationId xmlns:a16="http://schemas.microsoft.com/office/drawing/2014/main" id="{52DE115A-8147-46DC-86A6-26EA20DC91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0086" y="39637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C65AA564-D89D-42AB-997D-CBB8EE30DC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0386" y="40526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16F26561-AF15-4FF8-B62D-C83F9A1FF6BD}"/>
                </a:ext>
              </a:extLst>
            </p:cNvPr>
            <p:cNvCxnSpPr/>
            <p:nvPr/>
          </p:nvCxnSpPr>
          <p:spPr>
            <a:xfrm flipV="1">
              <a:off x="1012367" y="1665919"/>
              <a:ext cx="0" cy="228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7838F753-8D26-4966-AD60-9ACAD8665A22}"/>
                </a:ext>
              </a:extLst>
            </p:cNvPr>
            <p:cNvCxnSpPr/>
            <p:nvPr/>
          </p:nvCxnSpPr>
          <p:spPr>
            <a:xfrm>
              <a:off x="995836" y="3963780"/>
              <a:ext cx="3505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A19CE15-0DA7-46A2-96AF-DE2CBA7EDC0C}"/>
              </a:ext>
            </a:extLst>
          </p:cNvPr>
          <p:cNvSpPr txBox="1"/>
          <p:nvPr/>
        </p:nvSpPr>
        <p:spPr>
          <a:xfrm rot="16200000">
            <a:off x="5323044" y="3286833"/>
            <a:ext cx="2373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 of disease-free surviv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54">
            <a:extLst>
              <a:ext uri="{FF2B5EF4-FFF2-40B4-BE49-F238E27FC236}">
                <a16:creationId xmlns:a16="http://schemas.microsoft.com/office/drawing/2014/main" id="{5ADE0D89-CBF1-46CF-8F20-E2E07437B1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2855" y="185285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62">
            <a:extLst>
              <a:ext uri="{FF2B5EF4-FFF2-40B4-BE49-F238E27FC236}">
                <a16:creationId xmlns:a16="http://schemas.microsoft.com/office/drawing/2014/main" id="{86AEE0FB-2B10-449F-9149-89178B9D17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2001" y="1584946"/>
            <a:ext cx="15112" cy="1728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439EA555-CA1D-494C-8D48-CC121B1D8A6C}"/>
              </a:ext>
            </a:extLst>
          </p:cNvPr>
          <p:cNvSpPr txBox="1"/>
          <p:nvPr/>
        </p:nvSpPr>
        <p:spPr>
          <a:xfrm>
            <a:off x="6344898" y="1252023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36218B09-70A0-492C-8B3F-BD3D19723A59}"/>
              </a:ext>
            </a:extLst>
          </p:cNvPr>
          <p:cNvGrpSpPr/>
          <p:nvPr/>
        </p:nvGrpSpPr>
        <p:grpSpPr>
          <a:xfrm>
            <a:off x="6886634" y="2077271"/>
            <a:ext cx="4590085" cy="3762263"/>
            <a:chOff x="7459931" y="1690480"/>
            <a:chExt cx="3857353" cy="2764367"/>
          </a:xfrm>
        </p:grpSpPr>
        <p:sp>
          <p:nvSpPr>
            <p:cNvPr id="62" name="Line 63">
              <a:extLst>
                <a:ext uri="{FF2B5EF4-FFF2-40B4-BE49-F238E27FC236}">
                  <a16:creationId xmlns:a16="http://schemas.microsoft.com/office/drawing/2014/main" id="{41F20D0C-E0AF-42F7-B58B-6C605EF4AF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9764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4">
              <a:extLst>
                <a:ext uri="{FF2B5EF4-FFF2-40B4-BE49-F238E27FC236}">
                  <a16:creationId xmlns:a16="http://schemas.microsoft.com/office/drawing/2014/main" id="{83553F3B-8E08-4AB6-A0F8-9B9A44F3FF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8621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Line 65">
              <a:extLst>
                <a:ext uri="{FF2B5EF4-FFF2-40B4-BE49-F238E27FC236}">
                  <a16:creationId xmlns:a16="http://schemas.microsoft.com/office/drawing/2014/main" id="{4C7A6457-115C-48F4-88FB-17F890035C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7732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66">
              <a:extLst>
                <a:ext uri="{FF2B5EF4-FFF2-40B4-BE49-F238E27FC236}">
                  <a16:creationId xmlns:a16="http://schemas.microsoft.com/office/drawing/2014/main" id="{3305D2F6-BF2B-46EE-9670-112914A723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5573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7">
              <a:extLst>
                <a:ext uri="{FF2B5EF4-FFF2-40B4-BE49-F238E27FC236}">
                  <a16:creationId xmlns:a16="http://schemas.microsoft.com/office/drawing/2014/main" id="{DFD05DB3-5F97-4F0D-A0FA-EF45BB9435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4430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68">
              <a:extLst>
                <a:ext uri="{FF2B5EF4-FFF2-40B4-BE49-F238E27FC236}">
                  <a16:creationId xmlns:a16="http://schemas.microsoft.com/office/drawing/2014/main" id="{F04FC540-040E-48DD-9641-D4FE9BACC6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33541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Line 69">
              <a:extLst>
                <a:ext uri="{FF2B5EF4-FFF2-40B4-BE49-F238E27FC236}">
                  <a16:creationId xmlns:a16="http://schemas.microsoft.com/office/drawing/2014/main" id="{B1E8748E-4C60-4417-8A52-2F0BA25A44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31509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70">
              <a:extLst>
                <a:ext uri="{FF2B5EF4-FFF2-40B4-BE49-F238E27FC236}">
                  <a16:creationId xmlns:a16="http://schemas.microsoft.com/office/drawing/2014/main" id="{E6DA65AB-DAB6-4C44-8C0E-56B5F98C7F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30366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Line 71">
              <a:extLst>
                <a:ext uri="{FF2B5EF4-FFF2-40B4-BE49-F238E27FC236}">
                  <a16:creationId xmlns:a16="http://schemas.microsoft.com/office/drawing/2014/main" id="{E0B76009-2AE0-4B69-ABEA-447C4F4FC7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9350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72">
              <a:extLst>
                <a:ext uri="{FF2B5EF4-FFF2-40B4-BE49-F238E27FC236}">
                  <a16:creationId xmlns:a16="http://schemas.microsoft.com/office/drawing/2014/main" id="{93F0280B-851B-49B1-9957-8AA88487A7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7318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3">
              <a:extLst>
                <a:ext uri="{FF2B5EF4-FFF2-40B4-BE49-F238E27FC236}">
                  <a16:creationId xmlns:a16="http://schemas.microsoft.com/office/drawing/2014/main" id="{1307051F-6A0E-4F4D-B7FA-7BDD4E63CF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6175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74">
              <a:extLst>
                <a:ext uri="{FF2B5EF4-FFF2-40B4-BE49-F238E27FC236}">
                  <a16:creationId xmlns:a16="http://schemas.microsoft.com/office/drawing/2014/main" id="{282329DE-F3D9-4A5E-83CE-3337E18411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5159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Line 75">
              <a:extLst>
                <a:ext uri="{FF2B5EF4-FFF2-40B4-BE49-F238E27FC236}">
                  <a16:creationId xmlns:a16="http://schemas.microsoft.com/office/drawing/2014/main" id="{A60AD0E9-8E61-4AC3-ADDD-4F7AC3567F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23127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6">
              <a:extLst>
                <a:ext uri="{FF2B5EF4-FFF2-40B4-BE49-F238E27FC236}">
                  <a16:creationId xmlns:a16="http://schemas.microsoft.com/office/drawing/2014/main" id="{879224D7-A042-4A35-8D58-C7D3C5C07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21984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77">
              <a:extLst>
                <a:ext uri="{FF2B5EF4-FFF2-40B4-BE49-F238E27FC236}">
                  <a16:creationId xmlns:a16="http://schemas.microsoft.com/office/drawing/2014/main" id="{08824B05-68E4-4F80-9155-B84D351080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21095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78">
              <a:extLst>
                <a:ext uri="{FF2B5EF4-FFF2-40B4-BE49-F238E27FC236}">
                  <a16:creationId xmlns:a16="http://schemas.microsoft.com/office/drawing/2014/main" id="{61BDC263-2846-407F-BBF1-F5CD38FE77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13931" y="1893680"/>
              <a:ext cx="762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9">
              <a:extLst>
                <a:ext uri="{FF2B5EF4-FFF2-40B4-BE49-F238E27FC236}">
                  <a16:creationId xmlns:a16="http://schemas.microsoft.com/office/drawing/2014/main" id="{38540C36-D3E0-4EC7-BBBF-90FE8F9A61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59931" y="1779380"/>
              <a:ext cx="134711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80">
              <a:extLst>
                <a:ext uri="{FF2B5EF4-FFF2-40B4-BE49-F238E27FC236}">
                  <a16:creationId xmlns:a16="http://schemas.microsoft.com/office/drawing/2014/main" id="{E3213FA5-EE36-4249-ABE8-B62B7BAB1F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752031" y="1690480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88">
              <a:extLst>
                <a:ext uri="{FF2B5EF4-FFF2-40B4-BE49-F238E27FC236}">
                  <a16:creationId xmlns:a16="http://schemas.microsoft.com/office/drawing/2014/main" id="{FBC427DB-5467-4F7D-9CC8-D3A80CFD34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901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9">
              <a:extLst>
                <a:ext uri="{FF2B5EF4-FFF2-40B4-BE49-F238E27FC236}">
                  <a16:creationId xmlns:a16="http://schemas.microsoft.com/office/drawing/2014/main" id="{27F7BF80-1498-4857-9419-C89A9A3007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39331" y="4065380"/>
              <a:ext cx="53884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Line 90">
              <a:extLst>
                <a:ext uri="{FF2B5EF4-FFF2-40B4-BE49-F238E27FC236}">
                  <a16:creationId xmlns:a16="http://schemas.microsoft.com/office/drawing/2014/main" id="{25E60813-C7B0-4EEE-AFDF-31A3EF2679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3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91">
              <a:extLst>
                <a:ext uri="{FF2B5EF4-FFF2-40B4-BE49-F238E27FC236}">
                  <a16:creationId xmlns:a16="http://schemas.microsoft.com/office/drawing/2014/main" id="{30557258-2C77-421B-8051-C146DC7BE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4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Line 92">
              <a:extLst>
                <a:ext uri="{FF2B5EF4-FFF2-40B4-BE49-F238E27FC236}">
                  <a16:creationId xmlns:a16="http://schemas.microsoft.com/office/drawing/2014/main" id="{47B82442-125E-4C02-9613-56B5A88FCE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648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93">
              <a:extLst>
                <a:ext uri="{FF2B5EF4-FFF2-40B4-BE49-F238E27FC236}">
                  <a16:creationId xmlns:a16="http://schemas.microsoft.com/office/drawing/2014/main" id="{67DA3106-B6CE-4AF9-8129-9C14D84B2B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759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Line 94">
              <a:extLst>
                <a:ext uri="{FF2B5EF4-FFF2-40B4-BE49-F238E27FC236}">
                  <a16:creationId xmlns:a16="http://schemas.microsoft.com/office/drawing/2014/main" id="{EA2DA26D-0B9D-42AD-A6D3-8633AB6FD6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585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95">
              <a:extLst>
                <a:ext uri="{FF2B5EF4-FFF2-40B4-BE49-F238E27FC236}">
                  <a16:creationId xmlns:a16="http://schemas.microsoft.com/office/drawing/2014/main" id="{07BDF8C0-AD27-4329-9C53-8012ABD7D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96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Line 96">
              <a:extLst>
                <a:ext uri="{FF2B5EF4-FFF2-40B4-BE49-F238E27FC236}">
                  <a16:creationId xmlns:a16="http://schemas.microsoft.com/office/drawing/2014/main" id="{706C4FB7-1F4B-4E59-A919-663C3D0EC7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52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97">
              <a:extLst>
                <a:ext uri="{FF2B5EF4-FFF2-40B4-BE49-F238E27FC236}">
                  <a16:creationId xmlns:a16="http://schemas.microsoft.com/office/drawing/2014/main" id="{3BFDB2BF-179C-4E31-AB61-684AD23FD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63331" y="4065380"/>
              <a:ext cx="107769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Line 98">
              <a:extLst>
                <a:ext uri="{FF2B5EF4-FFF2-40B4-BE49-F238E27FC236}">
                  <a16:creationId xmlns:a16="http://schemas.microsoft.com/office/drawing/2014/main" id="{21AC52E1-371D-427F-BE5D-6A90BAF3EF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332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9">
              <a:extLst>
                <a:ext uri="{FF2B5EF4-FFF2-40B4-BE49-F238E27FC236}">
                  <a16:creationId xmlns:a16="http://schemas.microsoft.com/office/drawing/2014/main" id="{03D4FA76-5ACA-458B-A5D9-CE7E504882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935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Line 100">
              <a:extLst>
                <a:ext uri="{FF2B5EF4-FFF2-40B4-BE49-F238E27FC236}">
                  <a16:creationId xmlns:a16="http://schemas.microsoft.com/office/drawing/2014/main" id="{5C2A47F8-A813-47B1-9253-05D0DB7651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269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101">
              <a:extLst>
                <a:ext uri="{FF2B5EF4-FFF2-40B4-BE49-F238E27FC236}">
                  <a16:creationId xmlns:a16="http://schemas.microsoft.com/office/drawing/2014/main" id="{5485F41C-78F6-49C2-8154-A0F1C2F2E8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72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2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Line 102">
              <a:extLst>
                <a:ext uri="{FF2B5EF4-FFF2-40B4-BE49-F238E27FC236}">
                  <a16:creationId xmlns:a16="http://schemas.microsoft.com/office/drawing/2014/main" id="{421C9D4D-AD36-4AFB-884C-190B38C9E8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520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103">
              <a:extLst>
                <a:ext uri="{FF2B5EF4-FFF2-40B4-BE49-F238E27FC236}">
                  <a16:creationId xmlns:a16="http://schemas.microsoft.com/office/drawing/2014/main" id="{ED7AF7CF-DBD1-40B3-81CA-5A2D8DE7E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0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0</a:t>
              </a:r>
              <a:endParaRPr kumimoji="0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Line 104">
              <a:extLst>
                <a:ext uri="{FF2B5EF4-FFF2-40B4-BE49-F238E27FC236}">
                  <a16:creationId xmlns:a16="http://schemas.microsoft.com/office/drawing/2014/main" id="{A4D98045-6380-4369-9C98-80EF061F76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9016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105">
              <a:extLst>
                <a:ext uri="{FF2B5EF4-FFF2-40B4-BE49-F238E27FC236}">
                  <a16:creationId xmlns:a16="http://schemas.microsoft.com/office/drawing/2014/main" id="{64D288A7-D11F-453A-B3A3-758634E72C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619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Line 106">
              <a:extLst>
                <a:ext uri="{FF2B5EF4-FFF2-40B4-BE49-F238E27FC236}">
                  <a16:creationId xmlns:a16="http://schemas.microsoft.com/office/drawing/2014/main" id="{7A47BB4C-8D3C-41AB-A54D-B7D380450F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95331" y="3976480"/>
              <a:ext cx="0" cy="762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107">
              <a:extLst>
                <a:ext uri="{FF2B5EF4-FFF2-40B4-BE49-F238E27FC236}">
                  <a16:creationId xmlns:a16="http://schemas.microsoft.com/office/drawing/2014/main" id="{8A60A163-C5E9-4A76-BFEC-AF0AA369E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55631" y="4065380"/>
              <a:ext cx="161653" cy="1130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80</a:t>
              </a:r>
              <a:endPara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2" name="グループ化 101">
              <a:extLst>
                <a:ext uri="{FF2B5EF4-FFF2-40B4-BE49-F238E27FC236}">
                  <a16:creationId xmlns:a16="http://schemas.microsoft.com/office/drawing/2014/main" id="{DF8F8734-00E3-4B05-B0AF-441F97D44B2E}"/>
                </a:ext>
              </a:extLst>
            </p:cNvPr>
            <p:cNvGrpSpPr/>
            <p:nvPr/>
          </p:nvGrpSpPr>
          <p:grpSpPr>
            <a:xfrm>
              <a:off x="7790131" y="1690480"/>
              <a:ext cx="3505200" cy="2764367"/>
              <a:chOff x="7009954" y="1690480"/>
              <a:chExt cx="3505200" cy="2764367"/>
            </a:xfrm>
          </p:grpSpPr>
          <p:sp>
            <p:nvSpPr>
              <p:cNvPr id="104" name="Rectangle 45">
                <a:extLst>
                  <a:ext uri="{FF2B5EF4-FFF2-40B4-BE49-F238E27FC236}">
                    <a16:creationId xmlns:a16="http://schemas.microsoft.com/office/drawing/2014/main" id="{21DAD6E6-888F-4B4A-9BAF-5CC391EEC7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04384" y="4341776"/>
                <a:ext cx="643918" cy="113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Time (months)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5" name="グループ化 104">
                <a:extLst>
                  <a:ext uri="{FF2B5EF4-FFF2-40B4-BE49-F238E27FC236}">
                    <a16:creationId xmlns:a16="http://schemas.microsoft.com/office/drawing/2014/main" id="{374252DF-92F4-4689-B375-08CDA6EA4601}"/>
                  </a:ext>
                </a:extLst>
              </p:cNvPr>
              <p:cNvGrpSpPr/>
              <p:nvPr/>
            </p:nvGrpSpPr>
            <p:grpSpPr>
              <a:xfrm>
                <a:off x="7009954" y="1690480"/>
                <a:ext cx="3505200" cy="2286000"/>
                <a:chOff x="7009954" y="1690480"/>
                <a:chExt cx="3505200" cy="2286000"/>
              </a:xfrm>
            </p:grpSpPr>
            <p:cxnSp>
              <p:nvCxnSpPr>
                <p:cNvPr id="109" name="直線コネクタ 108">
                  <a:extLst>
                    <a:ext uri="{FF2B5EF4-FFF2-40B4-BE49-F238E27FC236}">
                      <a16:creationId xmlns:a16="http://schemas.microsoft.com/office/drawing/2014/main" id="{3002C42D-FC6D-4379-86CD-1E7574303729}"/>
                    </a:ext>
                  </a:extLst>
                </p:cNvPr>
                <p:cNvCxnSpPr/>
                <p:nvPr/>
              </p:nvCxnSpPr>
              <p:spPr>
                <a:xfrm flipV="1">
                  <a:off x="7009954" y="1690480"/>
                  <a:ext cx="0" cy="2286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線コネクタ 106">
                  <a:extLst>
                    <a:ext uri="{FF2B5EF4-FFF2-40B4-BE49-F238E27FC236}">
                      <a16:creationId xmlns:a16="http://schemas.microsoft.com/office/drawing/2014/main" id="{4C9FD613-8D49-4AE1-B91A-6F36E727A319}"/>
                    </a:ext>
                  </a:extLst>
                </p:cNvPr>
                <p:cNvCxnSpPr/>
                <p:nvPr/>
              </p:nvCxnSpPr>
              <p:spPr>
                <a:xfrm>
                  <a:off x="7009954" y="3972169"/>
                  <a:ext cx="3505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F04BF26B-DF10-4A98-9F57-2BA9449440F9}"/>
              </a:ext>
            </a:extLst>
          </p:cNvPr>
          <p:cNvCxnSpPr>
            <a:cxnSpLocks/>
          </p:cNvCxnSpPr>
          <p:nvPr/>
        </p:nvCxnSpPr>
        <p:spPr>
          <a:xfrm>
            <a:off x="7464197" y="1503350"/>
            <a:ext cx="43008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B15B3EB1-AC86-4E9A-9858-708DB9127620}"/>
              </a:ext>
            </a:extLst>
          </p:cNvPr>
          <p:cNvSpPr txBox="1"/>
          <p:nvPr/>
        </p:nvSpPr>
        <p:spPr>
          <a:xfrm>
            <a:off x="3841688" y="3293958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ong course</a:t>
            </a:r>
            <a:endParaRPr kumimoji="1" lang="en-US" altLang="ja-JP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28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D639AFD9-025D-4454-A021-2C90463C0EF8}"/>
              </a:ext>
            </a:extLst>
          </p:cNvPr>
          <p:cNvSpPr txBox="1"/>
          <p:nvPr/>
        </p:nvSpPr>
        <p:spPr>
          <a:xfrm>
            <a:off x="3841688" y="4212129"/>
            <a:ext cx="8098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hort course</a:t>
            </a:r>
            <a:endParaRPr kumimoji="1" lang="en-US" altLang="ja-JP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10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0595C1BE-F240-4791-BD92-06310170C689}"/>
              </a:ext>
            </a:extLst>
          </p:cNvPr>
          <p:cNvSpPr txBox="1"/>
          <p:nvPr/>
        </p:nvSpPr>
        <p:spPr>
          <a:xfrm>
            <a:off x="1251945" y="4792787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=</a:t>
            </a:r>
            <a:r>
              <a:rPr kumimoji="1" lang="en-US" altLang="ja-JP" sz="1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49</a:t>
            </a:r>
            <a:endParaRPr kumimoji="1" lang="ja-JP" altLang="en-US" sz="10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776C3EBA-7E17-49EC-8771-E0105FD1DA1E}"/>
              </a:ext>
            </a:extLst>
          </p:cNvPr>
          <p:cNvSpPr txBox="1"/>
          <p:nvPr/>
        </p:nvSpPr>
        <p:spPr>
          <a:xfrm>
            <a:off x="9710543" y="3577590"/>
            <a:ext cx="8130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ong course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</a:t>
            </a: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8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70C198C5-7BD2-4687-A821-B207CE107093}"/>
              </a:ext>
            </a:extLst>
          </p:cNvPr>
          <p:cNvSpPr txBox="1"/>
          <p:nvPr/>
        </p:nvSpPr>
        <p:spPr>
          <a:xfrm>
            <a:off x="9749756" y="4257309"/>
            <a:ext cx="8098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hort course</a:t>
            </a:r>
            <a:endParaRPr kumimoji="1" lang="en-US" altLang="ja-JP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n=10)</a:t>
            </a:r>
            <a:endParaRPr kumimoji="1" lang="ja-JP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7AAFB70D-85D0-4456-BA9F-0048EE36819E}"/>
              </a:ext>
            </a:extLst>
          </p:cNvPr>
          <p:cNvSpPr txBox="1"/>
          <p:nvPr/>
        </p:nvSpPr>
        <p:spPr>
          <a:xfrm>
            <a:off x="7372153" y="4792787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</a:t>
            </a:r>
            <a:r>
              <a:rPr kumimoji="1" lang="en-US" altLang="ja-JP" sz="1000" b="0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=</a:t>
            </a:r>
            <a:r>
              <a:rPr kumimoji="1" lang="en-US" altLang="ja-JP" sz="1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.96</a:t>
            </a:r>
            <a:endParaRPr kumimoji="1" lang="ja-JP" altLang="en-US" sz="10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0" name="Freeform 209">
            <a:extLst>
              <a:ext uri="{FF2B5EF4-FFF2-40B4-BE49-F238E27FC236}">
                <a16:creationId xmlns:a16="http://schemas.microsoft.com/office/drawing/2014/main" id="{8A96ADB2-495D-4E30-8379-6CF77CD25C77}"/>
              </a:ext>
            </a:extLst>
          </p:cNvPr>
          <p:cNvSpPr>
            <a:spLocks/>
          </p:cNvSpPr>
          <p:nvPr/>
        </p:nvSpPr>
        <p:spPr bwMode="auto">
          <a:xfrm>
            <a:off x="1131895" y="2363049"/>
            <a:ext cx="3860800" cy="1520825"/>
          </a:xfrm>
          <a:custGeom>
            <a:avLst/>
            <a:gdLst>
              <a:gd name="T0" fmla="*/ 0 w 2432"/>
              <a:gd name="T1" fmla="*/ 0 h 958"/>
              <a:gd name="T2" fmla="*/ 172 w 2432"/>
              <a:gd name="T3" fmla="*/ 0 h 958"/>
              <a:gd name="T4" fmla="*/ 172 w 2432"/>
              <a:gd name="T5" fmla="*/ 63 h 958"/>
              <a:gd name="T6" fmla="*/ 230 w 2432"/>
              <a:gd name="T7" fmla="*/ 63 h 958"/>
              <a:gd name="T8" fmla="*/ 230 w 2432"/>
              <a:gd name="T9" fmla="*/ 125 h 958"/>
              <a:gd name="T10" fmla="*/ 332 w 2432"/>
              <a:gd name="T11" fmla="*/ 125 h 958"/>
              <a:gd name="T12" fmla="*/ 369 w 2432"/>
              <a:gd name="T13" fmla="*/ 125 h 958"/>
              <a:gd name="T14" fmla="*/ 401 w 2432"/>
              <a:gd name="T15" fmla="*/ 125 h 958"/>
              <a:gd name="T16" fmla="*/ 413 w 2432"/>
              <a:gd name="T17" fmla="*/ 125 h 958"/>
              <a:gd name="T18" fmla="*/ 413 w 2432"/>
              <a:gd name="T19" fmla="*/ 194 h 958"/>
              <a:gd name="T20" fmla="*/ 427 w 2432"/>
              <a:gd name="T21" fmla="*/ 194 h 958"/>
              <a:gd name="T22" fmla="*/ 427 w 2432"/>
              <a:gd name="T23" fmla="*/ 265 h 958"/>
              <a:gd name="T24" fmla="*/ 448 w 2432"/>
              <a:gd name="T25" fmla="*/ 265 h 958"/>
              <a:gd name="T26" fmla="*/ 448 w 2432"/>
              <a:gd name="T27" fmla="*/ 335 h 958"/>
              <a:gd name="T28" fmla="*/ 506 w 2432"/>
              <a:gd name="T29" fmla="*/ 335 h 958"/>
              <a:gd name="T30" fmla="*/ 506 w 2432"/>
              <a:gd name="T31" fmla="*/ 404 h 958"/>
              <a:gd name="T32" fmla="*/ 513 w 2432"/>
              <a:gd name="T33" fmla="*/ 404 h 958"/>
              <a:gd name="T34" fmla="*/ 513 w 2432"/>
              <a:gd name="T35" fmla="*/ 474 h 958"/>
              <a:gd name="T36" fmla="*/ 526 w 2432"/>
              <a:gd name="T37" fmla="*/ 474 h 958"/>
              <a:gd name="T38" fmla="*/ 616 w 2432"/>
              <a:gd name="T39" fmla="*/ 474 h 958"/>
              <a:gd name="T40" fmla="*/ 649 w 2432"/>
              <a:gd name="T41" fmla="*/ 474 h 958"/>
              <a:gd name="T42" fmla="*/ 753 w 2432"/>
              <a:gd name="T43" fmla="*/ 474 h 958"/>
              <a:gd name="T44" fmla="*/ 764 w 2432"/>
              <a:gd name="T45" fmla="*/ 474 h 958"/>
              <a:gd name="T46" fmla="*/ 785 w 2432"/>
              <a:gd name="T47" fmla="*/ 474 h 958"/>
              <a:gd name="T48" fmla="*/ 785 w 2432"/>
              <a:gd name="T49" fmla="*/ 571 h 958"/>
              <a:gd name="T50" fmla="*/ 819 w 2432"/>
              <a:gd name="T51" fmla="*/ 571 h 958"/>
              <a:gd name="T52" fmla="*/ 846 w 2432"/>
              <a:gd name="T53" fmla="*/ 571 h 958"/>
              <a:gd name="T54" fmla="*/ 913 w 2432"/>
              <a:gd name="T55" fmla="*/ 571 h 958"/>
              <a:gd name="T56" fmla="*/ 987 w 2432"/>
              <a:gd name="T57" fmla="*/ 571 h 958"/>
              <a:gd name="T58" fmla="*/ 987 w 2432"/>
              <a:gd name="T59" fmla="*/ 700 h 958"/>
              <a:gd name="T60" fmla="*/ 1011 w 2432"/>
              <a:gd name="T61" fmla="*/ 700 h 958"/>
              <a:gd name="T62" fmla="*/ 1023 w 2432"/>
              <a:gd name="T63" fmla="*/ 700 h 958"/>
              <a:gd name="T64" fmla="*/ 1034 w 2432"/>
              <a:gd name="T65" fmla="*/ 700 h 958"/>
              <a:gd name="T66" fmla="*/ 1113 w 2432"/>
              <a:gd name="T67" fmla="*/ 700 h 958"/>
              <a:gd name="T68" fmla="*/ 1123 w 2432"/>
              <a:gd name="T69" fmla="*/ 700 h 958"/>
              <a:gd name="T70" fmla="*/ 1123 w 2432"/>
              <a:gd name="T71" fmla="*/ 958 h 958"/>
              <a:gd name="T72" fmla="*/ 1262 w 2432"/>
              <a:gd name="T73" fmla="*/ 958 h 958"/>
              <a:gd name="T74" fmla="*/ 1378 w 2432"/>
              <a:gd name="T75" fmla="*/ 958 h 958"/>
              <a:gd name="T76" fmla="*/ 2432 w 2432"/>
              <a:gd name="T77" fmla="*/ 958 h 9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</a:cxnLst>
            <a:rect l="0" t="0" r="r" b="b"/>
            <a:pathLst>
              <a:path w="2432" h="958">
                <a:moveTo>
                  <a:pt x="0" y="0"/>
                </a:moveTo>
                <a:lnTo>
                  <a:pt x="172" y="0"/>
                </a:lnTo>
                <a:lnTo>
                  <a:pt x="172" y="63"/>
                </a:lnTo>
                <a:lnTo>
                  <a:pt x="230" y="63"/>
                </a:lnTo>
                <a:lnTo>
                  <a:pt x="230" y="125"/>
                </a:lnTo>
                <a:lnTo>
                  <a:pt x="332" y="125"/>
                </a:lnTo>
                <a:lnTo>
                  <a:pt x="369" y="125"/>
                </a:lnTo>
                <a:lnTo>
                  <a:pt x="401" y="125"/>
                </a:lnTo>
                <a:lnTo>
                  <a:pt x="413" y="125"/>
                </a:lnTo>
                <a:lnTo>
                  <a:pt x="413" y="194"/>
                </a:lnTo>
                <a:lnTo>
                  <a:pt x="427" y="194"/>
                </a:lnTo>
                <a:lnTo>
                  <a:pt x="427" y="265"/>
                </a:lnTo>
                <a:lnTo>
                  <a:pt x="448" y="265"/>
                </a:lnTo>
                <a:lnTo>
                  <a:pt x="448" y="335"/>
                </a:lnTo>
                <a:lnTo>
                  <a:pt x="506" y="335"/>
                </a:lnTo>
                <a:lnTo>
                  <a:pt x="506" y="404"/>
                </a:lnTo>
                <a:lnTo>
                  <a:pt x="513" y="404"/>
                </a:lnTo>
                <a:lnTo>
                  <a:pt x="513" y="474"/>
                </a:lnTo>
                <a:lnTo>
                  <a:pt x="526" y="474"/>
                </a:lnTo>
                <a:lnTo>
                  <a:pt x="616" y="474"/>
                </a:lnTo>
                <a:lnTo>
                  <a:pt x="649" y="474"/>
                </a:lnTo>
                <a:lnTo>
                  <a:pt x="753" y="474"/>
                </a:lnTo>
                <a:lnTo>
                  <a:pt x="764" y="474"/>
                </a:lnTo>
                <a:lnTo>
                  <a:pt x="785" y="474"/>
                </a:lnTo>
                <a:lnTo>
                  <a:pt x="785" y="571"/>
                </a:lnTo>
                <a:lnTo>
                  <a:pt x="819" y="571"/>
                </a:lnTo>
                <a:lnTo>
                  <a:pt x="846" y="571"/>
                </a:lnTo>
                <a:lnTo>
                  <a:pt x="913" y="571"/>
                </a:lnTo>
                <a:lnTo>
                  <a:pt x="987" y="571"/>
                </a:lnTo>
                <a:lnTo>
                  <a:pt x="987" y="700"/>
                </a:lnTo>
                <a:lnTo>
                  <a:pt x="1011" y="700"/>
                </a:lnTo>
                <a:lnTo>
                  <a:pt x="1023" y="700"/>
                </a:lnTo>
                <a:lnTo>
                  <a:pt x="1034" y="700"/>
                </a:lnTo>
                <a:lnTo>
                  <a:pt x="1113" y="700"/>
                </a:lnTo>
                <a:lnTo>
                  <a:pt x="1123" y="700"/>
                </a:lnTo>
                <a:lnTo>
                  <a:pt x="1123" y="958"/>
                </a:lnTo>
                <a:lnTo>
                  <a:pt x="1262" y="958"/>
                </a:lnTo>
                <a:lnTo>
                  <a:pt x="1378" y="958"/>
                </a:lnTo>
                <a:lnTo>
                  <a:pt x="2432" y="958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" name="Freeform 210">
            <a:extLst>
              <a:ext uri="{FF2B5EF4-FFF2-40B4-BE49-F238E27FC236}">
                <a16:creationId xmlns:a16="http://schemas.microsoft.com/office/drawing/2014/main" id="{763D3E5D-4097-4DE8-8C4E-B3B8EB5421AA}"/>
              </a:ext>
            </a:extLst>
          </p:cNvPr>
          <p:cNvSpPr>
            <a:spLocks/>
          </p:cNvSpPr>
          <p:nvPr/>
        </p:nvSpPr>
        <p:spPr bwMode="auto">
          <a:xfrm>
            <a:off x="1131895" y="2363049"/>
            <a:ext cx="2940050" cy="2751137"/>
          </a:xfrm>
          <a:custGeom>
            <a:avLst/>
            <a:gdLst>
              <a:gd name="T0" fmla="*/ 0 w 1852"/>
              <a:gd name="T1" fmla="*/ 0 h 1733"/>
              <a:gd name="T2" fmla="*/ 333 w 1852"/>
              <a:gd name="T3" fmla="*/ 0 h 1733"/>
              <a:gd name="T4" fmla="*/ 333 w 1852"/>
              <a:gd name="T5" fmla="*/ 174 h 1733"/>
              <a:gd name="T6" fmla="*/ 339 w 1852"/>
              <a:gd name="T7" fmla="*/ 174 h 1733"/>
              <a:gd name="T8" fmla="*/ 339 w 1852"/>
              <a:gd name="T9" fmla="*/ 346 h 1733"/>
              <a:gd name="T10" fmla="*/ 485 w 1852"/>
              <a:gd name="T11" fmla="*/ 346 h 1733"/>
              <a:gd name="T12" fmla="*/ 485 w 1852"/>
              <a:gd name="T13" fmla="*/ 520 h 1733"/>
              <a:gd name="T14" fmla="*/ 634 w 1852"/>
              <a:gd name="T15" fmla="*/ 520 h 1733"/>
              <a:gd name="T16" fmla="*/ 634 w 1852"/>
              <a:gd name="T17" fmla="*/ 694 h 1733"/>
              <a:gd name="T18" fmla="*/ 1047 w 1852"/>
              <a:gd name="T19" fmla="*/ 694 h 1733"/>
              <a:gd name="T20" fmla="*/ 1047 w 1852"/>
              <a:gd name="T21" fmla="*/ 867 h 1733"/>
              <a:gd name="T22" fmla="*/ 1220 w 1852"/>
              <a:gd name="T23" fmla="*/ 867 h 1733"/>
              <a:gd name="T24" fmla="*/ 1314 w 1852"/>
              <a:gd name="T25" fmla="*/ 867 h 1733"/>
              <a:gd name="T26" fmla="*/ 1314 w 1852"/>
              <a:gd name="T27" fmla="*/ 1084 h 1733"/>
              <a:gd name="T28" fmla="*/ 1464 w 1852"/>
              <a:gd name="T29" fmla="*/ 1084 h 1733"/>
              <a:gd name="T30" fmla="*/ 1547 w 1852"/>
              <a:gd name="T31" fmla="*/ 1084 h 1733"/>
              <a:gd name="T32" fmla="*/ 1547 w 1852"/>
              <a:gd name="T33" fmla="*/ 1409 h 1733"/>
              <a:gd name="T34" fmla="*/ 1852 w 1852"/>
              <a:gd name="T35" fmla="*/ 1409 h 1733"/>
              <a:gd name="T36" fmla="*/ 1852 w 1852"/>
              <a:gd name="T37" fmla="*/ 1733 h 17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>
              <a:path w="1852" h="1733">
                <a:moveTo>
                  <a:pt x="0" y="0"/>
                </a:moveTo>
                <a:lnTo>
                  <a:pt x="333" y="0"/>
                </a:lnTo>
                <a:lnTo>
                  <a:pt x="333" y="174"/>
                </a:lnTo>
                <a:lnTo>
                  <a:pt x="339" y="174"/>
                </a:lnTo>
                <a:lnTo>
                  <a:pt x="339" y="346"/>
                </a:lnTo>
                <a:lnTo>
                  <a:pt x="485" y="346"/>
                </a:lnTo>
                <a:lnTo>
                  <a:pt x="485" y="520"/>
                </a:lnTo>
                <a:lnTo>
                  <a:pt x="634" y="520"/>
                </a:lnTo>
                <a:lnTo>
                  <a:pt x="634" y="694"/>
                </a:lnTo>
                <a:lnTo>
                  <a:pt x="1047" y="694"/>
                </a:lnTo>
                <a:lnTo>
                  <a:pt x="1047" y="867"/>
                </a:lnTo>
                <a:lnTo>
                  <a:pt x="1220" y="867"/>
                </a:lnTo>
                <a:lnTo>
                  <a:pt x="1314" y="867"/>
                </a:lnTo>
                <a:lnTo>
                  <a:pt x="1314" y="1084"/>
                </a:lnTo>
                <a:lnTo>
                  <a:pt x="1464" y="1084"/>
                </a:lnTo>
                <a:lnTo>
                  <a:pt x="1547" y="1084"/>
                </a:lnTo>
                <a:lnTo>
                  <a:pt x="1547" y="1409"/>
                </a:lnTo>
                <a:lnTo>
                  <a:pt x="1852" y="1409"/>
                </a:lnTo>
                <a:lnTo>
                  <a:pt x="1852" y="1733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" name="Freeform 266">
            <a:extLst>
              <a:ext uri="{FF2B5EF4-FFF2-40B4-BE49-F238E27FC236}">
                <a16:creationId xmlns:a16="http://schemas.microsoft.com/office/drawing/2014/main" id="{645F5BB7-AEDC-43A5-863F-E226AEBD8E5A}"/>
              </a:ext>
            </a:extLst>
          </p:cNvPr>
          <p:cNvSpPr>
            <a:spLocks/>
          </p:cNvSpPr>
          <p:nvPr/>
        </p:nvSpPr>
        <p:spPr bwMode="auto">
          <a:xfrm>
            <a:off x="7283228" y="2354754"/>
            <a:ext cx="2297113" cy="1470025"/>
          </a:xfrm>
          <a:custGeom>
            <a:avLst/>
            <a:gdLst>
              <a:gd name="T0" fmla="*/ 0 w 2894"/>
              <a:gd name="T1" fmla="*/ 0 h 926"/>
              <a:gd name="T2" fmla="*/ 173 w 2894"/>
              <a:gd name="T3" fmla="*/ 0 h 926"/>
              <a:gd name="T4" fmla="*/ 173 w 2894"/>
              <a:gd name="T5" fmla="*/ 63 h 926"/>
              <a:gd name="T6" fmla="*/ 247 w 2894"/>
              <a:gd name="T7" fmla="*/ 63 h 926"/>
              <a:gd name="T8" fmla="*/ 247 w 2894"/>
              <a:gd name="T9" fmla="*/ 126 h 926"/>
              <a:gd name="T10" fmla="*/ 319 w 2894"/>
              <a:gd name="T11" fmla="*/ 126 h 926"/>
              <a:gd name="T12" fmla="*/ 319 w 2894"/>
              <a:gd name="T13" fmla="*/ 189 h 926"/>
              <a:gd name="T14" fmla="*/ 351 w 2894"/>
              <a:gd name="T15" fmla="*/ 189 h 926"/>
              <a:gd name="T16" fmla="*/ 351 w 2894"/>
              <a:gd name="T17" fmla="*/ 251 h 926"/>
              <a:gd name="T18" fmla="*/ 377 w 2894"/>
              <a:gd name="T19" fmla="*/ 251 h 926"/>
              <a:gd name="T20" fmla="*/ 377 w 2894"/>
              <a:gd name="T21" fmla="*/ 314 h 926"/>
              <a:gd name="T22" fmla="*/ 418 w 2894"/>
              <a:gd name="T23" fmla="*/ 314 h 926"/>
              <a:gd name="T24" fmla="*/ 418 w 2894"/>
              <a:gd name="T25" fmla="*/ 377 h 926"/>
              <a:gd name="T26" fmla="*/ 470 w 2894"/>
              <a:gd name="T27" fmla="*/ 377 h 926"/>
              <a:gd name="T28" fmla="*/ 470 w 2894"/>
              <a:gd name="T29" fmla="*/ 439 h 926"/>
              <a:gd name="T30" fmla="*/ 510 w 2894"/>
              <a:gd name="T31" fmla="*/ 439 h 926"/>
              <a:gd name="T32" fmla="*/ 510 w 2894"/>
              <a:gd name="T33" fmla="*/ 502 h 926"/>
              <a:gd name="T34" fmla="*/ 517 w 2894"/>
              <a:gd name="T35" fmla="*/ 565 h 926"/>
              <a:gd name="T36" fmla="*/ 645 w 2894"/>
              <a:gd name="T37" fmla="*/ 565 h 926"/>
              <a:gd name="T38" fmla="*/ 645 w 2894"/>
              <a:gd name="T39" fmla="*/ 626 h 926"/>
              <a:gd name="T40" fmla="*/ 649 w 2894"/>
              <a:gd name="T41" fmla="*/ 689 h 926"/>
              <a:gd name="T42" fmla="*/ 697 w 2894"/>
              <a:gd name="T43" fmla="*/ 689 h 926"/>
              <a:gd name="T44" fmla="*/ 704 w 2894"/>
              <a:gd name="T45" fmla="*/ 689 h 926"/>
              <a:gd name="T46" fmla="*/ 704 w 2894"/>
              <a:gd name="T47" fmla="*/ 756 h 926"/>
              <a:gd name="T48" fmla="*/ 717 w 2894"/>
              <a:gd name="T49" fmla="*/ 756 h 926"/>
              <a:gd name="T50" fmla="*/ 717 w 2894"/>
              <a:gd name="T51" fmla="*/ 823 h 926"/>
              <a:gd name="T52" fmla="*/ 843 w 2894"/>
              <a:gd name="T53" fmla="*/ 823 h 926"/>
              <a:gd name="T54" fmla="*/ 941 w 2894"/>
              <a:gd name="T55" fmla="*/ 823 h 926"/>
              <a:gd name="T56" fmla="*/ 1580 w 2894"/>
              <a:gd name="T57" fmla="*/ 823 h 926"/>
              <a:gd name="T58" fmla="*/ 1606 w 2894"/>
              <a:gd name="T59" fmla="*/ 823 h 926"/>
              <a:gd name="T60" fmla="*/ 1779 w 2894"/>
              <a:gd name="T61" fmla="*/ 823 h 926"/>
              <a:gd name="T62" fmla="*/ 1829 w 2894"/>
              <a:gd name="T63" fmla="*/ 823 h 926"/>
              <a:gd name="T64" fmla="*/ 1829 w 2894"/>
              <a:gd name="T65" fmla="*/ 926 h 926"/>
              <a:gd name="T66" fmla="*/ 1917 w 2894"/>
              <a:gd name="T67" fmla="*/ 926 h 926"/>
              <a:gd name="T68" fmla="*/ 2125 w 2894"/>
              <a:gd name="T69" fmla="*/ 926 h 926"/>
              <a:gd name="T70" fmla="*/ 2150 w 2894"/>
              <a:gd name="T71" fmla="*/ 926 h 926"/>
              <a:gd name="T72" fmla="*/ 2171 w 2894"/>
              <a:gd name="T73" fmla="*/ 926 h 926"/>
              <a:gd name="T74" fmla="*/ 2341 w 2894"/>
              <a:gd name="T75" fmla="*/ 926 h 926"/>
              <a:gd name="T76" fmla="*/ 2546 w 2894"/>
              <a:gd name="T77" fmla="*/ 926 h 926"/>
              <a:gd name="T78" fmla="*/ 2654 w 2894"/>
              <a:gd name="T79" fmla="*/ 926 h 926"/>
              <a:gd name="T80" fmla="*/ 2894 w 2894"/>
              <a:gd name="T81" fmla="*/ 926 h 9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</a:cxnLst>
            <a:rect l="0" t="0" r="r" b="b"/>
            <a:pathLst>
              <a:path w="2894" h="926">
                <a:moveTo>
                  <a:pt x="0" y="0"/>
                </a:moveTo>
                <a:lnTo>
                  <a:pt x="173" y="0"/>
                </a:lnTo>
                <a:lnTo>
                  <a:pt x="173" y="63"/>
                </a:lnTo>
                <a:lnTo>
                  <a:pt x="247" y="63"/>
                </a:lnTo>
                <a:lnTo>
                  <a:pt x="247" y="126"/>
                </a:lnTo>
                <a:lnTo>
                  <a:pt x="319" y="126"/>
                </a:lnTo>
                <a:lnTo>
                  <a:pt x="319" y="189"/>
                </a:lnTo>
                <a:lnTo>
                  <a:pt x="351" y="189"/>
                </a:lnTo>
                <a:lnTo>
                  <a:pt x="351" y="251"/>
                </a:lnTo>
                <a:lnTo>
                  <a:pt x="377" y="251"/>
                </a:lnTo>
                <a:lnTo>
                  <a:pt x="377" y="314"/>
                </a:lnTo>
                <a:lnTo>
                  <a:pt x="418" y="314"/>
                </a:lnTo>
                <a:lnTo>
                  <a:pt x="418" y="377"/>
                </a:lnTo>
                <a:lnTo>
                  <a:pt x="470" y="377"/>
                </a:lnTo>
                <a:lnTo>
                  <a:pt x="470" y="439"/>
                </a:lnTo>
                <a:lnTo>
                  <a:pt x="510" y="439"/>
                </a:lnTo>
                <a:lnTo>
                  <a:pt x="510" y="502"/>
                </a:lnTo>
                <a:lnTo>
                  <a:pt x="517" y="565"/>
                </a:lnTo>
                <a:lnTo>
                  <a:pt x="645" y="565"/>
                </a:lnTo>
                <a:lnTo>
                  <a:pt x="645" y="626"/>
                </a:lnTo>
                <a:lnTo>
                  <a:pt x="649" y="689"/>
                </a:lnTo>
                <a:lnTo>
                  <a:pt x="697" y="689"/>
                </a:lnTo>
                <a:lnTo>
                  <a:pt x="704" y="689"/>
                </a:lnTo>
                <a:lnTo>
                  <a:pt x="704" y="756"/>
                </a:lnTo>
                <a:lnTo>
                  <a:pt x="717" y="756"/>
                </a:lnTo>
                <a:lnTo>
                  <a:pt x="717" y="823"/>
                </a:lnTo>
                <a:lnTo>
                  <a:pt x="843" y="823"/>
                </a:lnTo>
                <a:lnTo>
                  <a:pt x="941" y="823"/>
                </a:lnTo>
                <a:lnTo>
                  <a:pt x="1580" y="823"/>
                </a:lnTo>
                <a:lnTo>
                  <a:pt x="1606" y="823"/>
                </a:lnTo>
                <a:lnTo>
                  <a:pt x="1779" y="823"/>
                </a:lnTo>
                <a:lnTo>
                  <a:pt x="1829" y="823"/>
                </a:lnTo>
                <a:lnTo>
                  <a:pt x="1829" y="926"/>
                </a:lnTo>
                <a:lnTo>
                  <a:pt x="1917" y="926"/>
                </a:lnTo>
                <a:lnTo>
                  <a:pt x="2125" y="926"/>
                </a:lnTo>
                <a:lnTo>
                  <a:pt x="2150" y="926"/>
                </a:lnTo>
                <a:lnTo>
                  <a:pt x="2171" y="926"/>
                </a:lnTo>
                <a:lnTo>
                  <a:pt x="2341" y="926"/>
                </a:lnTo>
                <a:lnTo>
                  <a:pt x="2546" y="926"/>
                </a:lnTo>
                <a:lnTo>
                  <a:pt x="2654" y="926"/>
                </a:lnTo>
                <a:lnTo>
                  <a:pt x="2894" y="926"/>
                </a:lnTo>
              </a:path>
            </a:pathLst>
          </a:custGeom>
          <a:noFill/>
          <a:ln w="1905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" name="Freeform 267">
            <a:extLst>
              <a:ext uri="{FF2B5EF4-FFF2-40B4-BE49-F238E27FC236}">
                <a16:creationId xmlns:a16="http://schemas.microsoft.com/office/drawing/2014/main" id="{414C730B-8AEA-44A3-B5BE-26EABAB23D8A}"/>
              </a:ext>
            </a:extLst>
          </p:cNvPr>
          <p:cNvSpPr>
            <a:spLocks/>
          </p:cNvSpPr>
          <p:nvPr/>
        </p:nvSpPr>
        <p:spPr bwMode="auto">
          <a:xfrm>
            <a:off x="7283228" y="2354754"/>
            <a:ext cx="3087688" cy="1857375"/>
          </a:xfrm>
          <a:custGeom>
            <a:avLst/>
            <a:gdLst>
              <a:gd name="T0" fmla="*/ 0 w 3891"/>
              <a:gd name="T1" fmla="*/ 0 h 1170"/>
              <a:gd name="T2" fmla="*/ 146 w 3891"/>
              <a:gd name="T3" fmla="*/ 0 h 1170"/>
              <a:gd name="T4" fmla="*/ 146 w 3891"/>
              <a:gd name="T5" fmla="*/ 176 h 1170"/>
              <a:gd name="T6" fmla="*/ 286 w 3891"/>
              <a:gd name="T7" fmla="*/ 176 h 1170"/>
              <a:gd name="T8" fmla="*/ 286 w 3891"/>
              <a:gd name="T9" fmla="*/ 351 h 1170"/>
              <a:gd name="T10" fmla="*/ 513 w 3891"/>
              <a:gd name="T11" fmla="*/ 351 h 1170"/>
              <a:gd name="T12" fmla="*/ 513 w 3891"/>
              <a:gd name="T13" fmla="*/ 527 h 1170"/>
              <a:gd name="T14" fmla="*/ 694 w 3891"/>
              <a:gd name="T15" fmla="*/ 527 h 1170"/>
              <a:gd name="T16" fmla="*/ 694 w 3891"/>
              <a:gd name="T17" fmla="*/ 702 h 1170"/>
              <a:gd name="T18" fmla="*/ 739 w 3891"/>
              <a:gd name="T19" fmla="*/ 702 h 1170"/>
              <a:gd name="T20" fmla="*/ 739 w 3891"/>
              <a:gd name="T21" fmla="*/ 877 h 1170"/>
              <a:gd name="T22" fmla="*/ 2564 w 3891"/>
              <a:gd name="T23" fmla="*/ 877 h 1170"/>
              <a:gd name="T24" fmla="*/ 2762 w 3891"/>
              <a:gd name="T25" fmla="*/ 877 h 1170"/>
              <a:gd name="T26" fmla="*/ 2867 w 3891"/>
              <a:gd name="T27" fmla="*/ 877 h 1170"/>
              <a:gd name="T28" fmla="*/ 2867 w 3891"/>
              <a:gd name="T29" fmla="*/ 1170 h 1170"/>
              <a:gd name="T30" fmla="*/ 3076 w 3891"/>
              <a:gd name="T31" fmla="*/ 1170 h 1170"/>
              <a:gd name="T32" fmla="*/ 3891 w 3891"/>
              <a:gd name="T33" fmla="*/ 1170 h 11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891" h="1170">
                <a:moveTo>
                  <a:pt x="0" y="0"/>
                </a:moveTo>
                <a:lnTo>
                  <a:pt x="146" y="0"/>
                </a:lnTo>
                <a:lnTo>
                  <a:pt x="146" y="176"/>
                </a:lnTo>
                <a:lnTo>
                  <a:pt x="286" y="176"/>
                </a:lnTo>
                <a:lnTo>
                  <a:pt x="286" y="351"/>
                </a:lnTo>
                <a:lnTo>
                  <a:pt x="513" y="351"/>
                </a:lnTo>
                <a:lnTo>
                  <a:pt x="513" y="527"/>
                </a:lnTo>
                <a:lnTo>
                  <a:pt x="694" y="527"/>
                </a:lnTo>
                <a:lnTo>
                  <a:pt x="694" y="702"/>
                </a:lnTo>
                <a:lnTo>
                  <a:pt x="739" y="702"/>
                </a:lnTo>
                <a:lnTo>
                  <a:pt x="739" y="877"/>
                </a:lnTo>
                <a:lnTo>
                  <a:pt x="2564" y="877"/>
                </a:lnTo>
                <a:lnTo>
                  <a:pt x="2762" y="877"/>
                </a:lnTo>
                <a:lnTo>
                  <a:pt x="2867" y="877"/>
                </a:lnTo>
                <a:lnTo>
                  <a:pt x="2867" y="1170"/>
                </a:lnTo>
                <a:lnTo>
                  <a:pt x="3076" y="1170"/>
                </a:lnTo>
                <a:lnTo>
                  <a:pt x="3891" y="1170"/>
                </a:lnTo>
              </a:path>
            </a:pathLst>
          </a:custGeom>
          <a:noFill/>
          <a:ln w="19050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A29118E4-80CE-4B5A-848D-4E0C35788554}"/>
              </a:ext>
            </a:extLst>
          </p:cNvPr>
          <p:cNvSpPr txBox="1"/>
          <p:nvPr/>
        </p:nvSpPr>
        <p:spPr>
          <a:xfrm>
            <a:off x="2396844" y="1108933"/>
            <a:ext cx="1977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RI low grou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3C43D83D-E3E1-4D18-8CB0-032EDD992A08}"/>
              </a:ext>
            </a:extLst>
          </p:cNvPr>
          <p:cNvSpPr txBox="1"/>
          <p:nvPr/>
        </p:nvSpPr>
        <p:spPr>
          <a:xfrm>
            <a:off x="8681820" y="1108933"/>
            <a:ext cx="1977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RI low grou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939F9360-AE22-4B77-9680-2DDC5EB46EA9}"/>
              </a:ext>
            </a:extLst>
          </p:cNvPr>
          <p:cNvSpPr txBox="1"/>
          <p:nvPr/>
        </p:nvSpPr>
        <p:spPr>
          <a:xfrm>
            <a:off x="0" y="36576"/>
            <a:ext cx="2258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Fig. 2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41962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6</TotalTime>
  <Words>283</Words>
  <Application>Microsoft Office PowerPoint</Application>
  <PresentationFormat>ワイド画面</PresentationFormat>
  <Paragraphs>15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>UNITCOM P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zo Ide</dc:creator>
  <cp:lastModifiedBy>正造 井出</cp:lastModifiedBy>
  <cp:revision>59</cp:revision>
  <dcterms:created xsi:type="dcterms:W3CDTF">2017-05-15T10:58:12Z</dcterms:created>
  <dcterms:modified xsi:type="dcterms:W3CDTF">2021-01-05T07:05:10Z</dcterms:modified>
</cp:coreProperties>
</file>